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7" r:id="rId2"/>
  </p:sldIdLst>
  <p:sldSz cx="11704638" cy="76803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11" autoAdjust="0"/>
    <p:restoredTop sz="94660"/>
  </p:normalViewPr>
  <p:slideViewPr>
    <p:cSldViewPr snapToGrid="0">
      <p:cViewPr varScale="1">
        <p:scale>
          <a:sx n="53" d="100"/>
          <a:sy n="53" d="100"/>
        </p:scale>
        <p:origin x="1420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D620B3-B751-4F39-B21D-3D06789789F1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77913" y="1143000"/>
            <a:ext cx="47021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C86A92-F812-4C5A-B1DB-89EB735869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24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21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44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365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486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607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730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851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972" algn="l" defTabSz="91424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077913" y="1143000"/>
            <a:ext cx="47021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C86A92-F812-4C5A-B1DB-89EB735869D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7297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77848" y="1256943"/>
            <a:ext cx="9948942" cy="2673891"/>
          </a:xfrm>
        </p:spPr>
        <p:txBody>
          <a:bodyPr anchor="b"/>
          <a:lstStyle>
            <a:lvl1pPr algn="ctr">
              <a:defRPr sz="67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3080" y="4033949"/>
            <a:ext cx="8778479" cy="1854300"/>
          </a:xfrm>
        </p:spPr>
        <p:txBody>
          <a:bodyPr/>
          <a:lstStyle>
            <a:lvl1pPr marL="0" indent="0" algn="ctr">
              <a:buNone/>
              <a:defRPr sz="2688"/>
            </a:lvl1pPr>
            <a:lvl2pPr marL="512018" indent="0" algn="ctr">
              <a:buNone/>
              <a:defRPr sz="2240"/>
            </a:lvl2pPr>
            <a:lvl3pPr marL="1024037" indent="0" algn="ctr">
              <a:buNone/>
              <a:defRPr sz="2016"/>
            </a:lvl3pPr>
            <a:lvl4pPr marL="1536055" indent="0" algn="ctr">
              <a:buNone/>
              <a:defRPr sz="1792"/>
            </a:lvl4pPr>
            <a:lvl5pPr marL="2048073" indent="0" algn="ctr">
              <a:buNone/>
              <a:defRPr sz="1792"/>
            </a:lvl5pPr>
            <a:lvl6pPr marL="2560091" indent="0" algn="ctr">
              <a:buNone/>
              <a:defRPr sz="1792"/>
            </a:lvl6pPr>
            <a:lvl7pPr marL="3072110" indent="0" algn="ctr">
              <a:buNone/>
              <a:defRPr sz="1792"/>
            </a:lvl7pPr>
            <a:lvl8pPr marL="3584128" indent="0" algn="ctr">
              <a:buNone/>
              <a:defRPr sz="1792"/>
            </a:lvl8pPr>
            <a:lvl9pPr marL="4096146" indent="0" algn="ctr">
              <a:buNone/>
              <a:defRPr sz="1792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144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319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76132" y="408906"/>
            <a:ext cx="2523813" cy="650872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04694" y="408906"/>
            <a:ext cx="7425130" cy="650872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177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813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8598" y="1914750"/>
            <a:ext cx="10095250" cy="3194801"/>
          </a:xfrm>
        </p:spPr>
        <p:txBody>
          <a:bodyPr anchor="b"/>
          <a:lstStyle>
            <a:lvl1pPr>
              <a:defRPr sz="671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8598" y="5139775"/>
            <a:ext cx="10095250" cy="1680071"/>
          </a:xfrm>
        </p:spPr>
        <p:txBody>
          <a:bodyPr/>
          <a:lstStyle>
            <a:lvl1pPr marL="0" indent="0">
              <a:buNone/>
              <a:defRPr sz="2688">
                <a:solidFill>
                  <a:schemeClr val="tx1">
                    <a:tint val="82000"/>
                  </a:schemeClr>
                </a:solidFill>
              </a:defRPr>
            </a:lvl1pPr>
            <a:lvl2pPr marL="512018" indent="0">
              <a:buNone/>
              <a:defRPr sz="2240">
                <a:solidFill>
                  <a:schemeClr val="tx1">
                    <a:tint val="82000"/>
                  </a:schemeClr>
                </a:solidFill>
              </a:defRPr>
            </a:lvl2pPr>
            <a:lvl3pPr marL="1024037" indent="0">
              <a:buNone/>
              <a:defRPr sz="2016">
                <a:solidFill>
                  <a:schemeClr val="tx1">
                    <a:tint val="82000"/>
                  </a:schemeClr>
                </a:solidFill>
              </a:defRPr>
            </a:lvl3pPr>
            <a:lvl4pPr marL="1536055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4pPr>
            <a:lvl5pPr marL="2048073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5pPr>
            <a:lvl6pPr marL="2560091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6pPr>
            <a:lvl7pPr marL="3072110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7pPr>
            <a:lvl8pPr marL="3584128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8pPr>
            <a:lvl9pPr marL="4096146" indent="0">
              <a:buNone/>
              <a:defRPr sz="1792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5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04694" y="2044531"/>
            <a:ext cx="4974471" cy="4873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25473" y="2044531"/>
            <a:ext cx="4974471" cy="48730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01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6219" y="408908"/>
            <a:ext cx="10095250" cy="148450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6220" y="1882747"/>
            <a:ext cx="4951610" cy="922705"/>
          </a:xfrm>
        </p:spPr>
        <p:txBody>
          <a:bodyPr anchor="b"/>
          <a:lstStyle>
            <a:lvl1pPr marL="0" indent="0">
              <a:buNone/>
              <a:defRPr sz="2688" b="1"/>
            </a:lvl1pPr>
            <a:lvl2pPr marL="512018" indent="0">
              <a:buNone/>
              <a:defRPr sz="2240" b="1"/>
            </a:lvl2pPr>
            <a:lvl3pPr marL="1024037" indent="0">
              <a:buNone/>
              <a:defRPr sz="2016" b="1"/>
            </a:lvl3pPr>
            <a:lvl4pPr marL="1536055" indent="0">
              <a:buNone/>
              <a:defRPr sz="1792" b="1"/>
            </a:lvl4pPr>
            <a:lvl5pPr marL="2048073" indent="0">
              <a:buNone/>
              <a:defRPr sz="1792" b="1"/>
            </a:lvl5pPr>
            <a:lvl6pPr marL="2560091" indent="0">
              <a:buNone/>
              <a:defRPr sz="1792" b="1"/>
            </a:lvl6pPr>
            <a:lvl7pPr marL="3072110" indent="0">
              <a:buNone/>
              <a:defRPr sz="1792" b="1"/>
            </a:lvl7pPr>
            <a:lvl8pPr marL="3584128" indent="0">
              <a:buNone/>
              <a:defRPr sz="1792" b="1"/>
            </a:lvl8pPr>
            <a:lvl9pPr marL="4096146" indent="0">
              <a:buNone/>
              <a:defRPr sz="17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6220" y="2805452"/>
            <a:ext cx="4951610" cy="41263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925473" y="1882747"/>
            <a:ext cx="4975996" cy="922705"/>
          </a:xfrm>
        </p:spPr>
        <p:txBody>
          <a:bodyPr anchor="b"/>
          <a:lstStyle>
            <a:lvl1pPr marL="0" indent="0">
              <a:buNone/>
              <a:defRPr sz="2688" b="1"/>
            </a:lvl1pPr>
            <a:lvl2pPr marL="512018" indent="0">
              <a:buNone/>
              <a:defRPr sz="2240" b="1"/>
            </a:lvl2pPr>
            <a:lvl3pPr marL="1024037" indent="0">
              <a:buNone/>
              <a:defRPr sz="2016" b="1"/>
            </a:lvl3pPr>
            <a:lvl4pPr marL="1536055" indent="0">
              <a:buNone/>
              <a:defRPr sz="1792" b="1"/>
            </a:lvl4pPr>
            <a:lvl5pPr marL="2048073" indent="0">
              <a:buNone/>
              <a:defRPr sz="1792" b="1"/>
            </a:lvl5pPr>
            <a:lvl6pPr marL="2560091" indent="0">
              <a:buNone/>
              <a:defRPr sz="1792" b="1"/>
            </a:lvl6pPr>
            <a:lvl7pPr marL="3072110" indent="0">
              <a:buNone/>
              <a:defRPr sz="1792" b="1"/>
            </a:lvl7pPr>
            <a:lvl8pPr marL="3584128" indent="0">
              <a:buNone/>
              <a:defRPr sz="1792" b="1"/>
            </a:lvl8pPr>
            <a:lvl9pPr marL="4096146" indent="0">
              <a:buNone/>
              <a:defRPr sz="1792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925473" y="2805452"/>
            <a:ext cx="4975996" cy="41263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289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958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946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6219" y="512022"/>
            <a:ext cx="3775050" cy="1792076"/>
          </a:xfrm>
        </p:spPr>
        <p:txBody>
          <a:bodyPr anchor="b"/>
          <a:lstStyle>
            <a:lvl1pPr>
              <a:defRPr sz="35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975996" y="1105826"/>
            <a:ext cx="5925473" cy="5458009"/>
          </a:xfrm>
        </p:spPr>
        <p:txBody>
          <a:bodyPr/>
          <a:lstStyle>
            <a:lvl1pPr>
              <a:defRPr sz="3584"/>
            </a:lvl1pPr>
            <a:lvl2pPr>
              <a:defRPr sz="3136"/>
            </a:lvl2pPr>
            <a:lvl3pPr>
              <a:defRPr sz="2688"/>
            </a:lvl3pPr>
            <a:lvl4pPr>
              <a:defRPr sz="2240"/>
            </a:lvl4pPr>
            <a:lvl5pPr>
              <a:defRPr sz="2240"/>
            </a:lvl5pPr>
            <a:lvl6pPr>
              <a:defRPr sz="2240"/>
            </a:lvl6pPr>
            <a:lvl7pPr>
              <a:defRPr sz="2240"/>
            </a:lvl7pPr>
            <a:lvl8pPr>
              <a:defRPr sz="2240"/>
            </a:lvl8pPr>
            <a:lvl9pPr>
              <a:defRPr sz="224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6219" y="2304097"/>
            <a:ext cx="3775050" cy="4268626"/>
          </a:xfrm>
        </p:spPr>
        <p:txBody>
          <a:bodyPr/>
          <a:lstStyle>
            <a:lvl1pPr marL="0" indent="0">
              <a:buNone/>
              <a:defRPr sz="1792"/>
            </a:lvl1pPr>
            <a:lvl2pPr marL="512018" indent="0">
              <a:buNone/>
              <a:defRPr sz="1568"/>
            </a:lvl2pPr>
            <a:lvl3pPr marL="1024037" indent="0">
              <a:buNone/>
              <a:defRPr sz="1344"/>
            </a:lvl3pPr>
            <a:lvl4pPr marL="1536055" indent="0">
              <a:buNone/>
              <a:defRPr sz="1120"/>
            </a:lvl4pPr>
            <a:lvl5pPr marL="2048073" indent="0">
              <a:buNone/>
              <a:defRPr sz="1120"/>
            </a:lvl5pPr>
            <a:lvl6pPr marL="2560091" indent="0">
              <a:buNone/>
              <a:defRPr sz="1120"/>
            </a:lvl6pPr>
            <a:lvl7pPr marL="3072110" indent="0">
              <a:buNone/>
              <a:defRPr sz="1120"/>
            </a:lvl7pPr>
            <a:lvl8pPr marL="3584128" indent="0">
              <a:buNone/>
              <a:defRPr sz="1120"/>
            </a:lvl8pPr>
            <a:lvl9pPr marL="4096146" indent="0">
              <a:buNone/>
              <a:defRPr sz="11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8185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06219" y="512022"/>
            <a:ext cx="3775050" cy="1792076"/>
          </a:xfrm>
        </p:spPr>
        <p:txBody>
          <a:bodyPr anchor="b"/>
          <a:lstStyle>
            <a:lvl1pPr>
              <a:defRPr sz="358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975996" y="1105826"/>
            <a:ext cx="5925473" cy="5458009"/>
          </a:xfrm>
        </p:spPr>
        <p:txBody>
          <a:bodyPr anchor="t"/>
          <a:lstStyle>
            <a:lvl1pPr marL="0" indent="0">
              <a:buNone/>
              <a:defRPr sz="3584"/>
            </a:lvl1pPr>
            <a:lvl2pPr marL="512018" indent="0">
              <a:buNone/>
              <a:defRPr sz="3136"/>
            </a:lvl2pPr>
            <a:lvl3pPr marL="1024037" indent="0">
              <a:buNone/>
              <a:defRPr sz="2688"/>
            </a:lvl3pPr>
            <a:lvl4pPr marL="1536055" indent="0">
              <a:buNone/>
              <a:defRPr sz="2240"/>
            </a:lvl4pPr>
            <a:lvl5pPr marL="2048073" indent="0">
              <a:buNone/>
              <a:defRPr sz="2240"/>
            </a:lvl5pPr>
            <a:lvl6pPr marL="2560091" indent="0">
              <a:buNone/>
              <a:defRPr sz="2240"/>
            </a:lvl6pPr>
            <a:lvl7pPr marL="3072110" indent="0">
              <a:buNone/>
              <a:defRPr sz="2240"/>
            </a:lvl7pPr>
            <a:lvl8pPr marL="3584128" indent="0">
              <a:buNone/>
              <a:defRPr sz="2240"/>
            </a:lvl8pPr>
            <a:lvl9pPr marL="4096146" indent="0">
              <a:buNone/>
              <a:defRPr sz="224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06219" y="2304097"/>
            <a:ext cx="3775050" cy="4268626"/>
          </a:xfrm>
        </p:spPr>
        <p:txBody>
          <a:bodyPr/>
          <a:lstStyle>
            <a:lvl1pPr marL="0" indent="0">
              <a:buNone/>
              <a:defRPr sz="1792"/>
            </a:lvl1pPr>
            <a:lvl2pPr marL="512018" indent="0">
              <a:buNone/>
              <a:defRPr sz="1568"/>
            </a:lvl2pPr>
            <a:lvl3pPr marL="1024037" indent="0">
              <a:buNone/>
              <a:defRPr sz="1344"/>
            </a:lvl3pPr>
            <a:lvl4pPr marL="1536055" indent="0">
              <a:buNone/>
              <a:defRPr sz="1120"/>
            </a:lvl4pPr>
            <a:lvl5pPr marL="2048073" indent="0">
              <a:buNone/>
              <a:defRPr sz="1120"/>
            </a:lvl5pPr>
            <a:lvl6pPr marL="2560091" indent="0">
              <a:buNone/>
              <a:defRPr sz="1120"/>
            </a:lvl6pPr>
            <a:lvl7pPr marL="3072110" indent="0">
              <a:buNone/>
              <a:defRPr sz="1120"/>
            </a:lvl7pPr>
            <a:lvl8pPr marL="3584128" indent="0">
              <a:buNone/>
              <a:defRPr sz="1120"/>
            </a:lvl8pPr>
            <a:lvl9pPr marL="4096146" indent="0">
              <a:buNone/>
              <a:defRPr sz="112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685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04694" y="408908"/>
            <a:ext cx="10095250" cy="14845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04694" y="2044531"/>
            <a:ext cx="10095250" cy="48730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04694" y="7118525"/>
            <a:ext cx="2633544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02B30F-CAC1-4531-A3B1-D2AB3A8A7F3D}" type="datetimeFigureOut">
              <a:rPr lang="en-US" smtClean="0"/>
              <a:t>10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77162" y="7118525"/>
            <a:ext cx="3950315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66400" y="7118525"/>
            <a:ext cx="2633544" cy="4089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44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8C55BD-98DC-44D3-A8DD-23BC36CFDD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2639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024037" rtl="0" eaLnBrk="1" latinLnBrk="0" hangingPunct="1">
        <a:lnSpc>
          <a:spcPct val="90000"/>
        </a:lnSpc>
        <a:spcBef>
          <a:spcPct val="0"/>
        </a:spcBef>
        <a:buNone/>
        <a:defRPr sz="49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6009" indent="-256009" algn="l" defTabSz="1024037" rtl="0" eaLnBrk="1" latinLnBrk="0" hangingPunct="1">
        <a:lnSpc>
          <a:spcPct val="90000"/>
        </a:lnSpc>
        <a:spcBef>
          <a:spcPts val="1120"/>
        </a:spcBef>
        <a:buFont typeface="Arial" panose="020B0604020202020204" pitchFamily="34" charset="0"/>
        <a:buChar char="•"/>
        <a:defRPr sz="3136" kern="1200">
          <a:solidFill>
            <a:schemeClr val="tx1"/>
          </a:solidFill>
          <a:latin typeface="+mn-lt"/>
          <a:ea typeface="+mn-ea"/>
          <a:cs typeface="+mn-cs"/>
        </a:defRPr>
      </a:lvl1pPr>
      <a:lvl2pPr marL="768027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688" kern="1200">
          <a:solidFill>
            <a:schemeClr val="tx1"/>
          </a:solidFill>
          <a:latin typeface="+mn-lt"/>
          <a:ea typeface="+mn-ea"/>
          <a:cs typeface="+mn-cs"/>
        </a:defRPr>
      </a:lvl2pPr>
      <a:lvl3pPr marL="1280046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3pPr>
      <a:lvl4pPr marL="1792064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4pPr>
      <a:lvl5pPr marL="2304082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5pPr>
      <a:lvl6pPr marL="2816101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6pPr>
      <a:lvl7pPr marL="3328119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7pPr>
      <a:lvl8pPr marL="3840137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8pPr>
      <a:lvl9pPr marL="4352155" indent="-256009" algn="l" defTabSz="1024037" rtl="0" eaLnBrk="1" latinLnBrk="0" hangingPunct="1">
        <a:lnSpc>
          <a:spcPct val="90000"/>
        </a:lnSpc>
        <a:spcBef>
          <a:spcPts val="560"/>
        </a:spcBef>
        <a:buFont typeface="Arial" panose="020B0604020202020204" pitchFamily="34" charset="0"/>
        <a:buChar char="•"/>
        <a:defRPr sz="201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1pPr>
      <a:lvl2pPr marL="512018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2pPr>
      <a:lvl3pPr marL="1024037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3pPr>
      <a:lvl4pPr marL="1536055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4pPr>
      <a:lvl5pPr marL="2048073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5pPr>
      <a:lvl6pPr marL="2560091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6pPr>
      <a:lvl7pPr marL="3072110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7pPr>
      <a:lvl8pPr marL="3584128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8pPr>
      <a:lvl9pPr marL="4096146" algn="l" defTabSz="1024037" rtl="0" eaLnBrk="1" latinLnBrk="0" hangingPunct="1">
        <a:defRPr sz="201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0.svg"/><Relationship Id="rId18" Type="http://schemas.openxmlformats.org/officeDocument/2006/relationships/image" Target="../media/image15.png"/><Relationship Id="rId26" Type="http://schemas.openxmlformats.org/officeDocument/2006/relationships/image" Target="../media/image23.png"/><Relationship Id="rId3" Type="http://schemas.openxmlformats.org/officeDocument/2006/relationships/image" Target="../media/image1.png"/><Relationship Id="rId21" Type="http://schemas.openxmlformats.org/officeDocument/2006/relationships/image" Target="../media/image18.sv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17" Type="http://schemas.openxmlformats.org/officeDocument/2006/relationships/image" Target="../media/image14.svg"/><Relationship Id="rId25" Type="http://schemas.openxmlformats.org/officeDocument/2006/relationships/image" Target="../media/image22.sv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29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svg"/><Relationship Id="rId11" Type="http://schemas.openxmlformats.org/officeDocument/2006/relationships/image" Target="../media/image8.png"/><Relationship Id="rId24" Type="http://schemas.openxmlformats.org/officeDocument/2006/relationships/image" Target="../media/image21.png"/><Relationship Id="rId32" Type="http://schemas.openxmlformats.org/officeDocument/2006/relationships/image" Target="../media/image29.jpeg"/><Relationship Id="rId5" Type="http://schemas.openxmlformats.org/officeDocument/2006/relationships/image" Target="../media/image3.png"/><Relationship Id="rId15" Type="http://schemas.openxmlformats.org/officeDocument/2006/relationships/image" Target="../media/image12.svg"/><Relationship Id="rId23" Type="http://schemas.openxmlformats.org/officeDocument/2006/relationships/image" Target="../media/image20.svg"/><Relationship Id="rId28" Type="http://schemas.openxmlformats.org/officeDocument/2006/relationships/image" Target="../media/image25.png"/><Relationship Id="rId10" Type="http://schemas.openxmlformats.org/officeDocument/2006/relationships/image" Target="../media/image7.svg"/><Relationship Id="rId19" Type="http://schemas.openxmlformats.org/officeDocument/2006/relationships/image" Target="../media/image16.svg"/><Relationship Id="rId31" Type="http://schemas.openxmlformats.org/officeDocument/2006/relationships/image" Target="../media/image28.png"/><Relationship Id="rId4" Type="http://schemas.openxmlformats.org/officeDocument/2006/relationships/image" Target="../media/image2.svg"/><Relationship Id="rId9" Type="http://schemas.openxmlformats.org/officeDocument/2006/relationships/image" Target="../media/image6.png"/><Relationship Id="rId14" Type="http://schemas.openxmlformats.org/officeDocument/2006/relationships/image" Target="../media/image11.png"/><Relationship Id="rId22" Type="http://schemas.openxmlformats.org/officeDocument/2006/relationships/image" Target="../media/image19.png"/><Relationship Id="rId27" Type="http://schemas.openxmlformats.org/officeDocument/2006/relationships/image" Target="../media/image24.png"/><Relationship Id="rId30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F738B-9262-5B8F-6135-1FE306F46995}"/>
              </a:ext>
            </a:extLst>
          </p:cNvPr>
          <p:cNvSpPr txBox="1">
            <a:spLocks/>
          </p:cNvSpPr>
          <p:nvPr/>
        </p:nvSpPr>
        <p:spPr>
          <a:xfrm>
            <a:off x="149476" y="166740"/>
            <a:ext cx="11402613" cy="1016062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 w="38100">
            <a:solidFill>
              <a:schemeClr val="tx2">
                <a:lumMod val="90000"/>
                <a:lumOff val="10000"/>
              </a:schemeClr>
            </a:solidFill>
          </a:ln>
        </p:spPr>
        <p:txBody>
          <a:bodyPr>
            <a:normAutofit/>
          </a:bodyPr>
          <a:lstStyle>
            <a:lvl1pPr algn="l" defTabSz="914377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formin plus lifestyle interventions versus lifestyle interventions alone for the delay or prevention of type 2 diabetes in individuals with prediabetes: a meta-analysis of randomized controlled trials</a:t>
            </a:r>
            <a:endParaRPr lang="en-US" sz="2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3D901BB-5DA5-FEFE-54FA-CB8B1049B377}"/>
              </a:ext>
            </a:extLst>
          </p:cNvPr>
          <p:cNvSpPr txBox="1"/>
          <p:nvPr/>
        </p:nvSpPr>
        <p:spPr>
          <a:xfrm>
            <a:off x="130648" y="1295086"/>
            <a:ext cx="3241369" cy="369460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>
            <a:solidFill>
              <a:schemeClr val="tx2">
                <a:lumMod val="25000"/>
                <a:lumOff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1" b="1" dirty="0">
                <a:solidFill>
                  <a:schemeClr val="tx2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thod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3026BDB-C3C4-9B0E-350F-9FD4DBB5C8F0}"/>
              </a:ext>
            </a:extLst>
          </p:cNvPr>
          <p:cNvSpPr txBox="1"/>
          <p:nvPr/>
        </p:nvSpPr>
        <p:spPr>
          <a:xfrm>
            <a:off x="3461123" y="1290838"/>
            <a:ext cx="4155128" cy="369460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>
            <a:solidFill>
              <a:schemeClr val="tx2">
                <a:lumMod val="25000"/>
                <a:lumOff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1" b="1" dirty="0">
                <a:solidFill>
                  <a:schemeClr val="tx2">
                    <a:lumMod val="90000"/>
                    <a:lumOff val="1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igible studi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5BE162-0044-8749-DF96-9BC52210A969}"/>
              </a:ext>
            </a:extLst>
          </p:cNvPr>
          <p:cNvSpPr txBox="1"/>
          <p:nvPr/>
        </p:nvSpPr>
        <p:spPr>
          <a:xfrm>
            <a:off x="7727582" y="1278236"/>
            <a:ext cx="3824507" cy="369460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>
            <a:solidFill>
              <a:schemeClr val="tx2">
                <a:lumMod val="25000"/>
                <a:lumOff val="75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1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ndings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E17AA079-D1AD-CDF0-DD64-E91E287CB2FF}"/>
              </a:ext>
            </a:extLst>
          </p:cNvPr>
          <p:cNvSpPr txBox="1">
            <a:spLocks/>
          </p:cNvSpPr>
          <p:nvPr/>
        </p:nvSpPr>
        <p:spPr>
          <a:xfrm>
            <a:off x="130009" y="1755762"/>
            <a:ext cx="3260837" cy="5098549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</p:spPr>
        <p:txBody>
          <a:bodyPr vert="horz" lIns="91440" tIns="45721" rIns="91440" bIns="45721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endParaRPr lang="en-US" sz="1401" dirty="0"/>
          </a:p>
          <a:p>
            <a:pPr marL="0" indent="0" algn="ctr">
              <a:buNone/>
            </a:pPr>
            <a:endParaRPr lang="en-US" sz="1600" dirty="0"/>
          </a:p>
          <a:p>
            <a:pPr marL="0" indent="0">
              <a:buNone/>
            </a:pPr>
            <a:endParaRPr lang="en-US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C809621-8FEE-37C4-7982-B6F3D27A17A4}"/>
              </a:ext>
            </a:extLst>
          </p:cNvPr>
          <p:cNvSpPr txBox="1"/>
          <p:nvPr/>
        </p:nvSpPr>
        <p:spPr>
          <a:xfrm>
            <a:off x="270353" y="3110263"/>
            <a:ext cx="28909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up to March 20, 2024.</a:t>
            </a:r>
          </a:p>
        </p:txBody>
      </p:sp>
      <p:sp>
        <p:nvSpPr>
          <p:cNvPr id="15" name="Content Placeholder 2">
            <a:extLst>
              <a:ext uri="{FF2B5EF4-FFF2-40B4-BE49-F238E27FC236}">
                <a16:creationId xmlns:a16="http://schemas.microsoft.com/office/drawing/2014/main" id="{36094BF4-E7FC-2F36-9265-5C2B54630D74}"/>
              </a:ext>
            </a:extLst>
          </p:cNvPr>
          <p:cNvSpPr txBox="1">
            <a:spLocks/>
          </p:cNvSpPr>
          <p:nvPr/>
        </p:nvSpPr>
        <p:spPr>
          <a:xfrm>
            <a:off x="3461790" y="1755601"/>
            <a:ext cx="4155128" cy="5102118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</p:spPr>
        <p:txBody>
          <a:bodyPr vert="horz" lIns="91440" tIns="45721" rIns="91440" bIns="45721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endParaRPr lang="en-US" sz="1401" dirty="0"/>
          </a:p>
          <a:p>
            <a:pPr marL="0" indent="0" algn="ctr">
              <a:buNone/>
            </a:pPr>
            <a:endParaRPr lang="en-US" sz="1600" dirty="0"/>
          </a:p>
          <a:p>
            <a:pPr marL="0" indent="0">
              <a:buNone/>
            </a:pPr>
            <a:endParaRPr lang="en-US" sz="1600" dirty="0"/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3A6C05B1-EC92-F616-9891-DC227B3F6BC9}"/>
              </a:ext>
            </a:extLst>
          </p:cNvPr>
          <p:cNvGrpSpPr/>
          <p:nvPr/>
        </p:nvGrpSpPr>
        <p:grpSpPr>
          <a:xfrm>
            <a:off x="6253196" y="1881834"/>
            <a:ext cx="996339" cy="959098"/>
            <a:chOff x="8913801" y="2300952"/>
            <a:chExt cx="1284678" cy="1256291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A19B1A0C-0A0E-314F-9134-E5BE0C2E2AF7}"/>
                </a:ext>
              </a:extLst>
            </p:cNvPr>
            <p:cNvGrpSpPr/>
            <p:nvPr/>
          </p:nvGrpSpPr>
          <p:grpSpPr>
            <a:xfrm>
              <a:off x="8913801" y="2300952"/>
              <a:ext cx="1284678" cy="1256291"/>
              <a:chOff x="7829403" y="2150461"/>
              <a:chExt cx="1017046" cy="1091962"/>
            </a:xfrm>
          </p:grpSpPr>
          <p:sp>
            <p:nvSpPr>
              <p:cNvPr id="20" name="Oval 19">
                <a:extLst>
                  <a:ext uri="{FF2B5EF4-FFF2-40B4-BE49-F238E27FC236}">
                    <a16:creationId xmlns:a16="http://schemas.microsoft.com/office/drawing/2014/main" id="{1D315E4B-005E-C463-0491-F2D510DEBF10}"/>
                  </a:ext>
                </a:extLst>
              </p:cNvPr>
              <p:cNvSpPr/>
              <p:nvPr/>
            </p:nvSpPr>
            <p:spPr>
              <a:xfrm>
                <a:off x="7829403" y="2150461"/>
                <a:ext cx="1017046" cy="1091962"/>
              </a:xfrm>
              <a:prstGeom prst="ellipse">
                <a:avLst/>
              </a:prstGeom>
              <a:solidFill>
                <a:schemeClr val="tx2">
                  <a:lumMod val="90000"/>
                  <a:lumOff val="10000"/>
                </a:schemeClr>
              </a:solidFill>
              <a:ln>
                <a:solidFill>
                  <a:schemeClr val="tx2">
                    <a:lumMod val="90000"/>
                    <a:lumOff val="10000"/>
                  </a:schemeClr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1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5E22842-22AD-BD84-6896-4BC0C66F7E1F}"/>
                  </a:ext>
                </a:extLst>
              </p:cNvPr>
              <p:cNvSpPr txBox="1"/>
              <p:nvPr/>
            </p:nvSpPr>
            <p:spPr>
              <a:xfrm>
                <a:off x="8010868" y="2732668"/>
                <a:ext cx="654114" cy="385454"/>
              </a:xfrm>
              <a:prstGeom prst="rect">
                <a:avLst/>
              </a:prstGeom>
              <a:solidFill>
                <a:schemeClr val="tx2">
                  <a:lumMod val="90000"/>
                  <a:lumOff val="10000"/>
                </a:schemeClr>
              </a:solidFill>
              <a:ln>
                <a:solidFill>
                  <a:schemeClr val="tx2">
                    <a:lumMod val="90000"/>
                    <a:lumOff val="10000"/>
                  </a:schemeClr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solidFill>
                      <a:schemeClr val="bg1"/>
                    </a:solidFill>
                  </a:rPr>
                  <a:t>2720</a:t>
                </a:r>
              </a:p>
            </p:txBody>
          </p:sp>
        </p:grpSp>
        <p:pic>
          <p:nvPicPr>
            <p:cNvPr id="26" name="Graphic 25" descr="Group of people outline">
              <a:extLst>
                <a:ext uri="{FF2B5EF4-FFF2-40B4-BE49-F238E27FC236}">
                  <a16:creationId xmlns:a16="http://schemas.microsoft.com/office/drawing/2014/main" id="{A334ACC0-6EFC-DC9F-CA4F-73B05C1F2C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9226436" y="2363457"/>
              <a:ext cx="662395" cy="662395"/>
            </a:xfrm>
            <a:prstGeom prst="rect">
              <a:avLst/>
            </a:prstGeom>
          </p:spPr>
        </p:pic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1A2F6F48-07AA-0C6D-9A99-13FABABE6834}"/>
              </a:ext>
            </a:extLst>
          </p:cNvPr>
          <p:cNvGrpSpPr/>
          <p:nvPr/>
        </p:nvGrpSpPr>
        <p:grpSpPr>
          <a:xfrm>
            <a:off x="3835519" y="1881326"/>
            <a:ext cx="997001" cy="1000178"/>
            <a:chOff x="7829403" y="2150461"/>
            <a:chExt cx="1017046" cy="1091962"/>
          </a:xfrm>
          <a:solidFill>
            <a:schemeClr val="bg1"/>
          </a:solidFill>
        </p:grpSpPr>
        <p:sp>
          <p:nvSpPr>
            <p:cNvPr id="28" name="Oval 27">
              <a:extLst>
                <a:ext uri="{FF2B5EF4-FFF2-40B4-BE49-F238E27FC236}">
                  <a16:creationId xmlns:a16="http://schemas.microsoft.com/office/drawing/2014/main" id="{7C016395-17F5-A448-35BB-9A4F7E6080DA}"/>
                </a:ext>
              </a:extLst>
            </p:cNvPr>
            <p:cNvSpPr/>
            <p:nvPr/>
          </p:nvSpPr>
          <p:spPr>
            <a:xfrm>
              <a:off x="7829403" y="2150461"/>
              <a:ext cx="1017046" cy="1091962"/>
            </a:xfrm>
            <a:prstGeom prst="ellipse">
              <a:avLst/>
            </a:prstGeom>
            <a:solidFill>
              <a:schemeClr val="tx2">
                <a:lumMod val="90000"/>
                <a:lumOff val="10000"/>
              </a:schemeClr>
            </a:solidFill>
            <a:ln>
              <a:solidFill>
                <a:schemeClr val="tx2">
                  <a:lumMod val="90000"/>
                  <a:lumOff val="1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50055BD-F4DB-6BBC-4FEE-4ACF3A7FBA63}"/>
                </a:ext>
              </a:extLst>
            </p:cNvPr>
            <p:cNvSpPr txBox="1"/>
            <p:nvPr/>
          </p:nvSpPr>
          <p:spPr>
            <a:xfrm>
              <a:off x="7955574" y="2349992"/>
              <a:ext cx="757205" cy="638438"/>
            </a:xfrm>
            <a:prstGeom prst="rect">
              <a:avLst/>
            </a:prstGeom>
            <a:solidFill>
              <a:schemeClr val="tx2">
                <a:lumMod val="90000"/>
                <a:lumOff val="10000"/>
              </a:schemeClr>
            </a:solidFill>
            <a:ln>
              <a:solidFill>
                <a:schemeClr val="tx2">
                  <a:lumMod val="90000"/>
                  <a:lumOff val="1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b="1" dirty="0">
                  <a:solidFill>
                    <a:schemeClr val="bg1"/>
                  </a:solidFill>
                </a:rPr>
                <a:t>12 RCTs</a:t>
              </a:r>
            </a:p>
          </p:txBody>
        </p:sp>
      </p:grp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B869374A-2EFB-9893-5577-CB0F923106D1}"/>
              </a:ext>
            </a:extLst>
          </p:cNvPr>
          <p:cNvCxnSpPr>
            <a:cxnSpLocks/>
          </p:cNvCxnSpPr>
          <p:nvPr/>
        </p:nvCxnSpPr>
        <p:spPr>
          <a:xfrm flipV="1">
            <a:off x="5328715" y="2358590"/>
            <a:ext cx="513994" cy="6804"/>
          </a:xfrm>
          <a:prstGeom prst="straightConnector1">
            <a:avLst/>
          </a:prstGeom>
          <a:ln w="57150">
            <a:solidFill>
              <a:schemeClr val="tx2">
                <a:lumMod val="90000"/>
                <a:lumOff val="10000"/>
              </a:schemeClr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9" name="Group 78">
            <a:extLst>
              <a:ext uri="{FF2B5EF4-FFF2-40B4-BE49-F238E27FC236}">
                <a16:creationId xmlns:a16="http://schemas.microsoft.com/office/drawing/2014/main" id="{40FA09FD-B7B0-17FA-CA28-763ED862536F}"/>
              </a:ext>
            </a:extLst>
          </p:cNvPr>
          <p:cNvGrpSpPr/>
          <p:nvPr/>
        </p:nvGrpSpPr>
        <p:grpSpPr>
          <a:xfrm>
            <a:off x="4867017" y="3370836"/>
            <a:ext cx="662394" cy="690962"/>
            <a:chOff x="5823817" y="3793666"/>
            <a:chExt cx="1284678" cy="1256291"/>
          </a:xfrm>
        </p:grpSpPr>
        <p:sp>
          <p:nvSpPr>
            <p:cNvPr id="75" name="Oval 74">
              <a:extLst>
                <a:ext uri="{FF2B5EF4-FFF2-40B4-BE49-F238E27FC236}">
                  <a16:creationId xmlns:a16="http://schemas.microsoft.com/office/drawing/2014/main" id="{961910AA-8C13-DDD3-13F5-AEA3DBB15C3D}"/>
                </a:ext>
              </a:extLst>
            </p:cNvPr>
            <p:cNvSpPr/>
            <p:nvPr/>
          </p:nvSpPr>
          <p:spPr>
            <a:xfrm>
              <a:off x="5823817" y="3793666"/>
              <a:ext cx="1284678" cy="1256291"/>
            </a:xfrm>
            <a:prstGeom prst="ellipse">
              <a:avLst/>
            </a:prstGeom>
            <a:solidFill>
              <a:schemeClr val="tx2">
                <a:lumMod val="90000"/>
                <a:lumOff val="10000"/>
              </a:schemeClr>
            </a:solidFill>
            <a:ln>
              <a:solidFill>
                <a:schemeClr val="tx2">
                  <a:lumMod val="90000"/>
                  <a:lumOff val="1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pic>
          <p:nvPicPr>
            <p:cNvPr id="77" name="Graphic 76" descr="Medicine with solid fill">
              <a:extLst>
                <a:ext uri="{FF2B5EF4-FFF2-40B4-BE49-F238E27FC236}">
                  <a16:creationId xmlns:a16="http://schemas.microsoft.com/office/drawing/2014/main" id="{69E511A6-53A2-A46E-1481-D005CF71E8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6070212" y="3993585"/>
              <a:ext cx="882856" cy="882856"/>
            </a:xfrm>
            <a:prstGeom prst="rect">
              <a:avLst/>
            </a:prstGeom>
          </p:spPr>
        </p:pic>
      </p:grpSp>
      <p:sp>
        <p:nvSpPr>
          <p:cNvPr id="106" name="Content Placeholder 2">
            <a:extLst>
              <a:ext uri="{FF2B5EF4-FFF2-40B4-BE49-F238E27FC236}">
                <a16:creationId xmlns:a16="http://schemas.microsoft.com/office/drawing/2014/main" id="{36A79B96-19C4-B6EB-5586-A2B415AE11B5}"/>
              </a:ext>
            </a:extLst>
          </p:cNvPr>
          <p:cNvSpPr txBox="1">
            <a:spLocks/>
          </p:cNvSpPr>
          <p:nvPr/>
        </p:nvSpPr>
        <p:spPr>
          <a:xfrm>
            <a:off x="7714711" y="1753262"/>
            <a:ext cx="3859918" cy="5098549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</p:spPr>
        <p:txBody>
          <a:bodyPr vert="horz" lIns="91440" tIns="45721" rIns="91440" bIns="45721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endParaRPr lang="en-US" sz="1401" dirty="0"/>
          </a:p>
          <a:p>
            <a:pPr marL="0" indent="0" algn="ctr">
              <a:buNone/>
            </a:pPr>
            <a:endParaRPr lang="en-US" sz="1600" dirty="0"/>
          </a:p>
          <a:p>
            <a:pPr marL="0" indent="0">
              <a:buNone/>
            </a:pPr>
            <a:endParaRPr lang="en-US" sz="1600" dirty="0"/>
          </a:p>
        </p:txBody>
      </p:sp>
      <p:pic>
        <p:nvPicPr>
          <p:cNvPr id="107" name="Picture 106">
            <a:extLst>
              <a:ext uri="{FF2B5EF4-FFF2-40B4-BE49-F238E27FC236}">
                <a16:creationId xmlns:a16="http://schemas.microsoft.com/office/drawing/2014/main" id="{6BDCE33C-9B1C-D0E2-D937-2E558697BC80}"/>
              </a:ext>
            </a:extLst>
          </p:cNvPr>
          <p:cNvPicPr>
            <a:picLocks noChangeAspect="1"/>
          </p:cNvPicPr>
          <p:nvPr/>
        </p:nvPicPr>
        <p:blipFill>
          <a:blip r:embed="rId7">
            <a:alphaModFix/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artisticWatercolorSponge/>
                    </a14:imgEffect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6649" y="5143273"/>
            <a:ext cx="657351" cy="657351"/>
          </a:xfrm>
          <a:prstGeom prst="rect">
            <a:avLst/>
          </a:prstGeom>
        </p:spPr>
      </p:pic>
      <p:pic>
        <p:nvPicPr>
          <p:cNvPr id="108" name="Graphic 107" descr="Weight Loss outline">
            <a:extLst>
              <a:ext uri="{FF2B5EF4-FFF2-40B4-BE49-F238E27FC236}">
                <a16:creationId xmlns:a16="http://schemas.microsoft.com/office/drawing/2014/main" id="{F12904AF-0672-D910-F4EF-74F415541E5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6385756" y="5084238"/>
            <a:ext cx="731216" cy="731216"/>
          </a:xfrm>
          <a:prstGeom prst="rect">
            <a:avLst/>
          </a:prstGeom>
        </p:spPr>
      </p:pic>
      <p:pic>
        <p:nvPicPr>
          <p:cNvPr id="109" name="Picture 108" descr="A stethoscope with a pressure gauge&#10;&#10;Description automatically generated">
            <a:extLst>
              <a:ext uri="{FF2B5EF4-FFF2-40B4-BE49-F238E27FC236}">
                <a16:creationId xmlns:a16="http://schemas.microsoft.com/office/drawing/2014/main" id="{CBDED941-9E8A-02D6-CAB5-D2E96B1C6F47}"/>
              </a:ext>
            </a:extLst>
          </p:cNvPr>
          <p:cNvPicPr>
            <a:picLocks noChangeAspect="1"/>
          </p:cNvPicPr>
          <p:nvPr/>
        </p:nvPicPr>
        <p:blipFill>
          <a:blip r:embed="rId11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1606" y="5138446"/>
            <a:ext cx="662761" cy="657351"/>
          </a:xfrm>
          <a:prstGeom prst="rect">
            <a:avLst/>
          </a:prstGeom>
          <a:noFill/>
          <a:ln>
            <a:noFill/>
          </a:ln>
        </p:spPr>
      </p:pic>
      <p:sp>
        <p:nvSpPr>
          <p:cNvPr id="110" name="TextBox 109">
            <a:extLst>
              <a:ext uri="{FF2B5EF4-FFF2-40B4-BE49-F238E27FC236}">
                <a16:creationId xmlns:a16="http://schemas.microsoft.com/office/drawing/2014/main" id="{A4285F1D-DDCE-82A1-19D8-46EDBAEFC2A6}"/>
              </a:ext>
            </a:extLst>
          </p:cNvPr>
          <p:cNvSpPr txBox="1"/>
          <p:nvPr/>
        </p:nvSpPr>
        <p:spPr>
          <a:xfrm>
            <a:off x="3498845" y="5765020"/>
            <a:ext cx="144928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FPG</a:t>
            </a:r>
          </a:p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HbA1c</a:t>
            </a:r>
          </a:p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Incidence of T2DM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C429F5CF-02B2-E567-8B92-36F3CE8927D5}"/>
              </a:ext>
            </a:extLst>
          </p:cNvPr>
          <p:cNvSpPr txBox="1"/>
          <p:nvPr/>
        </p:nvSpPr>
        <p:spPr>
          <a:xfrm>
            <a:off x="4845212" y="6009579"/>
            <a:ext cx="96700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SBP</a:t>
            </a:r>
          </a:p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DBP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5233351F-C02E-90E5-4EC9-799BE5B5E1DB}"/>
              </a:ext>
            </a:extLst>
          </p:cNvPr>
          <p:cNvSpPr txBox="1"/>
          <p:nvPr/>
        </p:nvSpPr>
        <p:spPr>
          <a:xfrm>
            <a:off x="5790533" y="5763358"/>
            <a:ext cx="1841383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BMI</a:t>
            </a:r>
          </a:p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Body weight</a:t>
            </a:r>
          </a:p>
          <a:p>
            <a:pPr marL="285745" indent="-285745">
              <a:buFont typeface="Wingdings" panose="05000000000000000000" pitchFamily="2" charset="2"/>
              <a:buChar char="§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Waist circumference</a:t>
            </a:r>
          </a:p>
        </p:txBody>
      </p:sp>
      <p:grpSp>
        <p:nvGrpSpPr>
          <p:cNvPr id="137" name="Group 136">
            <a:extLst>
              <a:ext uri="{FF2B5EF4-FFF2-40B4-BE49-F238E27FC236}">
                <a16:creationId xmlns:a16="http://schemas.microsoft.com/office/drawing/2014/main" id="{D16EC3B7-C9AB-F0F8-FEF5-1ED015096B65}"/>
              </a:ext>
            </a:extLst>
          </p:cNvPr>
          <p:cNvGrpSpPr/>
          <p:nvPr/>
        </p:nvGrpSpPr>
        <p:grpSpPr>
          <a:xfrm>
            <a:off x="3679869" y="3366404"/>
            <a:ext cx="662396" cy="668797"/>
            <a:chOff x="4914465" y="4980125"/>
            <a:chExt cx="1284678" cy="1256291"/>
          </a:xfrm>
        </p:grpSpPr>
        <p:sp>
          <p:nvSpPr>
            <p:cNvPr id="138" name="Oval 137">
              <a:extLst>
                <a:ext uri="{FF2B5EF4-FFF2-40B4-BE49-F238E27FC236}">
                  <a16:creationId xmlns:a16="http://schemas.microsoft.com/office/drawing/2014/main" id="{7D70A1BF-F2A2-E014-CB02-7039E1FE0D10}"/>
                </a:ext>
              </a:extLst>
            </p:cNvPr>
            <p:cNvSpPr/>
            <p:nvPr/>
          </p:nvSpPr>
          <p:spPr>
            <a:xfrm>
              <a:off x="4914465" y="4980125"/>
              <a:ext cx="1284678" cy="1256291"/>
            </a:xfrm>
            <a:prstGeom prst="ellipse">
              <a:avLst/>
            </a:prstGeom>
            <a:solidFill>
              <a:schemeClr val="tx2">
                <a:lumMod val="90000"/>
                <a:lumOff val="10000"/>
              </a:schemeClr>
            </a:solidFill>
            <a:ln>
              <a:solidFill>
                <a:schemeClr val="tx2">
                  <a:lumMod val="90000"/>
                  <a:lumOff val="1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399C06AD-978E-889C-D438-E756729278CB}"/>
                </a:ext>
              </a:extLst>
            </p:cNvPr>
            <p:cNvGrpSpPr/>
            <p:nvPr/>
          </p:nvGrpSpPr>
          <p:grpSpPr>
            <a:xfrm>
              <a:off x="5011940" y="5033536"/>
              <a:ext cx="1110845" cy="1114496"/>
              <a:chOff x="8914041" y="3222562"/>
              <a:chExt cx="1229018" cy="1277883"/>
            </a:xfrm>
          </p:grpSpPr>
          <p:pic>
            <p:nvPicPr>
              <p:cNvPr id="140" name="Graphic 139" descr="Grocery bag with solid fill">
                <a:extLst>
                  <a:ext uri="{FF2B5EF4-FFF2-40B4-BE49-F238E27FC236}">
                    <a16:creationId xmlns:a16="http://schemas.microsoft.com/office/drawing/2014/main" id="{47C79825-840E-3462-4EA4-08B258D918F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9275488" y="3567979"/>
                <a:ext cx="507159" cy="507160"/>
              </a:xfrm>
              <a:prstGeom prst="rect">
                <a:avLst/>
              </a:prstGeom>
            </p:spPr>
          </p:pic>
          <p:grpSp>
            <p:nvGrpSpPr>
              <p:cNvPr id="141" name="Graphic 13" descr="Swimming outline">
                <a:extLst>
                  <a:ext uri="{FF2B5EF4-FFF2-40B4-BE49-F238E27FC236}">
                    <a16:creationId xmlns:a16="http://schemas.microsoft.com/office/drawing/2014/main" id="{69672E74-0769-7DCE-6C60-B845A65B34C8}"/>
                  </a:ext>
                </a:extLst>
              </p:cNvPr>
              <p:cNvGrpSpPr/>
              <p:nvPr/>
            </p:nvGrpSpPr>
            <p:grpSpPr>
              <a:xfrm>
                <a:off x="9078305" y="3222562"/>
                <a:ext cx="420722" cy="369332"/>
                <a:chOff x="6033758" y="4148441"/>
                <a:chExt cx="763409" cy="525370"/>
              </a:xfrm>
              <a:solidFill>
                <a:srgbClr val="000000"/>
              </a:solidFill>
            </p:grpSpPr>
            <p:sp>
              <p:nvSpPr>
                <p:cNvPr id="151" name="Freeform: Shape 150">
                  <a:extLst>
                    <a:ext uri="{FF2B5EF4-FFF2-40B4-BE49-F238E27FC236}">
                      <a16:creationId xmlns:a16="http://schemas.microsoft.com/office/drawing/2014/main" id="{BFC1135D-FC4D-7616-60C8-9263DB48F5D4}"/>
                    </a:ext>
                  </a:extLst>
                </p:cNvPr>
                <p:cNvSpPr/>
                <p:nvPr/>
              </p:nvSpPr>
              <p:spPr>
                <a:xfrm>
                  <a:off x="6160184" y="4148441"/>
                  <a:ext cx="493033" cy="397154"/>
                </a:xfrm>
                <a:custGeom>
                  <a:avLst/>
                  <a:gdLst>
                    <a:gd name="connsiteX0" fmla="*/ 241935 w 493033"/>
                    <a:gd name="connsiteY0" fmla="*/ 238792 h 397154"/>
                    <a:gd name="connsiteX1" fmla="*/ 0 w 493033"/>
                    <a:gd name="connsiteY1" fmla="*/ 382248 h 397154"/>
                    <a:gd name="connsiteX2" fmla="*/ 26432 w 493033"/>
                    <a:gd name="connsiteY2" fmla="*/ 388725 h 397154"/>
                    <a:gd name="connsiteX3" fmla="*/ 251670 w 493033"/>
                    <a:gd name="connsiteY3" fmla="*/ 255175 h 397154"/>
                    <a:gd name="connsiteX4" fmla="*/ 267129 w 493033"/>
                    <a:gd name="connsiteY4" fmla="*/ 246012 h 397154"/>
                    <a:gd name="connsiteX5" fmla="*/ 258880 w 493033"/>
                    <a:gd name="connsiteY5" fmla="*/ 230095 h 397154"/>
                    <a:gd name="connsiteX6" fmla="*/ 200625 w 493033"/>
                    <a:gd name="connsiteY6" fmla="*/ 117338 h 397154"/>
                    <a:gd name="connsiteX7" fmla="*/ 200406 w 493033"/>
                    <a:gd name="connsiteY7" fmla="*/ 92935 h 397154"/>
                    <a:gd name="connsiteX8" fmla="*/ 219142 w 493033"/>
                    <a:gd name="connsiteY8" fmla="*/ 77191 h 397154"/>
                    <a:gd name="connsiteX9" fmla="*/ 438217 w 493033"/>
                    <a:gd name="connsiteY9" fmla="*/ 20041 h 397154"/>
                    <a:gd name="connsiteX10" fmla="*/ 445608 w 493033"/>
                    <a:gd name="connsiteY10" fmla="*/ 19088 h 397154"/>
                    <a:gd name="connsiteX11" fmla="*/ 474001 w 493033"/>
                    <a:gd name="connsiteY11" fmla="*/ 48090 h 397154"/>
                    <a:gd name="connsiteX12" fmla="*/ 452447 w 493033"/>
                    <a:gd name="connsiteY12" fmla="*/ 75581 h 397154"/>
                    <a:gd name="connsiteX13" fmla="*/ 291475 w 493033"/>
                    <a:gd name="connsiteY13" fmla="*/ 117491 h 397154"/>
                    <a:gd name="connsiteX14" fmla="*/ 268338 w 493033"/>
                    <a:gd name="connsiteY14" fmla="*/ 123511 h 397154"/>
                    <a:gd name="connsiteX15" fmla="*/ 279368 w 493033"/>
                    <a:gd name="connsiteY15" fmla="*/ 144713 h 397154"/>
                    <a:gd name="connsiteX16" fmla="*/ 406117 w 493033"/>
                    <a:gd name="connsiteY16" fmla="*/ 388210 h 397154"/>
                    <a:gd name="connsiteX17" fmla="*/ 421872 w 493033"/>
                    <a:gd name="connsiteY17" fmla="*/ 393925 h 397154"/>
                    <a:gd name="connsiteX18" fmla="*/ 432254 w 493033"/>
                    <a:gd name="connsiteY18" fmla="*/ 397154 h 397154"/>
                    <a:gd name="connsiteX19" fmla="*/ 296228 w 493033"/>
                    <a:gd name="connsiteY19" fmla="*/ 135893 h 397154"/>
                    <a:gd name="connsiteX20" fmla="*/ 457200 w 493033"/>
                    <a:gd name="connsiteY20" fmla="*/ 93983 h 397154"/>
                    <a:gd name="connsiteX21" fmla="*/ 491508 w 493033"/>
                    <a:gd name="connsiteY21" fmla="*/ 35821 h 397154"/>
                    <a:gd name="connsiteX22" fmla="*/ 445560 w 493033"/>
                    <a:gd name="connsiteY22" fmla="*/ 0 h 397154"/>
                    <a:gd name="connsiteX23" fmla="*/ 433387 w 493033"/>
                    <a:gd name="connsiteY23" fmla="*/ 1562 h 397154"/>
                    <a:gd name="connsiteX24" fmla="*/ 214313 w 493033"/>
                    <a:gd name="connsiteY24" fmla="*/ 58712 h 397154"/>
                    <a:gd name="connsiteX25" fmla="*/ 182880 w 493033"/>
                    <a:gd name="connsiteY25" fmla="*/ 85382 h 397154"/>
                    <a:gd name="connsiteX26" fmla="*/ 183833 w 493033"/>
                    <a:gd name="connsiteY26" fmla="*/ 126340 h 3971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</a:cxnLst>
                  <a:rect l="l" t="t" r="r" b="b"/>
                  <a:pathLst>
                    <a:path w="493033" h="397154">
                      <a:moveTo>
                        <a:pt x="241935" y="238792"/>
                      </a:moveTo>
                      <a:lnTo>
                        <a:pt x="0" y="382248"/>
                      </a:lnTo>
                      <a:cubicBezTo>
                        <a:pt x="8950" y="383794"/>
                        <a:pt x="17781" y="385958"/>
                        <a:pt x="26432" y="388725"/>
                      </a:cubicBezTo>
                      <a:lnTo>
                        <a:pt x="251670" y="255175"/>
                      </a:lnTo>
                      <a:lnTo>
                        <a:pt x="267129" y="246012"/>
                      </a:lnTo>
                      <a:lnTo>
                        <a:pt x="258880" y="230095"/>
                      </a:lnTo>
                      <a:lnTo>
                        <a:pt x="200625" y="117338"/>
                      </a:lnTo>
                      <a:cubicBezTo>
                        <a:pt x="196898" y="109648"/>
                        <a:pt x="196818" y="100692"/>
                        <a:pt x="200406" y="92935"/>
                      </a:cubicBezTo>
                      <a:cubicBezTo>
                        <a:pt x="203850" y="85050"/>
                        <a:pt x="210781" y="79225"/>
                        <a:pt x="219142" y="77191"/>
                      </a:cubicBezTo>
                      <a:lnTo>
                        <a:pt x="438217" y="20041"/>
                      </a:lnTo>
                      <a:cubicBezTo>
                        <a:pt x="440630" y="19415"/>
                        <a:pt x="443114" y="19095"/>
                        <a:pt x="445608" y="19088"/>
                      </a:cubicBezTo>
                      <a:cubicBezTo>
                        <a:pt x="461457" y="19257"/>
                        <a:pt x="474169" y="32241"/>
                        <a:pt x="474001" y="48090"/>
                      </a:cubicBezTo>
                      <a:cubicBezTo>
                        <a:pt x="473863" y="61074"/>
                        <a:pt x="465024" y="72349"/>
                        <a:pt x="452447" y="75581"/>
                      </a:cubicBezTo>
                      <a:lnTo>
                        <a:pt x="291475" y="117491"/>
                      </a:lnTo>
                      <a:lnTo>
                        <a:pt x="268338" y="123511"/>
                      </a:lnTo>
                      <a:lnTo>
                        <a:pt x="279368" y="144713"/>
                      </a:lnTo>
                      <a:lnTo>
                        <a:pt x="406117" y="388210"/>
                      </a:lnTo>
                      <a:cubicBezTo>
                        <a:pt x="411451" y="389906"/>
                        <a:pt x="416700" y="391801"/>
                        <a:pt x="421872" y="393925"/>
                      </a:cubicBezTo>
                      <a:cubicBezTo>
                        <a:pt x="425271" y="395190"/>
                        <a:pt x="428737" y="396268"/>
                        <a:pt x="432254" y="397154"/>
                      </a:cubicBezTo>
                      <a:lnTo>
                        <a:pt x="296228" y="135893"/>
                      </a:lnTo>
                      <a:lnTo>
                        <a:pt x="457200" y="93983"/>
                      </a:lnTo>
                      <a:cubicBezTo>
                        <a:pt x="482735" y="87396"/>
                        <a:pt x="498096" y="61356"/>
                        <a:pt x="491508" y="35821"/>
                      </a:cubicBezTo>
                      <a:cubicBezTo>
                        <a:pt x="486095" y="14837"/>
                        <a:pt x="467231" y="130"/>
                        <a:pt x="445560" y="0"/>
                      </a:cubicBezTo>
                      <a:cubicBezTo>
                        <a:pt x="441453" y="3"/>
                        <a:pt x="437362" y="528"/>
                        <a:pt x="433387" y="1562"/>
                      </a:cubicBezTo>
                      <a:lnTo>
                        <a:pt x="214313" y="58712"/>
                      </a:lnTo>
                      <a:cubicBezTo>
                        <a:pt x="200259" y="62234"/>
                        <a:pt x="188643" y="72090"/>
                        <a:pt x="182880" y="85382"/>
                      </a:cubicBezTo>
                      <a:cubicBezTo>
                        <a:pt x="176984" y="98475"/>
                        <a:pt x="177335" y="113534"/>
                        <a:pt x="183833" y="12634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152" name="Freeform: Shape 151">
                  <a:extLst>
                    <a:ext uri="{FF2B5EF4-FFF2-40B4-BE49-F238E27FC236}">
                      <a16:creationId xmlns:a16="http://schemas.microsoft.com/office/drawing/2014/main" id="{407EF8C8-0446-8661-ADD9-9CBA6539E48B}"/>
                    </a:ext>
                  </a:extLst>
                </p:cNvPr>
                <p:cNvSpPr/>
                <p:nvPr/>
              </p:nvSpPr>
              <p:spPr>
                <a:xfrm>
                  <a:off x="6033758" y="4555882"/>
                  <a:ext cx="763409" cy="40052"/>
                </a:xfrm>
                <a:custGeom>
                  <a:avLst/>
                  <a:gdLst>
                    <a:gd name="connsiteX0" fmla="*/ 572195 w 763409"/>
                    <a:gd name="connsiteY0" fmla="*/ 40024 h 40052"/>
                    <a:gd name="connsiteX1" fmla="*/ 571519 w 763409"/>
                    <a:gd name="connsiteY1" fmla="*/ 40024 h 40052"/>
                    <a:gd name="connsiteX2" fmla="*/ 530676 w 763409"/>
                    <a:gd name="connsiteY2" fmla="*/ 30851 h 40052"/>
                    <a:gd name="connsiteX3" fmla="*/ 476488 w 763409"/>
                    <a:gd name="connsiteY3" fmla="*/ 19079 h 40052"/>
                    <a:gd name="connsiteX4" fmla="*/ 423491 w 763409"/>
                    <a:gd name="connsiteY4" fmla="*/ 30737 h 40052"/>
                    <a:gd name="connsiteX5" fmla="*/ 382362 w 763409"/>
                    <a:gd name="connsiteY5" fmla="*/ 40024 h 40052"/>
                    <a:gd name="connsiteX6" fmla="*/ 381686 w 763409"/>
                    <a:gd name="connsiteY6" fmla="*/ 40024 h 40052"/>
                    <a:gd name="connsiteX7" fmla="*/ 381010 w 763409"/>
                    <a:gd name="connsiteY7" fmla="*/ 40024 h 40052"/>
                    <a:gd name="connsiteX8" fmla="*/ 340166 w 763409"/>
                    <a:gd name="connsiteY8" fmla="*/ 30851 h 40052"/>
                    <a:gd name="connsiteX9" fmla="*/ 285979 w 763409"/>
                    <a:gd name="connsiteY9" fmla="*/ 19079 h 40052"/>
                    <a:gd name="connsiteX10" fmla="*/ 232982 w 763409"/>
                    <a:gd name="connsiteY10" fmla="*/ 30737 h 40052"/>
                    <a:gd name="connsiteX11" fmla="*/ 191853 w 763409"/>
                    <a:gd name="connsiteY11" fmla="*/ 40024 h 40052"/>
                    <a:gd name="connsiteX12" fmla="*/ 191176 w 763409"/>
                    <a:gd name="connsiteY12" fmla="*/ 40024 h 40052"/>
                    <a:gd name="connsiteX13" fmla="*/ 190500 w 763409"/>
                    <a:gd name="connsiteY13" fmla="*/ 40024 h 40052"/>
                    <a:gd name="connsiteX14" fmla="*/ 149657 w 763409"/>
                    <a:gd name="connsiteY14" fmla="*/ 30851 h 40052"/>
                    <a:gd name="connsiteX15" fmla="*/ 95469 w 763409"/>
                    <a:gd name="connsiteY15" fmla="*/ 19079 h 40052"/>
                    <a:gd name="connsiteX16" fmla="*/ 42472 w 763409"/>
                    <a:gd name="connsiteY16" fmla="*/ 30737 h 40052"/>
                    <a:gd name="connsiteX17" fmla="*/ 1343 w 763409"/>
                    <a:gd name="connsiteY17" fmla="*/ 40024 h 40052"/>
                    <a:gd name="connsiteX18" fmla="*/ 0 w 763409"/>
                    <a:gd name="connsiteY18" fmla="*/ 20974 h 40052"/>
                    <a:gd name="connsiteX19" fmla="*/ 35357 w 763409"/>
                    <a:gd name="connsiteY19" fmla="*/ 13021 h 40052"/>
                    <a:gd name="connsiteX20" fmla="*/ 95469 w 763409"/>
                    <a:gd name="connsiteY20" fmla="*/ 0 h 40052"/>
                    <a:gd name="connsiteX21" fmla="*/ 156801 w 763409"/>
                    <a:gd name="connsiteY21" fmla="*/ 13154 h 40052"/>
                    <a:gd name="connsiteX22" fmla="*/ 191195 w 763409"/>
                    <a:gd name="connsiteY22" fmla="*/ 20926 h 40052"/>
                    <a:gd name="connsiteX23" fmla="*/ 225885 w 763409"/>
                    <a:gd name="connsiteY23" fmla="*/ 13021 h 40052"/>
                    <a:gd name="connsiteX24" fmla="*/ 285998 w 763409"/>
                    <a:gd name="connsiteY24" fmla="*/ 0 h 40052"/>
                    <a:gd name="connsiteX25" fmla="*/ 347310 w 763409"/>
                    <a:gd name="connsiteY25" fmla="*/ 13154 h 40052"/>
                    <a:gd name="connsiteX26" fmla="*/ 381695 w 763409"/>
                    <a:gd name="connsiteY26" fmla="*/ 20926 h 40052"/>
                    <a:gd name="connsiteX27" fmla="*/ 416385 w 763409"/>
                    <a:gd name="connsiteY27" fmla="*/ 13021 h 40052"/>
                    <a:gd name="connsiteX28" fmla="*/ 476498 w 763409"/>
                    <a:gd name="connsiteY28" fmla="*/ 0 h 40052"/>
                    <a:gd name="connsiteX29" fmla="*/ 537820 w 763409"/>
                    <a:gd name="connsiteY29" fmla="*/ 13154 h 40052"/>
                    <a:gd name="connsiteX30" fmla="*/ 572195 w 763409"/>
                    <a:gd name="connsiteY30" fmla="*/ 20926 h 40052"/>
                    <a:gd name="connsiteX31" fmla="*/ 606885 w 763409"/>
                    <a:gd name="connsiteY31" fmla="*/ 13021 h 40052"/>
                    <a:gd name="connsiteX32" fmla="*/ 666998 w 763409"/>
                    <a:gd name="connsiteY32" fmla="*/ 0 h 40052"/>
                    <a:gd name="connsiteX33" fmla="*/ 728329 w 763409"/>
                    <a:gd name="connsiteY33" fmla="*/ 13154 h 40052"/>
                    <a:gd name="connsiteX34" fmla="*/ 763410 w 763409"/>
                    <a:gd name="connsiteY34" fmla="*/ 21003 h 40052"/>
                    <a:gd name="connsiteX35" fmla="*/ 762057 w 763409"/>
                    <a:gd name="connsiteY35" fmla="*/ 40053 h 40052"/>
                    <a:gd name="connsiteX36" fmla="*/ 721214 w 763409"/>
                    <a:gd name="connsiteY36" fmla="*/ 30880 h 40052"/>
                    <a:gd name="connsiteX37" fmla="*/ 667026 w 763409"/>
                    <a:gd name="connsiteY37" fmla="*/ 19107 h 40052"/>
                    <a:gd name="connsiteX38" fmla="*/ 614029 w 763409"/>
                    <a:gd name="connsiteY38" fmla="*/ 30766 h 40052"/>
                    <a:gd name="connsiteX39" fmla="*/ 572900 w 763409"/>
                    <a:gd name="connsiteY39" fmla="*/ 40053 h 4005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763409" h="40052">
                      <a:moveTo>
                        <a:pt x="572195" y="40024"/>
                      </a:moveTo>
                      <a:lnTo>
                        <a:pt x="571519" y="40024"/>
                      </a:lnTo>
                      <a:cubicBezTo>
                        <a:pt x="557522" y="39031"/>
                        <a:pt x="543754" y="35939"/>
                        <a:pt x="530676" y="30851"/>
                      </a:cubicBezTo>
                      <a:cubicBezTo>
                        <a:pt x="513463" y="23717"/>
                        <a:pt x="495110" y="19730"/>
                        <a:pt x="476488" y="19079"/>
                      </a:cubicBezTo>
                      <a:cubicBezTo>
                        <a:pt x="458273" y="19813"/>
                        <a:pt x="440332" y="23760"/>
                        <a:pt x="423491" y="30737"/>
                      </a:cubicBezTo>
                      <a:cubicBezTo>
                        <a:pt x="410327" y="35885"/>
                        <a:pt x="396461" y="39015"/>
                        <a:pt x="382362" y="40024"/>
                      </a:cubicBezTo>
                      <a:lnTo>
                        <a:pt x="381686" y="40024"/>
                      </a:lnTo>
                      <a:lnTo>
                        <a:pt x="381010" y="40024"/>
                      </a:lnTo>
                      <a:cubicBezTo>
                        <a:pt x="367013" y="39031"/>
                        <a:pt x="353244" y="35939"/>
                        <a:pt x="340166" y="30851"/>
                      </a:cubicBezTo>
                      <a:cubicBezTo>
                        <a:pt x="322954" y="23717"/>
                        <a:pt x="304600" y="19730"/>
                        <a:pt x="285979" y="19079"/>
                      </a:cubicBezTo>
                      <a:cubicBezTo>
                        <a:pt x="267764" y="19813"/>
                        <a:pt x="249823" y="23760"/>
                        <a:pt x="232982" y="30737"/>
                      </a:cubicBezTo>
                      <a:cubicBezTo>
                        <a:pt x="219817" y="35885"/>
                        <a:pt x="205951" y="39015"/>
                        <a:pt x="191853" y="40024"/>
                      </a:cubicBezTo>
                      <a:lnTo>
                        <a:pt x="191176" y="40024"/>
                      </a:lnTo>
                      <a:lnTo>
                        <a:pt x="190500" y="40024"/>
                      </a:lnTo>
                      <a:cubicBezTo>
                        <a:pt x="176503" y="39031"/>
                        <a:pt x="162735" y="35939"/>
                        <a:pt x="149657" y="30851"/>
                      </a:cubicBezTo>
                      <a:cubicBezTo>
                        <a:pt x="132444" y="23717"/>
                        <a:pt x="114090" y="19730"/>
                        <a:pt x="95469" y="19079"/>
                      </a:cubicBezTo>
                      <a:cubicBezTo>
                        <a:pt x="77254" y="19813"/>
                        <a:pt x="59313" y="23760"/>
                        <a:pt x="42472" y="30737"/>
                      </a:cubicBezTo>
                      <a:cubicBezTo>
                        <a:pt x="29307" y="35885"/>
                        <a:pt x="15442" y="39015"/>
                        <a:pt x="1343" y="40024"/>
                      </a:cubicBezTo>
                      <a:lnTo>
                        <a:pt x="0" y="20974"/>
                      </a:lnTo>
                      <a:cubicBezTo>
                        <a:pt x="12118" y="20110"/>
                        <a:pt x="24036" y="17429"/>
                        <a:pt x="35357" y="13021"/>
                      </a:cubicBezTo>
                      <a:cubicBezTo>
                        <a:pt x="54461" y="5142"/>
                        <a:pt x="74817" y="732"/>
                        <a:pt x="95469" y="0"/>
                      </a:cubicBezTo>
                      <a:cubicBezTo>
                        <a:pt x="116538" y="656"/>
                        <a:pt x="137315" y="5112"/>
                        <a:pt x="156801" y="13154"/>
                      </a:cubicBezTo>
                      <a:cubicBezTo>
                        <a:pt x="167824" y="17411"/>
                        <a:pt x="179412" y="20029"/>
                        <a:pt x="191195" y="20926"/>
                      </a:cubicBezTo>
                      <a:cubicBezTo>
                        <a:pt x="203083" y="20006"/>
                        <a:pt x="214773" y="17342"/>
                        <a:pt x="225885" y="13021"/>
                      </a:cubicBezTo>
                      <a:cubicBezTo>
                        <a:pt x="244990" y="5142"/>
                        <a:pt x="265346" y="732"/>
                        <a:pt x="285998" y="0"/>
                      </a:cubicBezTo>
                      <a:cubicBezTo>
                        <a:pt x="307060" y="658"/>
                        <a:pt x="327831" y="5114"/>
                        <a:pt x="347310" y="13154"/>
                      </a:cubicBezTo>
                      <a:cubicBezTo>
                        <a:pt x="358331" y="17410"/>
                        <a:pt x="369916" y="20028"/>
                        <a:pt x="381695" y="20926"/>
                      </a:cubicBezTo>
                      <a:cubicBezTo>
                        <a:pt x="393583" y="20006"/>
                        <a:pt x="405273" y="17342"/>
                        <a:pt x="416385" y="13021"/>
                      </a:cubicBezTo>
                      <a:cubicBezTo>
                        <a:pt x="435490" y="5142"/>
                        <a:pt x="455846" y="732"/>
                        <a:pt x="476498" y="0"/>
                      </a:cubicBezTo>
                      <a:cubicBezTo>
                        <a:pt x="497563" y="657"/>
                        <a:pt x="518337" y="5113"/>
                        <a:pt x="537820" y="13154"/>
                      </a:cubicBezTo>
                      <a:cubicBezTo>
                        <a:pt x="548837" y="17409"/>
                        <a:pt x="560419" y="20027"/>
                        <a:pt x="572195" y="20926"/>
                      </a:cubicBezTo>
                      <a:cubicBezTo>
                        <a:pt x="584084" y="20006"/>
                        <a:pt x="595773" y="17342"/>
                        <a:pt x="606885" y="13021"/>
                      </a:cubicBezTo>
                      <a:cubicBezTo>
                        <a:pt x="625990" y="5142"/>
                        <a:pt x="646346" y="732"/>
                        <a:pt x="666998" y="0"/>
                      </a:cubicBezTo>
                      <a:cubicBezTo>
                        <a:pt x="688067" y="656"/>
                        <a:pt x="708844" y="5112"/>
                        <a:pt x="728329" y="13154"/>
                      </a:cubicBezTo>
                      <a:cubicBezTo>
                        <a:pt x="739564" y="17510"/>
                        <a:pt x="751389" y="20156"/>
                        <a:pt x="763410" y="21003"/>
                      </a:cubicBezTo>
                      <a:lnTo>
                        <a:pt x="762057" y="40053"/>
                      </a:lnTo>
                      <a:cubicBezTo>
                        <a:pt x="748060" y="39059"/>
                        <a:pt x="734292" y="35967"/>
                        <a:pt x="721214" y="30880"/>
                      </a:cubicBezTo>
                      <a:cubicBezTo>
                        <a:pt x="704001" y="23746"/>
                        <a:pt x="685648" y="19759"/>
                        <a:pt x="667026" y="19107"/>
                      </a:cubicBezTo>
                      <a:cubicBezTo>
                        <a:pt x="648812" y="19842"/>
                        <a:pt x="630870" y="23789"/>
                        <a:pt x="614029" y="30766"/>
                      </a:cubicBezTo>
                      <a:cubicBezTo>
                        <a:pt x="600865" y="35913"/>
                        <a:pt x="586999" y="39044"/>
                        <a:pt x="572900" y="40053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153" name="Freeform: Shape 152">
                  <a:extLst>
                    <a:ext uri="{FF2B5EF4-FFF2-40B4-BE49-F238E27FC236}">
                      <a16:creationId xmlns:a16="http://schemas.microsoft.com/office/drawing/2014/main" id="{4F56F1B0-46C7-31A6-DA16-2EB5BC3F1D3C}"/>
                    </a:ext>
                  </a:extLst>
                </p:cNvPr>
                <p:cNvSpPr/>
                <p:nvPr/>
              </p:nvSpPr>
              <p:spPr>
                <a:xfrm>
                  <a:off x="6033787" y="4633807"/>
                  <a:ext cx="763381" cy="40004"/>
                </a:xfrm>
                <a:custGeom>
                  <a:avLst/>
                  <a:gdLst>
                    <a:gd name="connsiteX0" fmla="*/ 572167 w 763381"/>
                    <a:gd name="connsiteY0" fmla="*/ 40005 h 40004"/>
                    <a:gd name="connsiteX1" fmla="*/ 571491 w 763381"/>
                    <a:gd name="connsiteY1" fmla="*/ 39948 h 40004"/>
                    <a:gd name="connsiteX2" fmla="*/ 530647 w 763381"/>
                    <a:gd name="connsiteY2" fmla="*/ 30775 h 40004"/>
                    <a:gd name="connsiteX3" fmla="*/ 476488 w 763381"/>
                    <a:gd name="connsiteY3" fmla="*/ 19050 h 40004"/>
                    <a:gd name="connsiteX4" fmla="*/ 423491 w 763381"/>
                    <a:gd name="connsiteY4" fmla="*/ 30709 h 40004"/>
                    <a:gd name="connsiteX5" fmla="*/ 382362 w 763381"/>
                    <a:gd name="connsiteY5" fmla="*/ 39986 h 40004"/>
                    <a:gd name="connsiteX6" fmla="*/ 381667 w 763381"/>
                    <a:gd name="connsiteY6" fmla="*/ 40005 h 40004"/>
                    <a:gd name="connsiteX7" fmla="*/ 380991 w 763381"/>
                    <a:gd name="connsiteY7" fmla="*/ 39948 h 40004"/>
                    <a:gd name="connsiteX8" fmla="*/ 340147 w 763381"/>
                    <a:gd name="connsiteY8" fmla="*/ 30775 h 40004"/>
                    <a:gd name="connsiteX9" fmla="*/ 285979 w 763381"/>
                    <a:gd name="connsiteY9" fmla="*/ 19050 h 40004"/>
                    <a:gd name="connsiteX10" fmla="*/ 232982 w 763381"/>
                    <a:gd name="connsiteY10" fmla="*/ 30709 h 40004"/>
                    <a:gd name="connsiteX11" fmla="*/ 191853 w 763381"/>
                    <a:gd name="connsiteY11" fmla="*/ 39986 h 40004"/>
                    <a:gd name="connsiteX12" fmla="*/ 191167 w 763381"/>
                    <a:gd name="connsiteY12" fmla="*/ 40005 h 40004"/>
                    <a:gd name="connsiteX13" fmla="*/ 190500 w 763381"/>
                    <a:gd name="connsiteY13" fmla="*/ 40005 h 40004"/>
                    <a:gd name="connsiteX14" fmla="*/ 149657 w 763381"/>
                    <a:gd name="connsiteY14" fmla="*/ 30832 h 40004"/>
                    <a:gd name="connsiteX15" fmla="*/ 95469 w 763381"/>
                    <a:gd name="connsiteY15" fmla="*/ 19050 h 40004"/>
                    <a:gd name="connsiteX16" fmla="*/ 42472 w 763381"/>
                    <a:gd name="connsiteY16" fmla="*/ 30709 h 40004"/>
                    <a:gd name="connsiteX17" fmla="*/ 1343 w 763381"/>
                    <a:gd name="connsiteY17" fmla="*/ 39986 h 40004"/>
                    <a:gd name="connsiteX18" fmla="*/ 0 w 763381"/>
                    <a:gd name="connsiteY18" fmla="*/ 20955 h 40004"/>
                    <a:gd name="connsiteX19" fmla="*/ 35357 w 763381"/>
                    <a:gd name="connsiteY19" fmla="*/ 12992 h 40004"/>
                    <a:gd name="connsiteX20" fmla="*/ 95469 w 763381"/>
                    <a:gd name="connsiteY20" fmla="*/ 0 h 40004"/>
                    <a:gd name="connsiteX21" fmla="*/ 156772 w 763381"/>
                    <a:gd name="connsiteY21" fmla="*/ 13125 h 40004"/>
                    <a:gd name="connsiteX22" fmla="*/ 191167 w 763381"/>
                    <a:gd name="connsiteY22" fmla="*/ 20955 h 40004"/>
                    <a:gd name="connsiteX23" fmla="*/ 225857 w 763381"/>
                    <a:gd name="connsiteY23" fmla="*/ 13049 h 40004"/>
                    <a:gd name="connsiteX24" fmla="*/ 285979 w 763381"/>
                    <a:gd name="connsiteY24" fmla="*/ 0 h 40004"/>
                    <a:gd name="connsiteX25" fmla="*/ 347282 w 763381"/>
                    <a:gd name="connsiteY25" fmla="*/ 13125 h 40004"/>
                    <a:gd name="connsiteX26" fmla="*/ 381667 w 763381"/>
                    <a:gd name="connsiteY26" fmla="*/ 20955 h 40004"/>
                    <a:gd name="connsiteX27" fmla="*/ 416357 w 763381"/>
                    <a:gd name="connsiteY27" fmla="*/ 13049 h 40004"/>
                    <a:gd name="connsiteX28" fmla="*/ 476488 w 763381"/>
                    <a:gd name="connsiteY28" fmla="*/ 0 h 40004"/>
                    <a:gd name="connsiteX29" fmla="*/ 537791 w 763381"/>
                    <a:gd name="connsiteY29" fmla="*/ 13125 h 40004"/>
                    <a:gd name="connsiteX30" fmla="*/ 572167 w 763381"/>
                    <a:gd name="connsiteY30" fmla="*/ 20955 h 40004"/>
                    <a:gd name="connsiteX31" fmla="*/ 606857 w 763381"/>
                    <a:gd name="connsiteY31" fmla="*/ 13049 h 40004"/>
                    <a:gd name="connsiteX32" fmla="*/ 666998 w 763381"/>
                    <a:gd name="connsiteY32" fmla="*/ 0 h 40004"/>
                    <a:gd name="connsiteX33" fmla="*/ 728301 w 763381"/>
                    <a:gd name="connsiteY33" fmla="*/ 13125 h 40004"/>
                    <a:gd name="connsiteX34" fmla="*/ 763381 w 763381"/>
                    <a:gd name="connsiteY34" fmla="*/ 20974 h 40004"/>
                    <a:gd name="connsiteX35" fmla="*/ 762029 w 763381"/>
                    <a:gd name="connsiteY35" fmla="*/ 40005 h 40004"/>
                    <a:gd name="connsiteX36" fmla="*/ 721185 w 763381"/>
                    <a:gd name="connsiteY36" fmla="*/ 30832 h 40004"/>
                    <a:gd name="connsiteX37" fmla="*/ 666998 w 763381"/>
                    <a:gd name="connsiteY37" fmla="*/ 19050 h 40004"/>
                    <a:gd name="connsiteX38" fmla="*/ 614001 w 763381"/>
                    <a:gd name="connsiteY38" fmla="*/ 30709 h 40004"/>
                    <a:gd name="connsiteX39" fmla="*/ 572872 w 763381"/>
                    <a:gd name="connsiteY39" fmla="*/ 39986 h 4000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763381" h="40004">
                      <a:moveTo>
                        <a:pt x="572167" y="40005"/>
                      </a:moveTo>
                      <a:lnTo>
                        <a:pt x="571491" y="39948"/>
                      </a:lnTo>
                      <a:cubicBezTo>
                        <a:pt x="557493" y="38958"/>
                        <a:pt x="543724" y="35866"/>
                        <a:pt x="530647" y="30775"/>
                      </a:cubicBezTo>
                      <a:cubicBezTo>
                        <a:pt x="513439" y="23665"/>
                        <a:pt x="495096" y="19694"/>
                        <a:pt x="476488" y="19050"/>
                      </a:cubicBezTo>
                      <a:cubicBezTo>
                        <a:pt x="458274" y="19784"/>
                        <a:pt x="440332" y="23732"/>
                        <a:pt x="423491" y="30709"/>
                      </a:cubicBezTo>
                      <a:cubicBezTo>
                        <a:pt x="410327" y="35853"/>
                        <a:pt x="396460" y="38980"/>
                        <a:pt x="382362" y="39986"/>
                      </a:cubicBezTo>
                      <a:lnTo>
                        <a:pt x="381667" y="40005"/>
                      </a:lnTo>
                      <a:lnTo>
                        <a:pt x="380991" y="39948"/>
                      </a:lnTo>
                      <a:cubicBezTo>
                        <a:pt x="366993" y="38958"/>
                        <a:pt x="353224" y="35866"/>
                        <a:pt x="340147" y="30775"/>
                      </a:cubicBezTo>
                      <a:cubicBezTo>
                        <a:pt x="322936" y="23664"/>
                        <a:pt x="304590" y="19693"/>
                        <a:pt x="285979" y="19050"/>
                      </a:cubicBezTo>
                      <a:cubicBezTo>
                        <a:pt x="267764" y="19784"/>
                        <a:pt x="249823" y="23732"/>
                        <a:pt x="232982" y="30709"/>
                      </a:cubicBezTo>
                      <a:cubicBezTo>
                        <a:pt x="219817" y="35853"/>
                        <a:pt x="205951" y="38980"/>
                        <a:pt x="191853" y="39986"/>
                      </a:cubicBezTo>
                      <a:lnTo>
                        <a:pt x="191167" y="40005"/>
                      </a:lnTo>
                      <a:lnTo>
                        <a:pt x="190500" y="40005"/>
                      </a:lnTo>
                      <a:cubicBezTo>
                        <a:pt x="176502" y="39015"/>
                        <a:pt x="162734" y="35924"/>
                        <a:pt x="149657" y="30832"/>
                      </a:cubicBezTo>
                      <a:cubicBezTo>
                        <a:pt x="132443" y="23699"/>
                        <a:pt x="114090" y="19709"/>
                        <a:pt x="95469" y="19050"/>
                      </a:cubicBezTo>
                      <a:cubicBezTo>
                        <a:pt x="77254" y="19784"/>
                        <a:pt x="59313" y="23732"/>
                        <a:pt x="42472" y="30709"/>
                      </a:cubicBezTo>
                      <a:cubicBezTo>
                        <a:pt x="29307" y="35853"/>
                        <a:pt x="15441" y="38980"/>
                        <a:pt x="1343" y="39986"/>
                      </a:cubicBezTo>
                      <a:lnTo>
                        <a:pt x="0" y="20955"/>
                      </a:lnTo>
                      <a:cubicBezTo>
                        <a:pt x="12118" y="20087"/>
                        <a:pt x="24037" y="17403"/>
                        <a:pt x="35357" y="12992"/>
                      </a:cubicBezTo>
                      <a:cubicBezTo>
                        <a:pt x="54463" y="5123"/>
                        <a:pt x="74819" y="723"/>
                        <a:pt x="95469" y="0"/>
                      </a:cubicBezTo>
                      <a:cubicBezTo>
                        <a:pt x="116527" y="646"/>
                        <a:pt x="137295" y="5092"/>
                        <a:pt x="156772" y="13125"/>
                      </a:cubicBezTo>
                      <a:cubicBezTo>
                        <a:pt x="167791" y="17406"/>
                        <a:pt x="179381" y="20044"/>
                        <a:pt x="191167" y="20955"/>
                      </a:cubicBezTo>
                      <a:cubicBezTo>
                        <a:pt x="203057" y="20044"/>
                        <a:pt x="214746" y="17380"/>
                        <a:pt x="225857" y="13049"/>
                      </a:cubicBezTo>
                      <a:cubicBezTo>
                        <a:pt x="244962" y="5160"/>
                        <a:pt x="265322" y="740"/>
                        <a:pt x="285979" y="0"/>
                      </a:cubicBezTo>
                      <a:cubicBezTo>
                        <a:pt x="307036" y="646"/>
                        <a:pt x="327805" y="5092"/>
                        <a:pt x="347282" y="13125"/>
                      </a:cubicBezTo>
                      <a:cubicBezTo>
                        <a:pt x="358298" y="17405"/>
                        <a:pt x="369883" y="20043"/>
                        <a:pt x="381667" y="20955"/>
                      </a:cubicBezTo>
                      <a:cubicBezTo>
                        <a:pt x="393557" y="20043"/>
                        <a:pt x="405246" y="17380"/>
                        <a:pt x="416357" y="13049"/>
                      </a:cubicBezTo>
                      <a:cubicBezTo>
                        <a:pt x="435465" y="5158"/>
                        <a:pt x="455827" y="739"/>
                        <a:pt x="476488" y="0"/>
                      </a:cubicBezTo>
                      <a:cubicBezTo>
                        <a:pt x="497546" y="646"/>
                        <a:pt x="518314" y="5092"/>
                        <a:pt x="537791" y="13125"/>
                      </a:cubicBezTo>
                      <a:cubicBezTo>
                        <a:pt x="548805" y="17404"/>
                        <a:pt x="560386" y="20043"/>
                        <a:pt x="572167" y="20955"/>
                      </a:cubicBezTo>
                      <a:cubicBezTo>
                        <a:pt x="584057" y="20043"/>
                        <a:pt x="595746" y="17379"/>
                        <a:pt x="606857" y="13049"/>
                      </a:cubicBezTo>
                      <a:cubicBezTo>
                        <a:pt x="625968" y="5157"/>
                        <a:pt x="646334" y="738"/>
                        <a:pt x="666998" y="0"/>
                      </a:cubicBezTo>
                      <a:cubicBezTo>
                        <a:pt x="688056" y="645"/>
                        <a:pt x="708824" y="5092"/>
                        <a:pt x="728301" y="13125"/>
                      </a:cubicBezTo>
                      <a:cubicBezTo>
                        <a:pt x="739537" y="17476"/>
                        <a:pt x="751362" y="20122"/>
                        <a:pt x="763381" y="20974"/>
                      </a:cubicBezTo>
                      <a:lnTo>
                        <a:pt x="762029" y="40005"/>
                      </a:lnTo>
                      <a:cubicBezTo>
                        <a:pt x="748031" y="39015"/>
                        <a:pt x="734262" y="35924"/>
                        <a:pt x="721185" y="30832"/>
                      </a:cubicBezTo>
                      <a:cubicBezTo>
                        <a:pt x="703972" y="23699"/>
                        <a:pt x="685619" y="19709"/>
                        <a:pt x="666998" y="19050"/>
                      </a:cubicBezTo>
                      <a:cubicBezTo>
                        <a:pt x="648783" y="19784"/>
                        <a:pt x="630842" y="23732"/>
                        <a:pt x="614001" y="30709"/>
                      </a:cubicBezTo>
                      <a:cubicBezTo>
                        <a:pt x="600836" y="35853"/>
                        <a:pt x="586970" y="38980"/>
                        <a:pt x="572872" y="39986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154" name="Freeform: Shape 153">
                  <a:extLst>
                    <a:ext uri="{FF2B5EF4-FFF2-40B4-BE49-F238E27FC236}">
                      <a16:creationId xmlns:a16="http://schemas.microsoft.com/office/drawing/2014/main" id="{2D97048C-AFBE-3501-3E43-36C24D665FE2}"/>
                    </a:ext>
                  </a:extLst>
                </p:cNvPr>
                <p:cNvSpPr/>
                <p:nvPr/>
              </p:nvSpPr>
              <p:spPr>
                <a:xfrm>
                  <a:off x="6553566" y="4286239"/>
                  <a:ext cx="171450" cy="171450"/>
                </a:xfrm>
                <a:custGeom>
                  <a:avLst/>
                  <a:gdLst>
                    <a:gd name="connsiteX0" fmla="*/ 85725 w 171450"/>
                    <a:gd name="connsiteY0" fmla="*/ 19050 h 171450"/>
                    <a:gd name="connsiteX1" fmla="*/ 152400 w 171450"/>
                    <a:gd name="connsiteY1" fmla="*/ 85725 h 171450"/>
                    <a:gd name="connsiteX2" fmla="*/ 85725 w 171450"/>
                    <a:gd name="connsiteY2" fmla="*/ 152400 h 171450"/>
                    <a:gd name="connsiteX3" fmla="*/ 19050 w 171450"/>
                    <a:gd name="connsiteY3" fmla="*/ 85725 h 171450"/>
                    <a:gd name="connsiteX4" fmla="*/ 85725 w 171450"/>
                    <a:gd name="connsiteY4" fmla="*/ 19050 h 171450"/>
                    <a:gd name="connsiteX5" fmla="*/ 85725 w 171450"/>
                    <a:gd name="connsiteY5" fmla="*/ 0 h 171450"/>
                    <a:gd name="connsiteX6" fmla="*/ 0 w 171450"/>
                    <a:gd name="connsiteY6" fmla="*/ 85725 h 171450"/>
                    <a:gd name="connsiteX7" fmla="*/ 85725 w 171450"/>
                    <a:gd name="connsiteY7" fmla="*/ 171450 h 171450"/>
                    <a:gd name="connsiteX8" fmla="*/ 171450 w 171450"/>
                    <a:gd name="connsiteY8" fmla="*/ 85725 h 171450"/>
                    <a:gd name="connsiteX9" fmla="*/ 85725 w 171450"/>
                    <a:gd name="connsiteY9" fmla="*/ 0 h 1714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71450" h="171450">
                      <a:moveTo>
                        <a:pt x="85725" y="19050"/>
                      </a:moveTo>
                      <a:cubicBezTo>
                        <a:pt x="122549" y="19050"/>
                        <a:pt x="152400" y="48901"/>
                        <a:pt x="152400" y="85725"/>
                      </a:cubicBezTo>
                      <a:cubicBezTo>
                        <a:pt x="152400" y="122549"/>
                        <a:pt x="122549" y="152400"/>
                        <a:pt x="85725" y="152400"/>
                      </a:cubicBezTo>
                      <a:cubicBezTo>
                        <a:pt x="48901" y="152400"/>
                        <a:pt x="19050" y="122549"/>
                        <a:pt x="19050" y="85725"/>
                      </a:cubicBezTo>
                      <a:cubicBezTo>
                        <a:pt x="19098" y="48921"/>
                        <a:pt x="48921" y="19098"/>
                        <a:pt x="85725" y="19050"/>
                      </a:cubicBezTo>
                      <a:moveTo>
                        <a:pt x="85725" y="0"/>
                      </a:moveTo>
                      <a:cubicBezTo>
                        <a:pt x="38380" y="0"/>
                        <a:pt x="0" y="38380"/>
                        <a:pt x="0" y="85725"/>
                      </a:cubicBezTo>
                      <a:cubicBezTo>
                        <a:pt x="0" y="133070"/>
                        <a:pt x="38380" y="171450"/>
                        <a:pt x="85725" y="171450"/>
                      </a:cubicBezTo>
                      <a:cubicBezTo>
                        <a:pt x="133070" y="171450"/>
                        <a:pt x="171450" y="133070"/>
                        <a:pt x="171450" y="85725"/>
                      </a:cubicBezTo>
                      <a:cubicBezTo>
                        <a:pt x="171450" y="38380"/>
                        <a:pt x="133070" y="0"/>
                        <a:pt x="85725" y="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</p:grpSp>
          <p:grpSp>
            <p:nvGrpSpPr>
              <p:cNvPr id="142" name="Graphic 21" descr="Skipping Rope outline">
                <a:extLst>
                  <a:ext uri="{FF2B5EF4-FFF2-40B4-BE49-F238E27FC236}">
                    <a16:creationId xmlns:a16="http://schemas.microsoft.com/office/drawing/2014/main" id="{BE1E7023-D113-7DBB-C36D-5F753542BCE6}"/>
                  </a:ext>
                </a:extLst>
              </p:cNvPr>
              <p:cNvGrpSpPr/>
              <p:nvPr/>
            </p:nvGrpSpPr>
            <p:grpSpPr>
              <a:xfrm>
                <a:off x="9775934" y="3621525"/>
                <a:ext cx="367125" cy="457200"/>
                <a:chOff x="6424448" y="4257532"/>
                <a:chExt cx="591970" cy="876300"/>
              </a:xfrm>
              <a:solidFill>
                <a:srgbClr val="000000"/>
              </a:solidFill>
            </p:grpSpPr>
            <p:sp>
              <p:nvSpPr>
                <p:cNvPr id="149" name="Freeform: Shape 148">
                  <a:extLst>
                    <a:ext uri="{FF2B5EF4-FFF2-40B4-BE49-F238E27FC236}">
                      <a16:creationId xmlns:a16="http://schemas.microsoft.com/office/drawing/2014/main" id="{276E94E3-D8F2-6487-4A6C-ACABD418B6C4}"/>
                    </a:ext>
                  </a:extLst>
                </p:cNvPr>
                <p:cNvSpPr/>
                <p:nvPr/>
              </p:nvSpPr>
              <p:spPr>
                <a:xfrm>
                  <a:off x="6644235" y="4257532"/>
                  <a:ext cx="152400" cy="152400"/>
                </a:xfrm>
                <a:custGeom>
                  <a:avLst/>
                  <a:gdLst>
                    <a:gd name="connsiteX0" fmla="*/ 76200 w 152400"/>
                    <a:gd name="connsiteY0" fmla="*/ 152400 h 152400"/>
                    <a:gd name="connsiteX1" fmla="*/ 152400 w 152400"/>
                    <a:gd name="connsiteY1" fmla="*/ 76200 h 152400"/>
                    <a:gd name="connsiteX2" fmla="*/ 76200 w 152400"/>
                    <a:gd name="connsiteY2" fmla="*/ 0 h 152400"/>
                    <a:gd name="connsiteX3" fmla="*/ 0 w 152400"/>
                    <a:gd name="connsiteY3" fmla="*/ 76200 h 152400"/>
                    <a:gd name="connsiteX4" fmla="*/ 76200 w 152400"/>
                    <a:gd name="connsiteY4" fmla="*/ 152400 h 152400"/>
                    <a:gd name="connsiteX5" fmla="*/ 76200 w 152400"/>
                    <a:gd name="connsiteY5" fmla="*/ 19050 h 152400"/>
                    <a:gd name="connsiteX6" fmla="*/ 133350 w 152400"/>
                    <a:gd name="connsiteY6" fmla="*/ 76200 h 152400"/>
                    <a:gd name="connsiteX7" fmla="*/ 76200 w 152400"/>
                    <a:gd name="connsiteY7" fmla="*/ 133350 h 152400"/>
                    <a:gd name="connsiteX8" fmla="*/ 19050 w 152400"/>
                    <a:gd name="connsiteY8" fmla="*/ 76200 h 152400"/>
                    <a:gd name="connsiteX9" fmla="*/ 76200 w 152400"/>
                    <a:gd name="connsiteY9" fmla="*/ 19050 h 152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52400" h="152400">
                      <a:moveTo>
                        <a:pt x="76200" y="152400"/>
                      </a:moveTo>
                      <a:cubicBezTo>
                        <a:pt x="118284" y="152400"/>
                        <a:pt x="152400" y="118284"/>
                        <a:pt x="152400" y="76200"/>
                      </a:cubicBezTo>
                      <a:cubicBezTo>
                        <a:pt x="152400" y="34116"/>
                        <a:pt x="118284" y="0"/>
                        <a:pt x="76200" y="0"/>
                      </a:cubicBezTo>
                      <a:cubicBezTo>
                        <a:pt x="34116" y="0"/>
                        <a:pt x="0" y="34116"/>
                        <a:pt x="0" y="76200"/>
                      </a:cubicBezTo>
                      <a:cubicBezTo>
                        <a:pt x="0" y="118284"/>
                        <a:pt x="34116" y="152400"/>
                        <a:pt x="76200" y="152400"/>
                      </a:cubicBezTo>
                      <a:close/>
                      <a:moveTo>
                        <a:pt x="76200" y="19050"/>
                      </a:moveTo>
                      <a:cubicBezTo>
                        <a:pt x="107763" y="19050"/>
                        <a:pt x="133350" y="44637"/>
                        <a:pt x="133350" y="76200"/>
                      </a:cubicBezTo>
                      <a:cubicBezTo>
                        <a:pt x="133350" y="107763"/>
                        <a:pt x="107763" y="133350"/>
                        <a:pt x="76200" y="133350"/>
                      </a:cubicBezTo>
                      <a:cubicBezTo>
                        <a:pt x="44637" y="133350"/>
                        <a:pt x="19050" y="107763"/>
                        <a:pt x="19050" y="76200"/>
                      </a:cubicBezTo>
                      <a:cubicBezTo>
                        <a:pt x="19087" y="44652"/>
                        <a:pt x="44652" y="19087"/>
                        <a:pt x="76200" y="1905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150" name="Freeform: Shape 149">
                  <a:extLst>
                    <a:ext uri="{FF2B5EF4-FFF2-40B4-BE49-F238E27FC236}">
                      <a16:creationId xmlns:a16="http://schemas.microsoft.com/office/drawing/2014/main" id="{5DBD2ACF-B172-DD83-F92C-E574920ED9E8}"/>
                    </a:ext>
                  </a:extLst>
                </p:cNvPr>
                <p:cNvSpPr/>
                <p:nvPr/>
              </p:nvSpPr>
              <p:spPr>
                <a:xfrm>
                  <a:off x="6424448" y="4439030"/>
                  <a:ext cx="591970" cy="694801"/>
                </a:xfrm>
                <a:custGeom>
                  <a:avLst/>
                  <a:gdLst>
                    <a:gd name="connsiteX0" fmla="*/ 564906 w 591970"/>
                    <a:gd name="connsiteY0" fmla="*/ 162354 h 694801"/>
                    <a:gd name="connsiteX1" fmla="*/ 482696 w 591970"/>
                    <a:gd name="connsiteY1" fmla="*/ 121244 h 694801"/>
                    <a:gd name="connsiteX2" fmla="*/ 405782 w 591970"/>
                    <a:gd name="connsiteY2" fmla="*/ 27242 h 694801"/>
                    <a:gd name="connsiteX3" fmla="*/ 382626 w 591970"/>
                    <a:gd name="connsiteY3" fmla="*/ 12097 h 694801"/>
                    <a:gd name="connsiteX4" fmla="*/ 377407 w 591970"/>
                    <a:gd name="connsiteY4" fmla="*/ 10792 h 694801"/>
                    <a:gd name="connsiteX5" fmla="*/ 361938 w 591970"/>
                    <a:gd name="connsiteY5" fmla="*/ 7325 h 694801"/>
                    <a:gd name="connsiteX6" fmla="*/ 230045 w 591970"/>
                    <a:gd name="connsiteY6" fmla="*/ 7258 h 694801"/>
                    <a:gd name="connsiteX7" fmla="*/ 215015 w 591970"/>
                    <a:gd name="connsiteY7" fmla="*/ 10621 h 694801"/>
                    <a:gd name="connsiteX8" fmla="*/ 208881 w 591970"/>
                    <a:gd name="connsiteY8" fmla="*/ 12240 h 694801"/>
                    <a:gd name="connsiteX9" fmla="*/ 186230 w 591970"/>
                    <a:gd name="connsiteY9" fmla="*/ 27242 h 694801"/>
                    <a:gd name="connsiteX10" fmla="*/ 109326 w 591970"/>
                    <a:gd name="connsiteY10" fmla="*/ 121225 h 694801"/>
                    <a:gd name="connsiteX11" fmla="*/ 27068 w 591970"/>
                    <a:gd name="connsiteY11" fmla="*/ 162354 h 694801"/>
                    <a:gd name="connsiteX12" fmla="*/ 4265 w 591970"/>
                    <a:gd name="connsiteY12" fmla="*/ 224007 h 694801"/>
                    <a:gd name="connsiteX13" fmla="*/ 38850 w 591970"/>
                    <a:gd name="connsiteY13" fmla="*/ 250432 h 694801"/>
                    <a:gd name="connsiteX14" fmla="*/ 267450 w 591970"/>
                    <a:gd name="connsiteY14" fmla="*/ 626002 h 694801"/>
                    <a:gd name="connsiteX15" fmla="*/ 267450 w 591970"/>
                    <a:gd name="connsiteY15" fmla="*/ 606809 h 694801"/>
                    <a:gd name="connsiteX16" fmla="*/ 57900 w 591970"/>
                    <a:gd name="connsiteY16" fmla="*/ 249622 h 694801"/>
                    <a:gd name="connsiteX17" fmla="*/ 67349 w 591970"/>
                    <a:gd name="connsiteY17" fmla="*/ 246155 h 694801"/>
                    <a:gd name="connsiteX18" fmla="*/ 159741 w 591970"/>
                    <a:gd name="connsiteY18" fmla="*/ 199940 h 694801"/>
                    <a:gd name="connsiteX19" fmla="*/ 174800 w 591970"/>
                    <a:gd name="connsiteY19" fmla="*/ 188071 h 694801"/>
                    <a:gd name="connsiteX20" fmla="*/ 200604 w 591970"/>
                    <a:gd name="connsiteY20" fmla="*/ 158477 h 694801"/>
                    <a:gd name="connsiteX21" fmla="*/ 200775 w 591970"/>
                    <a:gd name="connsiteY21" fmla="*/ 158534 h 694801"/>
                    <a:gd name="connsiteX22" fmla="*/ 200775 w 591970"/>
                    <a:gd name="connsiteY22" fmla="*/ 462391 h 694801"/>
                    <a:gd name="connsiteX23" fmla="*/ 252210 w 591970"/>
                    <a:gd name="connsiteY23" fmla="*/ 513826 h 694801"/>
                    <a:gd name="connsiteX24" fmla="*/ 254115 w 591970"/>
                    <a:gd name="connsiteY24" fmla="*/ 513826 h 694801"/>
                    <a:gd name="connsiteX25" fmla="*/ 286500 w 591970"/>
                    <a:gd name="connsiteY25" fmla="*/ 502320 h 694801"/>
                    <a:gd name="connsiteX26" fmla="*/ 286500 w 591970"/>
                    <a:gd name="connsiteY26" fmla="*/ 643366 h 694801"/>
                    <a:gd name="connsiteX27" fmla="*/ 337935 w 591970"/>
                    <a:gd name="connsiteY27" fmla="*/ 694801 h 694801"/>
                    <a:gd name="connsiteX28" fmla="*/ 339840 w 591970"/>
                    <a:gd name="connsiteY28" fmla="*/ 694801 h 694801"/>
                    <a:gd name="connsiteX29" fmla="*/ 391275 w 591970"/>
                    <a:gd name="connsiteY29" fmla="*/ 643366 h 694801"/>
                    <a:gd name="connsiteX30" fmla="*/ 391275 w 591970"/>
                    <a:gd name="connsiteY30" fmla="*/ 158544 h 694801"/>
                    <a:gd name="connsiteX31" fmla="*/ 391437 w 591970"/>
                    <a:gd name="connsiteY31" fmla="*/ 158487 h 694801"/>
                    <a:gd name="connsiteX32" fmla="*/ 417040 w 591970"/>
                    <a:gd name="connsiteY32" fmla="*/ 187852 h 694801"/>
                    <a:gd name="connsiteX33" fmla="*/ 432233 w 591970"/>
                    <a:gd name="connsiteY33" fmla="*/ 199997 h 694801"/>
                    <a:gd name="connsiteX34" fmla="*/ 524625 w 591970"/>
                    <a:gd name="connsiteY34" fmla="*/ 246222 h 694801"/>
                    <a:gd name="connsiteX35" fmla="*/ 534055 w 591970"/>
                    <a:gd name="connsiteY35" fmla="*/ 249698 h 694801"/>
                    <a:gd name="connsiteX36" fmla="*/ 410230 w 591970"/>
                    <a:gd name="connsiteY36" fmla="*/ 579749 h 694801"/>
                    <a:gd name="connsiteX37" fmla="*/ 410230 w 591970"/>
                    <a:gd name="connsiteY37" fmla="*/ 601266 h 694801"/>
                    <a:gd name="connsiteX38" fmla="*/ 553038 w 591970"/>
                    <a:gd name="connsiteY38" fmla="*/ 250460 h 694801"/>
                    <a:gd name="connsiteX39" fmla="*/ 591343 w 591970"/>
                    <a:gd name="connsiteY39" fmla="*/ 197022 h 694801"/>
                    <a:gd name="connsiteX40" fmla="*/ 564906 w 591970"/>
                    <a:gd name="connsiteY40" fmla="*/ 162354 h 694801"/>
                    <a:gd name="connsiteX41" fmla="*/ 571279 w 591970"/>
                    <a:gd name="connsiteY41" fmla="*/ 213875 h 694801"/>
                    <a:gd name="connsiteX42" fmla="*/ 536206 w 591970"/>
                    <a:gd name="connsiteY42" fmla="*/ 230456 h 694801"/>
                    <a:gd name="connsiteX43" fmla="*/ 533179 w 591970"/>
                    <a:gd name="connsiteY43" fmla="*/ 229162 h 694801"/>
                    <a:gd name="connsiteX44" fmla="*/ 440729 w 591970"/>
                    <a:gd name="connsiteY44" fmla="*/ 182937 h 694801"/>
                    <a:gd name="connsiteX45" fmla="*/ 431585 w 591970"/>
                    <a:gd name="connsiteY45" fmla="*/ 175546 h 694801"/>
                    <a:gd name="connsiteX46" fmla="*/ 391266 w 591970"/>
                    <a:gd name="connsiteY46" fmla="*/ 129274 h 694801"/>
                    <a:gd name="connsiteX47" fmla="*/ 391266 w 591970"/>
                    <a:gd name="connsiteY47" fmla="*/ 117844 h 694801"/>
                    <a:gd name="connsiteX48" fmla="*/ 381741 w 591970"/>
                    <a:gd name="connsiteY48" fmla="*/ 108319 h 694801"/>
                    <a:gd name="connsiteX49" fmla="*/ 372216 w 591970"/>
                    <a:gd name="connsiteY49" fmla="*/ 117844 h 694801"/>
                    <a:gd name="connsiteX50" fmla="*/ 372216 w 591970"/>
                    <a:gd name="connsiteY50" fmla="*/ 643366 h 694801"/>
                    <a:gd name="connsiteX51" fmla="*/ 339831 w 591970"/>
                    <a:gd name="connsiteY51" fmla="*/ 675751 h 694801"/>
                    <a:gd name="connsiteX52" fmla="*/ 337926 w 591970"/>
                    <a:gd name="connsiteY52" fmla="*/ 675751 h 694801"/>
                    <a:gd name="connsiteX53" fmla="*/ 305541 w 591970"/>
                    <a:gd name="connsiteY53" fmla="*/ 643366 h 694801"/>
                    <a:gd name="connsiteX54" fmla="*/ 305541 w 591970"/>
                    <a:gd name="connsiteY54" fmla="*/ 323326 h 694801"/>
                    <a:gd name="connsiteX55" fmla="*/ 286491 w 591970"/>
                    <a:gd name="connsiteY55" fmla="*/ 323326 h 694801"/>
                    <a:gd name="connsiteX56" fmla="*/ 286491 w 591970"/>
                    <a:gd name="connsiteY56" fmla="*/ 462391 h 694801"/>
                    <a:gd name="connsiteX57" fmla="*/ 254106 w 591970"/>
                    <a:gd name="connsiteY57" fmla="*/ 494776 h 694801"/>
                    <a:gd name="connsiteX58" fmla="*/ 252201 w 591970"/>
                    <a:gd name="connsiteY58" fmla="*/ 494776 h 694801"/>
                    <a:gd name="connsiteX59" fmla="*/ 219816 w 591970"/>
                    <a:gd name="connsiteY59" fmla="*/ 462391 h 694801"/>
                    <a:gd name="connsiteX60" fmla="*/ 219816 w 591970"/>
                    <a:gd name="connsiteY60" fmla="*/ 117825 h 694801"/>
                    <a:gd name="connsiteX61" fmla="*/ 210291 w 591970"/>
                    <a:gd name="connsiteY61" fmla="*/ 108300 h 694801"/>
                    <a:gd name="connsiteX62" fmla="*/ 200766 w 591970"/>
                    <a:gd name="connsiteY62" fmla="*/ 117825 h 694801"/>
                    <a:gd name="connsiteX63" fmla="*/ 200766 w 591970"/>
                    <a:gd name="connsiteY63" fmla="*/ 129255 h 694801"/>
                    <a:gd name="connsiteX64" fmla="*/ 160227 w 591970"/>
                    <a:gd name="connsiteY64" fmla="*/ 175756 h 694801"/>
                    <a:gd name="connsiteX65" fmla="*/ 151255 w 591970"/>
                    <a:gd name="connsiteY65" fmla="*/ 182918 h 694801"/>
                    <a:gd name="connsiteX66" fmla="*/ 58862 w 591970"/>
                    <a:gd name="connsiteY66" fmla="*/ 229143 h 694801"/>
                    <a:gd name="connsiteX67" fmla="*/ 22048 w 591970"/>
                    <a:gd name="connsiteY67" fmla="*/ 216865 h 694801"/>
                    <a:gd name="connsiteX68" fmla="*/ 20762 w 591970"/>
                    <a:gd name="connsiteY68" fmla="*/ 213856 h 694801"/>
                    <a:gd name="connsiteX69" fmla="*/ 35659 w 591970"/>
                    <a:gd name="connsiteY69" fmla="*/ 179375 h 694801"/>
                    <a:gd name="connsiteX70" fmla="*/ 119698 w 591970"/>
                    <a:gd name="connsiteY70" fmla="*/ 137360 h 694801"/>
                    <a:gd name="connsiteX71" fmla="*/ 122813 w 591970"/>
                    <a:gd name="connsiteY71" fmla="*/ 134865 h 694801"/>
                    <a:gd name="connsiteX72" fmla="*/ 201004 w 591970"/>
                    <a:gd name="connsiteY72" fmla="*/ 39300 h 694801"/>
                    <a:gd name="connsiteX73" fmla="*/ 215377 w 591970"/>
                    <a:gd name="connsiteY73" fmla="*/ 30223 h 694801"/>
                    <a:gd name="connsiteX74" fmla="*/ 216663 w 591970"/>
                    <a:gd name="connsiteY74" fmla="*/ 29785 h 694801"/>
                    <a:gd name="connsiteX75" fmla="*/ 234246 w 591970"/>
                    <a:gd name="connsiteY75" fmla="*/ 25861 h 694801"/>
                    <a:gd name="connsiteX76" fmla="*/ 357852 w 591970"/>
                    <a:gd name="connsiteY76" fmla="*/ 25861 h 694801"/>
                    <a:gd name="connsiteX77" fmla="*/ 375949 w 591970"/>
                    <a:gd name="connsiteY77" fmla="*/ 29918 h 694801"/>
                    <a:gd name="connsiteX78" fmla="*/ 376749 w 591970"/>
                    <a:gd name="connsiteY78" fmla="*/ 30166 h 694801"/>
                    <a:gd name="connsiteX79" fmla="*/ 391132 w 591970"/>
                    <a:gd name="connsiteY79" fmla="*/ 39253 h 694801"/>
                    <a:gd name="connsiteX80" fmla="*/ 469323 w 591970"/>
                    <a:gd name="connsiteY80" fmla="*/ 134817 h 694801"/>
                    <a:gd name="connsiteX81" fmla="*/ 472438 w 591970"/>
                    <a:gd name="connsiteY81" fmla="*/ 137313 h 694801"/>
                    <a:gd name="connsiteX82" fmla="*/ 556477 w 591970"/>
                    <a:gd name="connsiteY82" fmla="*/ 179327 h 694801"/>
                    <a:gd name="connsiteX83" fmla="*/ 571279 w 591970"/>
                    <a:gd name="connsiteY83" fmla="*/ 213856 h 6948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</a:cxnLst>
                  <a:rect l="l" t="t" r="r" b="b"/>
                  <a:pathLst>
                    <a:path w="591970" h="694801">
                      <a:moveTo>
                        <a:pt x="564906" y="162354"/>
                      </a:moveTo>
                      <a:lnTo>
                        <a:pt x="482696" y="121244"/>
                      </a:lnTo>
                      <a:lnTo>
                        <a:pt x="405782" y="27242"/>
                      </a:lnTo>
                      <a:cubicBezTo>
                        <a:pt x="399801" y="19936"/>
                        <a:pt x="391717" y="14648"/>
                        <a:pt x="382626" y="12097"/>
                      </a:cubicBezTo>
                      <a:cubicBezTo>
                        <a:pt x="382150" y="11907"/>
                        <a:pt x="377921" y="10906"/>
                        <a:pt x="377407" y="10792"/>
                      </a:cubicBezTo>
                      <a:lnTo>
                        <a:pt x="361938" y="7325"/>
                      </a:lnTo>
                      <a:cubicBezTo>
                        <a:pt x="318516" y="-2419"/>
                        <a:pt x="273478" y="-2442"/>
                        <a:pt x="230045" y="7258"/>
                      </a:cubicBezTo>
                      <a:lnTo>
                        <a:pt x="215015" y="10621"/>
                      </a:lnTo>
                      <a:cubicBezTo>
                        <a:pt x="214310" y="10783"/>
                        <a:pt x="209509" y="11945"/>
                        <a:pt x="208881" y="12240"/>
                      </a:cubicBezTo>
                      <a:cubicBezTo>
                        <a:pt x="199989" y="14839"/>
                        <a:pt x="192093" y="20069"/>
                        <a:pt x="186230" y="27242"/>
                      </a:cubicBezTo>
                      <a:lnTo>
                        <a:pt x="109326" y="121225"/>
                      </a:lnTo>
                      <a:lnTo>
                        <a:pt x="27068" y="162354"/>
                      </a:lnTo>
                      <a:cubicBezTo>
                        <a:pt x="3746" y="173082"/>
                        <a:pt x="-6463" y="200685"/>
                        <a:pt x="4265" y="224007"/>
                      </a:cubicBezTo>
                      <a:cubicBezTo>
                        <a:pt x="10703" y="238002"/>
                        <a:pt x="23655" y="247899"/>
                        <a:pt x="38850" y="250432"/>
                      </a:cubicBezTo>
                      <a:cubicBezTo>
                        <a:pt x="39698" y="470459"/>
                        <a:pt x="124299" y="607810"/>
                        <a:pt x="267450" y="626002"/>
                      </a:cubicBezTo>
                      <a:lnTo>
                        <a:pt x="267450" y="606809"/>
                      </a:lnTo>
                      <a:cubicBezTo>
                        <a:pt x="134310" y="588864"/>
                        <a:pt x="58529" y="461020"/>
                        <a:pt x="57900" y="249622"/>
                      </a:cubicBezTo>
                      <a:cubicBezTo>
                        <a:pt x="61164" y="248808"/>
                        <a:pt x="64332" y="247646"/>
                        <a:pt x="67349" y="246155"/>
                      </a:cubicBezTo>
                      <a:lnTo>
                        <a:pt x="159741" y="199940"/>
                      </a:lnTo>
                      <a:cubicBezTo>
                        <a:pt x="165545" y="197095"/>
                        <a:pt x="170678" y="193050"/>
                        <a:pt x="174800" y="188071"/>
                      </a:cubicBezTo>
                      <a:lnTo>
                        <a:pt x="200604" y="158477"/>
                      </a:lnTo>
                      <a:cubicBezTo>
                        <a:pt x="200699" y="158363"/>
                        <a:pt x="200775" y="158391"/>
                        <a:pt x="200775" y="158534"/>
                      </a:cubicBezTo>
                      <a:lnTo>
                        <a:pt x="200775" y="462391"/>
                      </a:lnTo>
                      <a:cubicBezTo>
                        <a:pt x="200775" y="490798"/>
                        <a:pt x="223804" y="513826"/>
                        <a:pt x="252210" y="513826"/>
                      </a:cubicBezTo>
                      <a:lnTo>
                        <a:pt x="254115" y="513826"/>
                      </a:lnTo>
                      <a:cubicBezTo>
                        <a:pt x="265914" y="513837"/>
                        <a:pt x="277353" y="509773"/>
                        <a:pt x="286500" y="502320"/>
                      </a:cubicBezTo>
                      <a:lnTo>
                        <a:pt x="286500" y="643366"/>
                      </a:lnTo>
                      <a:cubicBezTo>
                        <a:pt x="286500" y="671773"/>
                        <a:pt x="309529" y="694801"/>
                        <a:pt x="337935" y="694801"/>
                      </a:cubicBezTo>
                      <a:lnTo>
                        <a:pt x="339840" y="694801"/>
                      </a:lnTo>
                      <a:cubicBezTo>
                        <a:pt x="368246" y="694801"/>
                        <a:pt x="391275" y="671773"/>
                        <a:pt x="391275" y="643366"/>
                      </a:cubicBezTo>
                      <a:lnTo>
                        <a:pt x="391275" y="158544"/>
                      </a:lnTo>
                      <a:cubicBezTo>
                        <a:pt x="391275" y="158401"/>
                        <a:pt x="391342" y="158372"/>
                        <a:pt x="391437" y="158487"/>
                      </a:cubicBezTo>
                      <a:lnTo>
                        <a:pt x="417040" y="187852"/>
                      </a:lnTo>
                      <a:cubicBezTo>
                        <a:pt x="421180" y="192938"/>
                        <a:pt x="426360" y="197078"/>
                        <a:pt x="432233" y="199997"/>
                      </a:cubicBezTo>
                      <a:lnTo>
                        <a:pt x="524625" y="246222"/>
                      </a:lnTo>
                      <a:cubicBezTo>
                        <a:pt x="527634" y="247716"/>
                        <a:pt x="530795" y="248882"/>
                        <a:pt x="534055" y="249698"/>
                      </a:cubicBezTo>
                      <a:cubicBezTo>
                        <a:pt x="533617" y="416757"/>
                        <a:pt x="490478" y="529733"/>
                        <a:pt x="410230" y="579749"/>
                      </a:cubicBezTo>
                      <a:lnTo>
                        <a:pt x="410230" y="601266"/>
                      </a:lnTo>
                      <a:cubicBezTo>
                        <a:pt x="501670" y="550345"/>
                        <a:pt x="552410" y="428625"/>
                        <a:pt x="553038" y="250460"/>
                      </a:cubicBezTo>
                      <a:cubicBezTo>
                        <a:pt x="578373" y="246282"/>
                        <a:pt x="595523" y="222357"/>
                        <a:pt x="591343" y="197022"/>
                      </a:cubicBezTo>
                      <a:cubicBezTo>
                        <a:pt x="588831" y="181794"/>
                        <a:pt x="578927" y="168805"/>
                        <a:pt x="564906" y="162354"/>
                      </a:cubicBezTo>
                      <a:close/>
                      <a:moveTo>
                        <a:pt x="571279" y="213875"/>
                      </a:moveTo>
                      <a:cubicBezTo>
                        <a:pt x="566172" y="228138"/>
                        <a:pt x="550469" y="235562"/>
                        <a:pt x="536206" y="230456"/>
                      </a:cubicBezTo>
                      <a:cubicBezTo>
                        <a:pt x="535172" y="230085"/>
                        <a:pt x="534161" y="229654"/>
                        <a:pt x="533179" y="229162"/>
                      </a:cubicBezTo>
                      <a:lnTo>
                        <a:pt x="440729" y="182937"/>
                      </a:lnTo>
                      <a:cubicBezTo>
                        <a:pt x="437184" y="181161"/>
                        <a:pt x="434065" y="178640"/>
                        <a:pt x="431585" y="175546"/>
                      </a:cubicBezTo>
                      <a:lnTo>
                        <a:pt x="391266" y="129274"/>
                      </a:lnTo>
                      <a:lnTo>
                        <a:pt x="391266" y="117844"/>
                      </a:lnTo>
                      <a:cubicBezTo>
                        <a:pt x="391266" y="112583"/>
                        <a:pt x="387001" y="108319"/>
                        <a:pt x="381741" y="108319"/>
                      </a:cubicBezTo>
                      <a:cubicBezTo>
                        <a:pt x="376480" y="108319"/>
                        <a:pt x="372216" y="112583"/>
                        <a:pt x="372216" y="117844"/>
                      </a:cubicBezTo>
                      <a:lnTo>
                        <a:pt x="372216" y="643366"/>
                      </a:lnTo>
                      <a:cubicBezTo>
                        <a:pt x="372216" y="661252"/>
                        <a:pt x="357717" y="675751"/>
                        <a:pt x="339831" y="675751"/>
                      </a:cubicBezTo>
                      <a:lnTo>
                        <a:pt x="337926" y="675751"/>
                      </a:lnTo>
                      <a:cubicBezTo>
                        <a:pt x="320039" y="675751"/>
                        <a:pt x="305541" y="661252"/>
                        <a:pt x="305541" y="643366"/>
                      </a:cubicBezTo>
                      <a:lnTo>
                        <a:pt x="305541" y="323326"/>
                      </a:lnTo>
                      <a:lnTo>
                        <a:pt x="286491" y="323326"/>
                      </a:lnTo>
                      <a:lnTo>
                        <a:pt x="286491" y="462391"/>
                      </a:lnTo>
                      <a:cubicBezTo>
                        <a:pt x="286491" y="480277"/>
                        <a:pt x="271992" y="494776"/>
                        <a:pt x="254106" y="494776"/>
                      </a:cubicBezTo>
                      <a:lnTo>
                        <a:pt x="252201" y="494776"/>
                      </a:lnTo>
                      <a:cubicBezTo>
                        <a:pt x="234314" y="494776"/>
                        <a:pt x="219816" y="480277"/>
                        <a:pt x="219816" y="462391"/>
                      </a:cubicBezTo>
                      <a:lnTo>
                        <a:pt x="219816" y="117825"/>
                      </a:lnTo>
                      <a:cubicBezTo>
                        <a:pt x="219816" y="112564"/>
                        <a:pt x="215551" y="108300"/>
                        <a:pt x="210291" y="108300"/>
                      </a:cubicBezTo>
                      <a:cubicBezTo>
                        <a:pt x="205030" y="108300"/>
                        <a:pt x="200766" y="112564"/>
                        <a:pt x="200766" y="117825"/>
                      </a:cubicBezTo>
                      <a:lnTo>
                        <a:pt x="200766" y="129255"/>
                      </a:lnTo>
                      <a:lnTo>
                        <a:pt x="160227" y="175756"/>
                      </a:lnTo>
                      <a:cubicBezTo>
                        <a:pt x="157775" y="178750"/>
                        <a:pt x="154718" y="181192"/>
                        <a:pt x="151255" y="182918"/>
                      </a:cubicBezTo>
                      <a:lnTo>
                        <a:pt x="58862" y="229143"/>
                      </a:lnTo>
                      <a:cubicBezTo>
                        <a:pt x="45305" y="235918"/>
                        <a:pt x="28823" y="230421"/>
                        <a:pt x="22048" y="216865"/>
                      </a:cubicBezTo>
                      <a:cubicBezTo>
                        <a:pt x="21559" y="215888"/>
                        <a:pt x="21131" y="214883"/>
                        <a:pt x="20762" y="213856"/>
                      </a:cubicBezTo>
                      <a:cubicBezTo>
                        <a:pt x="16416" y="200255"/>
                        <a:pt x="22776" y="185532"/>
                        <a:pt x="35659" y="179375"/>
                      </a:cubicBezTo>
                      <a:lnTo>
                        <a:pt x="119698" y="137360"/>
                      </a:lnTo>
                      <a:cubicBezTo>
                        <a:pt x="120899" y="136755"/>
                        <a:pt x="121960" y="135905"/>
                        <a:pt x="122813" y="134865"/>
                      </a:cubicBezTo>
                      <a:lnTo>
                        <a:pt x="201004" y="39300"/>
                      </a:lnTo>
                      <a:cubicBezTo>
                        <a:pt x="204697" y="34810"/>
                        <a:pt x="209735" y="31628"/>
                        <a:pt x="215377" y="30223"/>
                      </a:cubicBezTo>
                      <a:cubicBezTo>
                        <a:pt x="215815" y="30107"/>
                        <a:pt x="216245" y="29961"/>
                        <a:pt x="216663" y="29785"/>
                      </a:cubicBezTo>
                      <a:lnTo>
                        <a:pt x="234246" y="25861"/>
                      </a:lnTo>
                      <a:cubicBezTo>
                        <a:pt x="274951" y="16812"/>
                        <a:pt x="317147" y="16812"/>
                        <a:pt x="357852" y="25861"/>
                      </a:cubicBezTo>
                      <a:lnTo>
                        <a:pt x="375949" y="29918"/>
                      </a:lnTo>
                      <a:cubicBezTo>
                        <a:pt x="376211" y="30016"/>
                        <a:pt x="376478" y="30099"/>
                        <a:pt x="376749" y="30166"/>
                      </a:cubicBezTo>
                      <a:cubicBezTo>
                        <a:pt x="382393" y="31578"/>
                        <a:pt x="387434" y="34763"/>
                        <a:pt x="391132" y="39253"/>
                      </a:cubicBezTo>
                      <a:lnTo>
                        <a:pt x="469323" y="134817"/>
                      </a:lnTo>
                      <a:cubicBezTo>
                        <a:pt x="470174" y="135859"/>
                        <a:pt x="471235" y="136710"/>
                        <a:pt x="472438" y="137313"/>
                      </a:cubicBezTo>
                      <a:lnTo>
                        <a:pt x="556477" y="179327"/>
                      </a:lnTo>
                      <a:cubicBezTo>
                        <a:pt x="569346" y="185521"/>
                        <a:pt x="575667" y="200264"/>
                        <a:pt x="571279" y="213856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317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 dirty="0"/>
                </a:p>
              </p:txBody>
            </p:sp>
          </p:grpSp>
          <p:grpSp>
            <p:nvGrpSpPr>
              <p:cNvPr id="143" name="Graphic 23" descr="Body builder outline">
                <a:extLst>
                  <a:ext uri="{FF2B5EF4-FFF2-40B4-BE49-F238E27FC236}">
                    <a16:creationId xmlns:a16="http://schemas.microsoft.com/office/drawing/2014/main" id="{636BE2DF-D0A0-C8EC-8B07-A4C38C7CCB05}"/>
                  </a:ext>
                </a:extLst>
              </p:cNvPr>
              <p:cNvGrpSpPr/>
              <p:nvPr/>
            </p:nvGrpSpPr>
            <p:grpSpPr>
              <a:xfrm>
                <a:off x="8914041" y="3720742"/>
                <a:ext cx="420721" cy="369332"/>
                <a:chOff x="6385314" y="4474207"/>
                <a:chExt cx="781051" cy="742950"/>
              </a:xfrm>
              <a:solidFill>
                <a:srgbClr val="000000"/>
              </a:solidFill>
            </p:grpSpPr>
            <p:sp>
              <p:nvSpPr>
                <p:cNvPr id="147" name="Freeform: Shape 146">
                  <a:extLst>
                    <a:ext uri="{FF2B5EF4-FFF2-40B4-BE49-F238E27FC236}">
                      <a16:creationId xmlns:a16="http://schemas.microsoft.com/office/drawing/2014/main" id="{3BFEA17A-F758-0681-E035-9E1C28DFCFCE}"/>
                    </a:ext>
                  </a:extLst>
                </p:cNvPr>
                <p:cNvSpPr/>
                <p:nvPr/>
              </p:nvSpPr>
              <p:spPr>
                <a:xfrm>
                  <a:off x="6699625" y="4588602"/>
                  <a:ext cx="152400" cy="152398"/>
                </a:xfrm>
                <a:custGeom>
                  <a:avLst/>
                  <a:gdLst>
                    <a:gd name="connsiteX0" fmla="*/ 76200 w 152400"/>
                    <a:gd name="connsiteY0" fmla="*/ 152400 h 152399"/>
                    <a:gd name="connsiteX1" fmla="*/ 152400 w 152400"/>
                    <a:gd name="connsiteY1" fmla="*/ 76200 h 152399"/>
                    <a:gd name="connsiteX2" fmla="*/ 76200 w 152400"/>
                    <a:gd name="connsiteY2" fmla="*/ 0 h 152399"/>
                    <a:gd name="connsiteX3" fmla="*/ 0 w 152400"/>
                    <a:gd name="connsiteY3" fmla="*/ 76200 h 152399"/>
                    <a:gd name="connsiteX4" fmla="*/ 76200 w 152400"/>
                    <a:gd name="connsiteY4" fmla="*/ 152400 h 152399"/>
                    <a:gd name="connsiteX5" fmla="*/ 76200 w 152400"/>
                    <a:gd name="connsiteY5" fmla="*/ 19050 h 152399"/>
                    <a:gd name="connsiteX6" fmla="*/ 133350 w 152400"/>
                    <a:gd name="connsiteY6" fmla="*/ 76200 h 152399"/>
                    <a:gd name="connsiteX7" fmla="*/ 76200 w 152400"/>
                    <a:gd name="connsiteY7" fmla="*/ 133350 h 152399"/>
                    <a:gd name="connsiteX8" fmla="*/ 19050 w 152400"/>
                    <a:gd name="connsiteY8" fmla="*/ 76200 h 152399"/>
                    <a:gd name="connsiteX9" fmla="*/ 76200 w 152400"/>
                    <a:gd name="connsiteY9" fmla="*/ 19012 h 15239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52400" h="152399">
                      <a:moveTo>
                        <a:pt x="76200" y="152400"/>
                      </a:moveTo>
                      <a:cubicBezTo>
                        <a:pt x="118284" y="152400"/>
                        <a:pt x="152400" y="118284"/>
                        <a:pt x="152400" y="76200"/>
                      </a:cubicBezTo>
                      <a:cubicBezTo>
                        <a:pt x="152400" y="34116"/>
                        <a:pt x="118284" y="0"/>
                        <a:pt x="76200" y="0"/>
                      </a:cubicBezTo>
                      <a:cubicBezTo>
                        <a:pt x="34116" y="0"/>
                        <a:pt x="0" y="34116"/>
                        <a:pt x="0" y="76200"/>
                      </a:cubicBezTo>
                      <a:cubicBezTo>
                        <a:pt x="0" y="118284"/>
                        <a:pt x="34116" y="152400"/>
                        <a:pt x="76200" y="152400"/>
                      </a:cubicBezTo>
                      <a:close/>
                      <a:moveTo>
                        <a:pt x="76200" y="19050"/>
                      </a:moveTo>
                      <a:cubicBezTo>
                        <a:pt x="107763" y="19050"/>
                        <a:pt x="133350" y="44637"/>
                        <a:pt x="133350" y="76200"/>
                      </a:cubicBezTo>
                      <a:cubicBezTo>
                        <a:pt x="133350" y="107763"/>
                        <a:pt x="107763" y="133350"/>
                        <a:pt x="76200" y="133350"/>
                      </a:cubicBezTo>
                      <a:cubicBezTo>
                        <a:pt x="44637" y="133350"/>
                        <a:pt x="19050" y="107763"/>
                        <a:pt x="19050" y="76200"/>
                      </a:cubicBezTo>
                      <a:cubicBezTo>
                        <a:pt x="19071" y="44640"/>
                        <a:pt x="44640" y="19054"/>
                        <a:pt x="76200" y="19012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148" name="Freeform: Shape 147">
                  <a:extLst>
                    <a:ext uri="{FF2B5EF4-FFF2-40B4-BE49-F238E27FC236}">
                      <a16:creationId xmlns:a16="http://schemas.microsoft.com/office/drawing/2014/main" id="{0BAA05B1-41D0-864C-91F3-1D6570A3BAF4}"/>
                    </a:ext>
                  </a:extLst>
                </p:cNvPr>
                <p:cNvSpPr/>
                <p:nvPr/>
              </p:nvSpPr>
              <p:spPr>
                <a:xfrm>
                  <a:off x="6385314" y="4474207"/>
                  <a:ext cx="781051" cy="742950"/>
                </a:xfrm>
                <a:custGeom>
                  <a:avLst/>
                  <a:gdLst>
                    <a:gd name="connsiteX0" fmla="*/ 771525 w 781050"/>
                    <a:gd name="connsiteY0" fmla="*/ 76200 h 742950"/>
                    <a:gd name="connsiteX1" fmla="*/ 752475 w 781050"/>
                    <a:gd name="connsiteY1" fmla="*/ 76200 h 742950"/>
                    <a:gd name="connsiteX2" fmla="*/ 752475 w 781050"/>
                    <a:gd name="connsiteY2" fmla="*/ 56197 h 742950"/>
                    <a:gd name="connsiteX3" fmla="*/ 724853 w 781050"/>
                    <a:gd name="connsiteY3" fmla="*/ 28575 h 742950"/>
                    <a:gd name="connsiteX4" fmla="*/ 722948 w 781050"/>
                    <a:gd name="connsiteY4" fmla="*/ 28575 h 742950"/>
                    <a:gd name="connsiteX5" fmla="*/ 714375 w 781050"/>
                    <a:gd name="connsiteY5" fmla="*/ 30070 h 742950"/>
                    <a:gd name="connsiteX6" fmla="*/ 714375 w 781050"/>
                    <a:gd name="connsiteY6" fmla="*/ 27622 h 742950"/>
                    <a:gd name="connsiteX7" fmla="*/ 686753 w 781050"/>
                    <a:gd name="connsiteY7" fmla="*/ 0 h 742950"/>
                    <a:gd name="connsiteX8" fmla="*/ 684848 w 781050"/>
                    <a:gd name="connsiteY8" fmla="*/ 0 h 742950"/>
                    <a:gd name="connsiteX9" fmla="*/ 657225 w 781050"/>
                    <a:gd name="connsiteY9" fmla="*/ 27622 h 742950"/>
                    <a:gd name="connsiteX10" fmla="*/ 657225 w 781050"/>
                    <a:gd name="connsiteY10" fmla="*/ 76200 h 742950"/>
                    <a:gd name="connsiteX11" fmla="*/ 123825 w 781050"/>
                    <a:gd name="connsiteY11" fmla="*/ 76200 h 742950"/>
                    <a:gd name="connsiteX12" fmla="*/ 123825 w 781050"/>
                    <a:gd name="connsiteY12" fmla="*/ 27622 h 742950"/>
                    <a:gd name="connsiteX13" fmla="*/ 96203 w 781050"/>
                    <a:gd name="connsiteY13" fmla="*/ 0 h 742950"/>
                    <a:gd name="connsiteX14" fmla="*/ 94298 w 781050"/>
                    <a:gd name="connsiteY14" fmla="*/ 0 h 742950"/>
                    <a:gd name="connsiteX15" fmla="*/ 66675 w 781050"/>
                    <a:gd name="connsiteY15" fmla="*/ 27622 h 742950"/>
                    <a:gd name="connsiteX16" fmla="*/ 66675 w 781050"/>
                    <a:gd name="connsiteY16" fmla="*/ 30070 h 742950"/>
                    <a:gd name="connsiteX17" fmla="*/ 58103 w 781050"/>
                    <a:gd name="connsiteY17" fmla="*/ 28575 h 742950"/>
                    <a:gd name="connsiteX18" fmla="*/ 56197 w 781050"/>
                    <a:gd name="connsiteY18" fmla="*/ 28575 h 742950"/>
                    <a:gd name="connsiteX19" fmla="*/ 28575 w 781050"/>
                    <a:gd name="connsiteY19" fmla="*/ 56197 h 742950"/>
                    <a:gd name="connsiteX20" fmla="*/ 28575 w 781050"/>
                    <a:gd name="connsiteY20" fmla="*/ 76200 h 742950"/>
                    <a:gd name="connsiteX21" fmla="*/ 9525 w 781050"/>
                    <a:gd name="connsiteY21" fmla="*/ 76200 h 742950"/>
                    <a:gd name="connsiteX22" fmla="*/ 0 w 781050"/>
                    <a:gd name="connsiteY22" fmla="*/ 85725 h 742950"/>
                    <a:gd name="connsiteX23" fmla="*/ 9525 w 781050"/>
                    <a:gd name="connsiteY23" fmla="*/ 95250 h 742950"/>
                    <a:gd name="connsiteX24" fmla="*/ 28575 w 781050"/>
                    <a:gd name="connsiteY24" fmla="*/ 95250 h 742950"/>
                    <a:gd name="connsiteX25" fmla="*/ 28575 w 781050"/>
                    <a:gd name="connsiteY25" fmla="*/ 115253 h 742950"/>
                    <a:gd name="connsiteX26" fmla="*/ 56197 w 781050"/>
                    <a:gd name="connsiteY26" fmla="*/ 142875 h 742950"/>
                    <a:gd name="connsiteX27" fmla="*/ 58103 w 781050"/>
                    <a:gd name="connsiteY27" fmla="*/ 142875 h 742950"/>
                    <a:gd name="connsiteX28" fmla="*/ 66675 w 781050"/>
                    <a:gd name="connsiteY28" fmla="*/ 141380 h 742950"/>
                    <a:gd name="connsiteX29" fmla="*/ 66675 w 781050"/>
                    <a:gd name="connsiteY29" fmla="*/ 143828 h 742950"/>
                    <a:gd name="connsiteX30" fmla="*/ 94298 w 781050"/>
                    <a:gd name="connsiteY30" fmla="*/ 171450 h 742950"/>
                    <a:gd name="connsiteX31" fmla="*/ 96203 w 781050"/>
                    <a:gd name="connsiteY31" fmla="*/ 171450 h 742950"/>
                    <a:gd name="connsiteX32" fmla="*/ 123825 w 781050"/>
                    <a:gd name="connsiteY32" fmla="*/ 143828 h 742950"/>
                    <a:gd name="connsiteX33" fmla="*/ 123825 w 781050"/>
                    <a:gd name="connsiteY33" fmla="*/ 95250 h 742950"/>
                    <a:gd name="connsiteX34" fmla="*/ 168726 w 781050"/>
                    <a:gd name="connsiteY34" fmla="*/ 95250 h 742950"/>
                    <a:gd name="connsiteX35" fmla="*/ 168726 w 781050"/>
                    <a:gd name="connsiteY35" fmla="*/ 253003 h 742950"/>
                    <a:gd name="connsiteX36" fmla="*/ 191891 w 781050"/>
                    <a:gd name="connsiteY36" fmla="*/ 293075 h 742950"/>
                    <a:gd name="connsiteX37" fmla="*/ 304800 w 781050"/>
                    <a:gd name="connsiteY37" fmla="*/ 359626 h 742950"/>
                    <a:gd name="connsiteX38" fmla="*/ 304800 w 781050"/>
                    <a:gd name="connsiteY38" fmla="*/ 453923 h 742950"/>
                    <a:gd name="connsiteX39" fmla="*/ 189986 w 781050"/>
                    <a:gd name="connsiteY39" fmla="*/ 528218 h 742950"/>
                    <a:gd name="connsiteX40" fmla="*/ 168726 w 781050"/>
                    <a:gd name="connsiteY40" fmla="*/ 567271 h 742950"/>
                    <a:gd name="connsiteX41" fmla="*/ 168726 w 781050"/>
                    <a:gd name="connsiteY41" fmla="*/ 742950 h 742950"/>
                    <a:gd name="connsiteX42" fmla="*/ 252193 w 781050"/>
                    <a:gd name="connsiteY42" fmla="*/ 742950 h 742950"/>
                    <a:gd name="connsiteX43" fmla="*/ 252193 w 781050"/>
                    <a:gd name="connsiteY43" fmla="*/ 592636 h 742950"/>
                    <a:gd name="connsiteX44" fmla="*/ 319421 w 781050"/>
                    <a:gd name="connsiteY44" fmla="*/ 549088 h 742950"/>
                    <a:gd name="connsiteX45" fmla="*/ 461677 w 781050"/>
                    <a:gd name="connsiteY45" fmla="*/ 549088 h 742950"/>
                    <a:gd name="connsiteX46" fmla="*/ 528904 w 781050"/>
                    <a:gd name="connsiteY46" fmla="*/ 592636 h 742950"/>
                    <a:gd name="connsiteX47" fmla="*/ 528904 w 781050"/>
                    <a:gd name="connsiteY47" fmla="*/ 742950 h 742950"/>
                    <a:gd name="connsiteX48" fmla="*/ 612372 w 781050"/>
                    <a:gd name="connsiteY48" fmla="*/ 742950 h 742950"/>
                    <a:gd name="connsiteX49" fmla="*/ 612372 w 781050"/>
                    <a:gd name="connsiteY49" fmla="*/ 567299 h 742950"/>
                    <a:gd name="connsiteX50" fmla="*/ 591112 w 781050"/>
                    <a:gd name="connsiteY50" fmla="*/ 528247 h 742950"/>
                    <a:gd name="connsiteX51" fmla="*/ 476298 w 781050"/>
                    <a:gd name="connsiteY51" fmla="*/ 453952 h 742950"/>
                    <a:gd name="connsiteX52" fmla="*/ 476298 w 781050"/>
                    <a:gd name="connsiteY52" fmla="*/ 359654 h 742950"/>
                    <a:gd name="connsiteX53" fmla="*/ 589131 w 781050"/>
                    <a:gd name="connsiteY53" fmla="*/ 293141 h 742950"/>
                    <a:gd name="connsiteX54" fmla="*/ 612372 w 781050"/>
                    <a:gd name="connsiteY54" fmla="*/ 253003 h 742950"/>
                    <a:gd name="connsiteX55" fmla="*/ 612372 w 781050"/>
                    <a:gd name="connsiteY55" fmla="*/ 95250 h 742950"/>
                    <a:gd name="connsiteX56" fmla="*/ 657225 w 781050"/>
                    <a:gd name="connsiteY56" fmla="*/ 95250 h 742950"/>
                    <a:gd name="connsiteX57" fmla="*/ 657225 w 781050"/>
                    <a:gd name="connsiteY57" fmla="*/ 143828 h 742950"/>
                    <a:gd name="connsiteX58" fmla="*/ 684848 w 781050"/>
                    <a:gd name="connsiteY58" fmla="*/ 171450 h 742950"/>
                    <a:gd name="connsiteX59" fmla="*/ 686753 w 781050"/>
                    <a:gd name="connsiteY59" fmla="*/ 171450 h 742950"/>
                    <a:gd name="connsiteX60" fmla="*/ 714375 w 781050"/>
                    <a:gd name="connsiteY60" fmla="*/ 143828 h 742950"/>
                    <a:gd name="connsiteX61" fmla="*/ 714375 w 781050"/>
                    <a:gd name="connsiteY61" fmla="*/ 141380 h 742950"/>
                    <a:gd name="connsiteX62" fmla="*/ 722948 w 781050"/>
                    <a:gd name="connsiteY62" fmla="*/ 142875 h 742950"/>
                    <a:gd name="connsiteX63" fmla="*/ 724853 w 781050"/>
                    <a:gd name="connsiteY63" fmla="*/ 142875 h 742950"/>
                    <a:gd name="connsiteX64" fmla="*/ 752475 w 781050"/>
                    <a:gd name="connsiteY64" fmla="*/ 115253 h 742950"/>
                    <a:gd name="connsiteX65" fmla="*/ 752475 w 781050"/>
                    <a:gd name="connsiteY65" fmla="*/ 95250 h 742950"/>
                    <a:gd name="connsiteX66" fmla="*/ 771525 w 781050"/>
                    <a:gd name="connsiteY66" fmla="*/ 95250 h 742950"/>
                    <a:gd name="connsiteX67" fmla="*/ 781050 w 781050"/>
                    <a:gd name="connsiteY67" fmla="*/ 85725 h 742950"/>
                    <a:gd name="connsiteX68" fmla="*/ 771525 w 781050"/>
                    <a:gd name="connsiteY68" fmla="*/ 76200 h 742950"/>
                    <a:gd name="connsiteX69" fmla="*/ 58103 w 781050"/>
                    <a:gd name="connsiteY69" fmla="*/ 123825 h 742950"/>
                    <a:gd name="connsiteX70" fmla="*/ 56197 w 781050"/>
                    <a:gd name="connsiteY70" fmla="*/ 123825 h 742950"/>
                    <a:gd name="connsiteX71" fmla="*/ 47625 w 781050"/>
                    <a:gd name="connsiteY71" fmla="*/ 115253 h 742950"/>
                    <a:gd name="connsiteX72" fmla="*/ 47625 w 781050"/>
                    <a:gd name="connsiteY72" fmla="*/ 56197 h 742950"/>
                    <a:gd name="connsiteX73" fmla="*/ 56197 w 781050"/>
                    <a:gd name="connsiteY73" fmla="*/ 47625 h 742950"/>
                    <a:gd name="connsiteX74" fmla="*/ 58103 w 781050"/>
                    <a:gd name="connsiteY74" fmla="*/ 47625 h 742950"/>
                    <a:gd name="connsiteX75" fmla="*/ 66675 w 781050"/>
                    <a:gd name="connsiteY75" fmla="*/ 56197 h 742950"/>
                    <a:gd name="connsiteX76" fmla="*/ 66675 w 781050"/>
                    <a:gd name="connsiteY76" fmla="*/ 115253 h 742950"/>
                    <a:gd name="connsiteX77" fmla="*/ 58103 w 781050"/>
                    <a:gd name="connsiteY77" fmla="*/ 123825 h 742950"/>
                    <a:gd name="connsiteX78" fmla="*/ 104775 w 781050"/>
                    <a:gd name="connsiteY78" fmla="*/ 143828 h 742950"/>
                    <a:gd name="connsiteX79" fmla="*/ 96203 w 781050"/>
                    <a:gd name="connsiteY79" fmla="*/ 152400 h 742950"/>
                    <a:gd name="connsiteX80" fmla="*/ 94298 w 781050"/>
                    <a:gd name="connsiteY80" fmla="*/ 152400 h 742950"/>
                    <a:gd name="connsiteX81" fmla="*/ 85725 w 781050"/>
                    <a:gd name="connsiteY81" fmla="*/ 143828 h 742950"/>
                    <a:gd name="connsiteX82" fmla="*/ 85725 w 781050"/>
                    <a:gd name="connsiteY82" fmla="*/ 27622 h 742950"/>
                    <a:gd name="connsiteX83" fmla="*/ 94298 w 781050"/>
                    <a:gd name="connsiteY83" fmla="*/ 19050 h 742950"/>
                    <a:gd name="connsiteX84" fmla="*/ 96203 w 781050"/>
                    <a:gd name="connsiteY84" fmla="*/ 19050 h 742950"/>
                    <a:gd name="connsiteX85" fmla="*/ 104775 w 781050"/>
                    <a:gd name="connsiteY85" fmla="*/ 27622 h 742950"/>
                    <a:gd name="connsiteX86" fmla="*/ 528904 w 781050"/>
                    <a:gd name="connsiteY86" fmla="*/ 95250 h 742950"/>
                    <a:gd name="connsiteX87" fmla="*/ 528904 w 781050"/>
                    <a:gd name="connsiteY87" fmla="*/ 226352 h 742950"/>
                    <a:gd name="connsiteX88" fmla="*/ 421272 w 781050"/>
                    <a:gd name="connsiteY88" fmla="*/ 289674 h 742950"/>
                    <a:gd name="connsiteX89" fmla="*/ 359769 w 781050"/>
                    <a:gd name="connsiteY89" fmla="*/ 289674 h 742950"/>
                    <a:gd name="connsiteX90" fmla="*/ 252193 w 781050"/>
                    <a:gd name="connsiteY90" fmla="*/ 226352 h 742950"/>
                    <a:gd name="connsiteX91" fmla="*/ 252193 w 781050"/>
                    <a:gd name="connsiteY91" fmla="*/ 95250 h 742950"/>
                    <a:gd name="connsiteX92" fmla="*/ 593322 w 781050"/>
                    <a:gd name="connsiteY92" fmla="*/ 567299 h 742950"/>
                    <a:gd name="connsiteX93" fmla="*/ 593322 w 781050"/>
                    <a:gd name="connsiteY93" fmla="*/ 723900 h 742950"/>
                    <a:gd name="connsiteX94" fmla="*/ 547954 w 781050"/>
                    <a:gd name="connsiteY94" fmla="*/ 723900 h 742950"/>
                    <a:gd name="connsiteX95" fmla="*/ 547954 w 781050"/>
                    <a:gd name="connsiteY95" fmla="*/ 582273 h 742950"/>
                    <a:gd name="connsiteX96" fmla="*/ 467316 w 781050"/>
                    <a:gd name="connsiteY96" fmla="*/ 530038 h 742950"/>
                    <a:gd name="connsiteX97" fmla="*/ 313782 w 781050"/>
                    <a:gd name="connsiteY97" fmla="*/ 530038 h 742950"/>
                    <a:gd name="connsiteX98" fmla="*/ 233143 w 781050"/>
                    <a:gd name="connsiteY98" fmla="*/ 582273 h 742950"/>
                    <a:gd name="connsiteX99" fmla="*/ 233143 w 781050"/>
                    <a:gd name="connsiteY99" fmla="*/ 723900 h 742950"/>
                    <a:gd name="connsiteX100" fmla="*/ 187776 w 781050"/>
                    <a:gd name="connsiteY100" fmla="*/ 723900 h 742950"/>
                    <a:gd name="connsiteX101" fmla="*/ 187776 w 781050"/>
                    <a:gd name="connsiteY101" fmla="*/ 567299 h 742950"/>
                    <a:gd name="connsiteX102" fmla="*/ 200330 w 781050"/>
                    <a:gd name="connsiteY102" fmla="*/ 544230 h 742950"/>
                    <a:gd name="connsiteX103" fmla="*/ 328917 w 781050"/>
                    <a:gd name="connsiteY103" fmla="*/ 460981 h 742950"/>
                    <a:gd name="connsiteX104" fmla="*/ 452161 w 781050"/>
                    <a:gd name="connsiteY104" fmla="*/ 460981 h 742950"/>
                    <a:gd name="connsiteX105" fmla="*/ 580749 w 781050"/>
                    <a:gd name="connsiteY105" fmla="*/ 544230 h 742950"/>
                    <a:gd name="connsiteX106" fmla="*/ 593322 w 781050"/>
                    <a:gd name="connsiteY106" fmla="*/ 567299 h 742950"/>
                    <a:gd name="connsiteX107" fmla="*/ 457248 w 781050"/>
                    <a:gd name="connsiteY107" fmla="*/ 441960 h 742950"/>
                    <a:gd name="connsiteX108" fmla="*/ 323850 w 781050"/>
                    <a:gd name="connsiteY108" fmla="*/ 441960 h 742950"/>
                    <a:gd name="connsiteX109" fmla="*/ 323850 w 781050"/>
                    <a:gd name="connsiteY109" fmla="*/ 362502 h 742950"/>
                    <a:gd name="connsiteX110" fmla="*/ 323912 w 781050"/>
                    <a:gd name="connsiteY110" fmla="*/ 349127 h 742950"/>
                    <a:gd name="connsiteX111" fmla="*/ 321945 w 781050"/>
                    <a:gd name="connsiteY111" fmla="*/ 347605 h 742950"/>
                    <a:gd name="connsiteX112" fmla="*/ 201492 w 781050"/>
                    <a:gd name="connsiteY112" fmla="*/ 276616 h 742950"/>
                    <a:gd name="connsiteX113" fmla="*/ 187776 w 781050"/>
                    <a:gd name="connsiteY113" fmla="*/ 252974 h 742950"/>
                    <a:gd name="connsiteX114" fmla="*/ 187776 w 781050"/>
                    <a:gd name="connsiteY114" fmla="*/ 95250 h 742950"/>
                    <a:gd name="connsiteX115" fmla="*/ 233143 w 781050"/>
                    <a:gd name="connsiteY115" fmla="*/ 95250 h 742950"/>
                    <a:gd name="connsiteX116" fmla="*/ 233143 w 781050"/>
                    <a:gd name="connsiteY116" fmla="*/ 237249 h 742950"/>
                    <a:gd name="connsiteX117" fmla="*/ 354587 w 781050"/>
                    <a:gd name="connsiteY117" fmla="*/ 308686 h 742950"/>
                    <a:gd name="connsiteX118" fmla="*/ 426501 w 781050"/>
                    <a:gd name="connsiteY118" fmla="*/ 308686 h 742950"/>
                    <a:gd name="connsiteX119" fmla="*/ 547954 w 781050"/>
                    <a:gd name="connsiteY119" fmla="*/ 237249 h 742950"/>
                    <a:gd name="connsiteX120" fmla="*/ 547954 w 781050"/>
                    <a:gd name="connsiteY120" fmla="*/ 95250 h 742950"/>
                    <a:gd name="connsiteX121" fmla="*/ 593322 w 781050"/>
                    <a:gd name="connsiteY121" fmla="*/ 95250 h 742950"/>
                    <a:gd name="connsiteX122" fmla="*/ 593322 w 781050"/>
                    <a:gd name="connsiteY122" fmla="*/ 252936 h 742950"/>
                    <a:gd name="connsiteX123" fmla="*/ 579530 w 781050"/>
                    <a:gd name="connsiteY123" fmla="*/ 276663 h 742950"/>
                    <a:gd name="connsiteX124" fmla="*/ 459372 w 781050"/>
                    <a:gd name="connsiteY124" fmla="*/ 347491 h 742950"/>
                    <a:gd name="connsiteX125" fmla="*/ 456000 w 781050"/>
                    <a:gd name="connsiteY125" fmla="*/ 360531 h 742950"/>
                    <a:gd name="connsiteX126" fmla="*/ 457248 w 781050"/>
                    <a:gd name="connsiteY126" fmla="*/ 361921 h 742950"/>
                    <a:gd name="connsiteX127" fmla="*/ 695325 w 781050"/>
                    <a:gd name="connsiteY127" fmla="*/ 143828 h 742950"/>
                    <a:gd name="connsiteX128" fmla="*/ 686753 w 781050"/>
                    <a:gd name="connsiteY128" fmla="*/ 152400 h 742950"/>
                    <a:gd name="connsiteX129" fmla="*/ 684848 w 781050"/>
                    <a:gd name="connsiteY129" fmla="*/ 152400 h 742950"/>
                    <a:gd name="connsiteX130" fmla="*/ 676275 w 781050"/>
                    <a:gd name="connsiteY130" fmla="*/ 143828 h 742950"/>
                    <a:gd name="connsiteX131" fmla="*/ 676275 w 781050"/>
                    <a:gd name="connsiteY131" fmla="*/ 27622 h 742950"/>
                    <a:gd name="connsiteX132" fmla="*/ 684848 w 781050"/>
                    <a:gd name="connsiteY132" fmla="*/ 19050 h 742950"/>
                    <a:gd name="connsiteX133" fmla="*/ 686753 w 781050"/>
                    <a:gd name="connsiteY133" fmla="*/ 19050 h 742950"/>
                    <a:gd name="connsiteX134" fmla="*/ 695325 w 781050"/>
                    <a:gd name="connsiteY134" fmla="*/ 27622 h 742950"/>
                    <a:gd name="connsiteX135" fmla="*/ 695325 w 781050"/>
                    <a:gd name="connsiteY135" fmla="*/ 143828 h 742950"/>
                    <a:gd name="connsiteX136" fmla="*/ 733425 w 781050"/>
                    <a:gd name="connsiteY136" fmla="*/ 115253 h 742950"/>
                    <a:gd name="connsiteX137" fmla="*/ 724853 w 781050"/>
                    <a:gd name="connsiteY137" fmla="*/ 123825 h 742950"/>
                    <a:gd name="connsiteX138" fmla="*/ 722948 w 781050"/>
                    <a:gd name="connsiteY138" fmla="*/ 123825 h 742950"/>
                    <a:gd name="connsiteX139" fmla="*/ 714375 w 781050"/>
                    <a:gd name="connsiteY139" fmla="*/ 115253 h 742950"/>
                    <a:gd name="connsiteX140" fmla="*/ 714375 w 781050"/>
                    <a:gd name="connsiteY140" fmla="*/ 56197 h 742950"/>
                    <a:gd name="connsiteX141" fmla="*/ 722948 w 781050"/>
                    <a:gd name="connsiteY141" fmla="*/ 47625 h 742950"/>
                    <a:gd name="connsiteX142" fmla="*/ 724853 w 781050"/>
                    <a:gd name="connsiteY142" fmla="*/ 47625 h 742950"/>
                    <a:gd name="connsiteX143" fmla="*/ 733425 w 781050"/>
                    <a:gd name="connsiteY143" fmla="*/ 56197 h 742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  <a:cxn ang="0">
                      <a:pos x="connsiteX138" y="connsiteY138"/>
                    </a:cxn>
                    <a:cxn ang="0">
                      <a:pos x="connsiteX139" y="connsiteY139"/>
                    </a:cxn>
                    <a:cxn ang="0">
                      <a:pos x="connsiteX140" y="connsiteY140"/>
                    </a:cxn>
                    <a:cxn ang="0">
                      <a:pos x="connsiteX141" y="connsiteY141"/>
                    </a:cxn>
                    <a:cxn ang="0">
                      <a:pos x="connsiteX142" y="connsiteY142"/>
                    </a:cxn>
                    <a:cxn ang="0">
                      <a:pos x="connsiteX143" y="connsiteY143"/>
                    </a:cxn>
                  </a:cxnLst>
                  <a:rect l="l" t="t" r="r" b="b"/>
                  <a:pathLst>
                    <a:path w="781050" h="742950">
                      <a:moveTo>
                        <a:pt x="771525" y="76200"/>
                      </a:moveTo>
                      <a:lnTo>
                        <a:pt x="752475" y="76200"/>
                      </a:lnTo>
                      <a:lnTo>
                        <a:pt x="752475" y="56197"/>
                      </a:lnTo>
                      <a:cubicBezTo>
                        <a:pt x="752475" y="40942"/>
                        <a:pt x="740108" y="28575"/>
                        <a:pt x="724853" y="28575"/>
                      </a:cubicBezTo>
                      <a:lnTo>
                        <a:pt x="722948" y="28575"/>
                      </a:lnTo>
                      <a:cubicBezTo>
                        <a:pt x="720028" y="28611"/>
                        <a:pt x="717133" y="29116"/>
                        <a:pt x="714375" y="30070"/>
                      </a:cubicBezTo>
                      <a:lnTo>
                        <a:pt x="714375" y="27622"/>
                      </a:lnTo>
                      <a:cubicBezTo>
                        <a:pt x="714375" y="12367"/>
                        <a:pt x="702008" y="0"/>
                        <a:pt x="686753" y="0"/>
                      </a:cubicBezTo>
                      <a:lnTo>
                        <a:pt x="684848" y="0"/>
                      </a:lnTo>
                      <a:cubicBezTo>
                        <a:pt x="669592" y="0"/>
                        <a:pt x="657225" y="12367"/>
                        <a:pt x="657225" y="27622"/>
                      </a:cubicBezTo>
                      <a:lnTo>
                        <a:pt x="657225" y="76200"/>
                      </a:lnTo>
                      <a:lnTo>
                        <a:pt x="123825" y="76200"/>
                      </a:lnTo>
                      <a:lnTo>
                        <a:pt x="123825" y="27622"/>
                      </a:lnTo>
                      <a:cubicBezTo>
                        <a:pt x="123825" y="12367"/>
                        <a:pt x="111458" y="0"/>
                        <a:pt x="96203" y="0"/>
                      </a:cubicBezTo>
                      <a:lnTo>
                        <a:pt x="94298" y="0"/>
                      </a:lnTo>
                      <a:cubicBezTo>
                        <a:pt x="79042" y="0"/>
                        <a:pt x="66675" y="12367"/>
                        <a:pt x="66675" y="27622"/>
                      </a:cubicBezTo>
                      <a:lnTo>
                        <a:pt x="66675" y="30070"/>
                      </a:lnTo>
                      <a:cubicBezTo>
                        <a:pt x="63917" y="29116"/>
                        <a:pt x="61022" y="28611"/>
                        <a:pt x="58103" y="28575"/>
                      </a:cubicBezTo>
                      <a:lnTo>
                        <a:pt x="56197" y="28575"/>
                      </a:lnTo>
                      <a:cubicBezTo>
                        <a:pt x="40942" y="28575"/>
                        <a:pt x="28575" y="40942"/>
                        <a:pt x="28575" y="56197"/>
                      </a:cubicBezTo>
                      <a:lnTo>
                        <a:pt x="28575" y="76200"/>
                      </a:lnTo>
                      <a:lnTo>
                        <a:pt x="9525" y="76200"/>
                      </a:lnTo>
                      <a:cubicBezTo>
                        <a:pt x="4265" y="76200"/>
                        <a:pt x="0" y="80464"/>
                        <a:pt x="0" y="85725"/>
                      </a:cubicBezTo>
                      <a:cubicBezTo>
                        <a:pt x="0" y="90986"/>
                        <a:pt x="4265" y="95250"/>
                        <a:pt x="9525" y="95250"/>
                      </a:cubicBezTo>
                      <a:lnTo>
                        <a:pt x="28575" y="95250"/>
                      </a:lnTo>
                      <a:lnTo>
                        <a:pt x="28575" y="115253"/>
                      </a:lnTo>
                      <a:cubicBezTo>
                        <a:pt x="28575" y="130508"/>
                        <a:pt x="40942" y="142875"/>
                        <a:pt x="56197" y="142875"/>
                      </a:cubicBezTo>
                      <a:lnTo>
                        <a:pt x="58103" y="142875"/>
                      </a:lnTo>
                      <a:cubicBezTo>
                        <a:pt x="61022" y="142839"/>
                        <a:pt x="63917" y="142334"/>
                        <a:pt x="66675" y="141380"/>
                      </a:cubicBezTo>
                      <a:lnTo>
                        <a:pt x="66675" y="143828"/>
                      </a:lnTo>
                      <a:cubicBezTo>
                        <a:pt x="66675" y="159083"/>
                        <a:pt x="79042" y="171450"/>
                        <a:pt x="94298" y="171450"/>
                      </a:cubicBezTo>
                      <a:lnTo>
                        <a:pt x="96203" y="171450"/>
                      </a:lnTo>
                      <a:cubicBezTo>
                        <a:pt x="111458" y="171450"/>
                        <a:pt x="123825" y="159083"/>
                        <a:pt x="123825" y="143828"/>
                      </a:cubicBezTo>
                      <a:lnTo>
                        <a:pt x="123825" y="95250"/>
                      </a:lnTo>
                      <a:lnTo>
                        <a:pt x="168726" y="95250"/>
                      </a:lnTo>
                      <a:lnTo>
                        <a:pt x="168726" y="253003"/>
                      </a:lnTo>
                      <a:cubicBezTo>
                        <a:pt x="168813" y="269518"/>
                        <a:pt x="177623" y="284757"/>
                        <a:pt x="191891" y="293075"/>
                      </a:cubicBezTo>
                      <a:lnTo>
                        <a:pt x="304800" y="359626"/>
                      </a:lnTo>
                      <a:lnTo>
                        <a:pt x="304800" y="453923"/>
                      </a:lnTo>
                      <a:lnTo>
                        <a:pt x="189986" y="528218"/>
                      </a:lnTo>
                      <a:cubicBezTo>
                        <a:pt x="176709" y="536764"/>
                        <a:pt x="168696" y="551481"/>
                        <a:pt x="168726" y="567271"/>
                      </a:cubicBezTo>
                      <a:lnTo>
                        <a:pt x="168726" y="742950"/>
                      </a:lnTo>
                      <a:lnTo>
                        <a:pt x="252193" y="742950"/>
                      </a:lnTo>
                      <a:lnTo>
                        <a:pt x="252193" y="592636"/>
                      </a:lnTo>
                      <a:lnTo>
                        <a:pt x="319421" y="549088"/>
                      </a:lnTo>
                      <a:lnTo>
                        <a:pt x="461677" y="549088"/>
                      </a:lnTo>
                      <a:lnTo>
                        <a:pt x="528904" y="592636"/>
                      </a:lnTo>
                      <a:lnTo>
                        <a:pt x="528904" y="742950"/>
                      </a:lnTo>
                      <a:lnTo>
                        <a:pt x="612372" y="742950"/>
                      </a:lnTo>
                      <a:lnTo>
                        <a:pt x="612372" y="567299"/>
                      </a:lnTo>
                      <a:cubicBezTo>
                        <a:pt x="612401" y="551510"/>
                        <a:pt x="604389" y="536793"/>
                        <a:pt x="591112" y="528247"/>
                      </a:cubicBezTo>
                      <a:lnTo>
                        <a:pt x="476298" y="453952"/>
                      </a:lnTo>
                      <a:lnTo>
                        <a:pt x="476298" y="359654"/>
                      </a:lnTo>
                      <a:lnTo>
                        <a:pt x="589131" y="293141"/>
                      </a:lnTo>
                      <a:cubicBezTo>
                        <a:pt x="603448" y="284831"/>
                        <a:pt x="612292" y="269558"/>
                        <a:pt x="612372" y="253003"/>
                      </a:cubicBezTo>
                      <a:lnTo>
                        <a:pt x="612372" y="95250"/>
                      </a:lnTo>
                      <a:lnTo>
                        <a:pt x="657225" y="95250"/>
                      </a:lnTo>
                      <a:lnTo>
                        <a:pt x="657225" y="143828"/>
                      </a:lnTo>
                      <a:cubicBezTo>
                        <a:pt x="657225" y="159083"/>
                        <a:pt x="669592" y="171450"/>
                        <a:pt x="684848" y="171450"/>
                      </a:cubicBezTo>
                      <a:lnTo>
                        <a:pt x="686753" y="171450"/>
                      </a:lnTo>
                      <a:cubicBezTo>
                        <a:pt x="702008" y="171450"/>
                        <a:pt x="714375" y="159083"/>
                        <a:pt x="714375" y="143828"/>
                      </a:cubicBezTo>
                      <a:lnTo>
                        <a:pt x="714375" y="141380"/>
                      </a:lnTo>
                      <a:cubicBezTo>
                        <a:pt x="717133" y="142334"/>
                        <a:pt x="720028" y="142839"/>
                        <a:pt x="722948" y="142875"/>
                      </a:cubicBezTo>
                      <a:lnTo>
                        <a:pt x="724853" y="142875"/>
                      </a:lnTo>
                      <a:cubicBezTo>
                        <a:pt x="740108" y="142875"/>
                        <a:pt x="752475" y="130508"/>
                        <a:pt x="752475" y="115253"/>
                      </a:cubicBezTo>
                      <a:lnTo>
                        <a:pt x="752475" y="95250"/>
                      </a:lnTo>
                      <a:lnTo>
                        <a:pt x="771525" y="95250"/>
                      </a:lnTo>
                      <a:cubicBezTo>
                        <a:pt x="776786" y="95250"/>
                        <a:pt x="781050" y="90986"/>
                        <a:pt x="781050" y="85725"/>
                      </a:cubicBezTo>
                      <a:cubicBezTo>
                        <a:pt x="781050" y="80464"/>
                        <a:pt x="776786" y="76200"/>
                        <a:pt x="771525" y="76200"/>
                      </a:cubicBezTo>
                      <a:close/>
                      <a:moveTo>
                        <a:pt x="58103" y="123825"/>
                      </a:moveTo>
                      <a:lnTo>
                        <a:pt x="56197" y="123825"/>
                      </a:lnTo>
                      <a:cubicBezTo>
                        <a:pt x="51463" y="123825"/>
                        <a:pt x="47625" y="119987"/>
                        <a:pt x="47625" y="115253"/>
                      </a:cubicBezTo>
                      <a:lnTo>
                        <a:pt x="47625" y="56197"/>
                      </a:lnTo>
                      <a:cubicBezTo>
                        <a:pt x="47625" y="51463"/>
                        <a:pt x="51463" y="47625"/>
                        <a:pt x="56197" y="47625"/>
                      </a:cubicBezTo>
                      <a:lnTo>
                        <a:pt x="58103" y="47625"/>
                      </a:lnTo>
                      <a:cubicBezTo>
                        <a:pt x="62837" y="47625"/>
                        <a:pt x="66675" y="51463"/>
                        <a:pt x="66675" y="56197"/>
                      </a:cubicBezTo>
                      <a:lnTo>
                        <a:pt x="66675" y="115253"/>
                      </a:lnTo>
                      <a:cubicBezTo>
                        <a:pt x="66675" y="119987"/>
                        <a:pt x="62837" y="123825"/>
                        <a:pt x="58103" y="123825"/>
                      </a:cubicBezTo>
                      <a:close/>
                      <a:moveTo>
                        <a:pt x="104775" y="143828"/>
                      </a:moveTo>
                      <a:cubicBezTo>
                        <a:pt x="104775" y="148562"/>
                        <a:pt x="100937" y="152400"/>
                        <a:pt x="96203" y="152400"/>
                      </a:cubicBezTo>
                      <a:lnTo>
                        <a:pt x="94298" y="152400"/>
                      </a:lnTo>
                      <a:cubicBezTo>
                        <a:pt x="89563" y="152400"/>
                        <a:pt x="85725" y="148562"/>
                        <a:pt x="85725" y="143828"/>
                      </a:cubicBezTo>
                      <a:lnTo>
                        <a:pt x="85725" y="27622"/>
                      </a:lnTo>
                      <a:cubicBezTo>
                        <a:pt x="85725" y="22888"/>
                        <a:pt x="89563" y="19050"/>
                        <a:pt x="94298" y="19050"/>
                      </a:cubicBezTo>
                      <a:lnTo>
                        <a:pt x="96203" y="19050"/>
                      </a:lnTo>
                      <a:cubicBezTo>
                        <a:pt x="100937" y="19050"/>
                        <a:pt x="104775" y="22888"/>
                        <a:pt x="104775" y="27622"/>
                      </a:cubicBezTo>
                      <a:close/>
                      <a:moveTo>
                        <a:pt x="528904" y="95250"/>
                      </a:moveTo>
                      <a:lnTo>
                        <a:pt x="528904" y="226352"/>
                      </a:lnTo>
                      <a:lnTo>
                        <a:pt x="421272" y="289674"/>
                      </a:lnTo>
                      <a:lnTo>
                        <a:pt x="359769" y="289674"/>
                      </a:lnTo>
                      <a:lnTo>
                        <a:pt x="252193" y="226352"/>
                      </a:lnTo>
                      <a:lnTo>
                        <a:pt x="252193" y="95250"/>
                      </a:lnTo>
                      <a:close/>
                      <a:moveTo>
                        <a:pt x="593322" y="567299"/>
                      </a:moveTo>
                      <a:lnTo>
                        <a:pt x="593322" y="723900"/>
                      </a:lnTo>
                      <a:lnTo>
                        <a:pt x="547954" y="723900"/>
                      </a:lnTo>
                      <a:lnTo>
                        <a:pt x="547954" y="582273"/>
                      </a:lnTo>
                      <a:lnTo>
                        <a:pt x="467316" y="530038"/>
                      </a:lnTo>
                      <a:lnTo>
                        <a:pt x="313782" y="530038"/>
                      </a:lnTo>
                      <a:lnTo>
                        <a:pt x="233143" y="582273"/>
                      </a:lnTo>
                      <a:lnTo>
                        <a:pt x="233143" y="723900"/>
                      </a:lnTo>
                      <a:lnTo>
                        <a:pt x="187776" y="723900"/>
                      </a:lnTo>
                      <a:lnTo>
                        <a:pt x="187776" y="567299"/>
                      </a:lnTo>
                      <a:cubicBezTo>
                        <a:pt x="187764" y="557975"/>
                        <a:pt x="192494" y="549284"/>
                        <a:pt x="200330" y="544230"/>
                      </a:cubicBezTo>
                      <a:lnTo>
                        <a:pt x="328917" y="460981"/>
                      </a:lnTo>
                      <a:lnTo>
                        <a:pt x="452161" y="460981"/>
                      </a:lnTo>
                      <a:lnTo>
                        <a:pt x="580749" y="544230"/>
                      </a:lnTo>
                      <a:cubicBezTo>
                        <a:pt x="588597" y="549274"/>
                        <a:pt x="593336" y="557970"/>
                        <a:pt x="593322" y="567299"/>
                      </a:cubicBezTo>
                      <a:close/>
                      <a:moveTo>
                        <a:pt x="457248" y="441960"/>
                      </a:moveTo>
                      <a:lnTo>
                        <a:pt x="323850" y="441960"/>
                      </a:lnTo>
                      <a:lnTo>
                        <a:pt x="323850" y="362502"/>
                      </a:lnTo>
                      <a:cubicBezTo>
                        <a:pt x="327561" y="358826"/>
                        <a:pt x="327589" y="352837"/>
                        <a:pt x="323912" y="349127"/>
                      </a:cubicBezTo>
                      <a:cubicBezTo>
                        <a:pt x="323326" y="348535"/>
                        <a:pt x="322665" y="348024"/>
                        <a:pt x="321945" y="347605"/>
                      </a:cubicBezTo>
                      <a:lnTo>
                        <a:pt x="201492" y="276616"/>
                      </a:lnTo>
                      <a:cubicBezTo>
                        <a:pt x="193057" y="271719"/>
                        <a:pt x="187841" y="262727"/>
                        <a:pt x="187776" y="252974"/>
                      </a:cubicBezTo>
                      <a:lnTo>
                        <a:pt x="187776" y="95250"/>
                      </a:lnTo>
                      <a:lnTo>
                        <a:pt x="233143" y="95250"/>
                      </a:lnTo>
                      <a:lnTo>
                        <a:pt x="233143" y="237249"/>
                      </a:lnTo>
                      <a:lnTo>
                        <a:pt x="354587" y="308686"/>
                      </a:lnTo>
                      <a:lnTo>
                        <a:pt x="426501" y="308686"/>
                      </a:lnTo>
                      <a:lnTo>
                        <a:pt x="547954" y="237249"/>
                      </a:lnTo>
                      <a:lnTo>
                        <a:pt x="547954" y="95250"/>
                      </a:lnTo>
                      <a:lnTo>
                        <a:pt x="593322" y="95250"/>
                      </a:lnTo>
                      <a:lnTo>
                        <a:pt x="593322" y="252936"/>
                      </a:lnTo>
                      <a:cubicBezTo>
                        <a:pt x="593256" y="262731"/>
                        <a:pt x="588009" y="271759"/>
                        <a:pt x="579530" y="276663"/>
                      </a:cubicBezTo>
                      <a:lnTo>
                        <a:pt x="459372" y="347491"/>
                      </a:lnTo>
                      <a:cubicBezTo>
                        <a:pt x="454841" y="350161"/>
                        <a:pt x="453331" y="355999"/>
                        <a:pt x="456000" y="360531"/>
                      </a:cubicBezTo>
                      <a:cubicBezTo>
                        <a:pt x="456368" y="361036"/>
                        <a:pt x="456786" y="361501"/>
                        <a:pt x="457248" y="361921"/>
                      </a:cubicBezTo>
                      <a:close/>
                      <a:moveTo>
                        <a:pt x="695325" y="143828"/>
                      </a:moveTo>
                      <a:cubicBezTo>
                        <a:pt x="695325" y="148562"/>
                        <a:pt x="691487" y="152400"/>
                        <a:pt x="686753" y="152400"/>
                      </a:cubicBezTo>
                      <a:lnTo>
                        <a:pt x="684848" y="152400"/>
                      </a:lnTo>
                      <a:cubicBezTo>
                        <a:pt x="680113" y="152400"/>
                        <a:pt x="676275" y="148562"/>
                        <a:pt x="676275" y="143828"/>
                      </a:cubicBezTo>
                      <a:lnTo>
                        <a:pt x="676275" y="27622"/>
                      </a:lnTo>
                      <a:cubicBezTo>
                        <a:pt x="676275" y="22888"/>
                        <a:pt x="680113" y="19050"/>
                        <a:pt x="684848" y="19050"/>
                      </a:cubicBezTo>
                      <a:lnTo>
                        <a:pt x="686753" y="19050"/>
                      </a:lnTo>
                      <a:cubicBezTo>
                        <a:pt x="691487" y="19050"/>
                        <a:pt x="695325" y="22888"/>
                        <a:pt x="695325" y="27622"/>
                      </a:cubicBezTo>
                      <a:lnTo>
                        <a:pt x="695325" y="143828"/>
                      </a:lnTo>
                      <a:close/>
                      <a:moveTo>
                        <a:pt x="733425" y="115253"/>
                      </a:moveTo>
                      <a:cubicBezTo>
                        <a:pt x="733425" y="119987"/>
                        <a:pt x="729587" y="123825"/>
                        <a:pt x="724853" y="123825"/>
                      </a:cubicBezTo>
                      <a:lnTo>
                        <a:pt x="722948" y="123825"/>
                      </a:lnTo>
                      <a:cubicBezTo>
                        <a:pt x="718213" y="123825"/>
                        <a:pt x="714375" y="119987"/>
                        <a:pt x="714375" y="115253"/>
                      </a:cubicBezTo>
                      <a:lnTo>
                        <a:pt x="714375" y="56197"/>
                      </a:lnTo>
                      <a:cubicBezTo>
                        <a:pt x="714375" y="51463"/>
                        <a:pt x="718213" y="47625"/>
                        <a:pt x="722948" y="47625"/>
                      </a:cubicBezTo>
                      <a:lnTo>
                        <a:pt x="724853" y="47625"/>
                      </a:lnTo>
                      <a:cubicBezTo>
                        <a:pt x="729587" y="47625"/>
                        <a:pt x="733425" y="51463"/>
                        <a:pt x="733425" y="56197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6350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 dirty="0"/>
                </a:p>
              </p:txBody>
            </p:sp>
          </p:grpSp>
          <p:pic>
            <p:nvPicPr>
              <p:cNvPr id="144" name="Graphic 143" descr="Run outline">
                <a:extLst>
                  <a:ext uri="{FF2B5EF4-FFF2-40B4-BE49-F238E27FC236}">
                    <a16:creationId xmlns:a16="http://schemas.microsoft.com/office/drawing/2014/main" id="{5AF23359-B849-A0C0-1A4D-79F64FBF6CE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96DAC541-7B7A-43D3-8B79-37D633B846F1}">
                    <asvg:svgBlip xmlns:asvg="http://schemas.microsoft.com/office/drawing/2016/SVG/main" r:embed="rId15"/>
                  </a:ext>
                </a:extLst>
              </a:blip>
              <a:stretch>
                <a:fillRect/>
              </a:stretch>
            </p:blipFill>
            <p:spPr>
              <a:xfrm>
                <a:off x="9507991" y="3238745"/>
                <a:ext cx="457200" cy="457199"/>
              </a:xfrm>
              <a:prstGeom prst="rect">
                <a:avLst/>
              </a:prstGeom>
            </p:spPr>
          </p:pic>
          <p:pic>
            <p:nvPicPr>
              <p:cNvPr id="145" name="Graphic 144" descr="Cycling outline">
                <a:extLst>
                  <a:ext uri="{FF2B5EF4-FFF2-40B4-BE49-F238E27FC236}">
                    <a16:creationId xmlns:a16="http://schemas.microsoft.com/office/drawing/2014/main" id="{F8405E5E-44A5-7D07-8019-64FC09984A9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96DAC541-7B7A-43D3-8B79-37D633B846F1}">
                    <asvg:svgBlip xmlns:asvg="http://schemas.microsoft.com/office/drawing/2016/SVG/main" r:embed="rId17"/>
                  </a:ext>
                </a:extLst>
              </a:blip>
              <a:stretch>
                <a:fillRect/>
              </a:stretch>
            </p:blipFill>
            <p:spPr>
              <a:xfrm>
                <a:off x="9513072" y="3986115"/>
                <a:ext cx="490460" cy="490461"/>
              </a:xfrm>
              <a:prstGeom prst="rect">
                <a:avLst/>
              </a:prstGeom>
            </p:spPr>
          </p:pic>
          <p:pic>
            <p:nvPicPr>
              <p:cNvPr id="146" name="Graphic 145" descr="Tennis outline">
                <a:extLst>
                  <a:ext uri="{FF2B5EF4-FFF2-40B4-BE49-F238E27FC236}">
                    <a16:creationId xmlns:a16="http://schemas.microsoft.com/office/drawing/2014/main" id="{47297E80-5CD2-085C-613A-9A57CE1065E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96DAC541-7B7A-43D3-8B79-37D633B846F1}">
                    <asvg:svgBlip xmlns:asvg="http://schemas.microsoft.com/office/drawing/2016/SVG/main" r:embed="rId19"/>
                  </a:ext>
                </a:extLst>
              </a:blip>
              <a:stretch>
                <a:fillRect/>
              </a:stretch>
            </p:blipFill>
            <p:spPr>
              <a:xfrm>
                <a:off x="9172156" y="4043245"/>
                <a:ext cx="457201" cy="457200"/>
              </a:xfrm>
              <a:prstGeom prst="rect">
                <a:avLst/>
              </a:prstGeom>
            </p:spPr>
          </p:pic>
        </p:grp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1AFFB1E4-BEDA-F1CC-15FE-711492F68CD9}"/>
              </a:ext>
            </a:extLst>
          </p:cNvPr>
          <p:cNvSpPr txBox="1"/>
          <p:nvPr/>
        </p:nvSpPr>
        <p:spPr>
          <a:xfrm>
            <a:off x="3589818" y="4364515"/>
            <a:ext cx="3897737" cy="338554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>
            <a:solidFill>
              <a:schemeClr val="tx2">
                <a:lumMod val="90000"/>
                <a:lumOff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</a:rPr>
              <a:t>Outcome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CEF5EC-D23C-0082-49ED-51CBC2BC8D7C}"/>
              </a:ext>
            </a:extLst>
          </p:cNvPr>
          <p:cNvSpPr txBox="1"/>
          <p:nvPr/>
        </p:nvSpPr>
        <p:spPr>
          <a:xfrm>
            <a:off x="3586845" y="4757068"/>
            <a:ext cx="1284779" cy="338554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>
            <a:solidFill>
              <a:schemeClr val="tx2">
                <a:lumMod val="90000"/>
                <a:lumOff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</a:rPr>
              <a:t>Primary</a:t>
            </a:r>
            <a:endParaRPr lang="en-US" sz="1600" dirty="0"/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505A36C6-D6D4-B8EA-AC67-31C09A42BB86}"/>
              </a:ext>
            </a:extLst>
          </p:cNvPr>
          <p:cNvGrpSpPr/>
          <p:nvPr/>
        </p:nvGrpSpPr>
        <p:grpSpPr>
          <a:xfrm>
            <a:off x="6308163" y="3371740"/>
            <a:ext cx="662396" cy="668797"/>
            <a:chOff x="4914465" y="4980125"/>
            <a:chExt cx="1284678" cy="1256291"/>
          </a:xfrm>
        </p:grpSpPr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BC774F9C-8813-9834-3543-64DEFEF93D0F}"/>
                </a:ext>
              </a:extLst>
            </p:cNvPr>
            <p:cNvSpPr/>
            <p:nvPr/>
          </p:nvSpPr>
          <p:spPr>
            <a:xfrm>
              <a:off x="4914465" y="4980125"/>
              <a:ext cx="1284678" cy="1256291"/>
            </a:xfrm>
            <a:prstGeom prst="ellipse">
              <a:avLst/>
            </a:prstGeom>
            <a:solidFill>
              <a:schemeClr val="tx2">
                <a:lumMod val="90000"/>
                <a:lumOff val="10000"/>
              </a:schemeClr>
            </a:solidFill>
            <a:ln>
              <a:solidFill>
                <a:schemeClr val="tx2">
                  <a:lumMod val="90000"/>
                  <a:lumOff val="10000"/>
                </a:schemeClr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2321282A-FEAD-261C-21ED-A895FC1B1F84}"/>
                </a:ext>
              </a:extLst>
            </p:cNvPr>
            <p:cNvGrpSpPr/>
            <p:nvPr/>
          </p:nvGrpSpPr>
          <p:grpSpPr>
            <a:xfrm>
              <a:off x="5011940" y="5033536"/>
              <a:ext cx="1110845" cy="1114496"/>
              <a:chOff x="8914041" y="3222562"/>
              <a:chExt cx="1229018" cy="1277883"/>
            </a:xfrm>
          </p:grpSpPr>
          <p:pic>
            <p:nvPicPr>
              <p:cNvPr id="22" name="Graphic 21" descr="Grocery bag with solid fill">
                <a:extLst>
                  <a:ext uri="{FF2B5EF4-FFF2-40B4-BE49-F238E27FC236}">
                    <a16:creationId xmlns:a16="http://schemas.microsoft.com/office/drawing/2014/main" id="{C493053B-4E0E-9E04-4A4D-5710AC105F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96DAC541-7B7A-43D3-8B79-37D633B846F1}">
                    <asvg:svgBlip xmlns:asvg="http://schemas.microsoft.com/office/drawing/2016/SVG/main" r:embed="rId13"/>
                  </a:ext>
                </a:extLst>
              </a:blip>
              <a:stretch>
                <a:fillRect/>
              </a:stretch>
            </p:blipFill>
            <p:spPr>
              <a:xfrm>
                <a:off x="9275488" y="3567979"/>
                <a:ext cx="507159" cy="507160"/>
              </a:xfrm>
              <a:prstGeom prst="rect">
                <a:avLst/>
              </a:prstGeom>
            </p:spPr>
          </p:pic>
          <p:grpSp>
            <p:nvGrpSpPr>
              <p:cNvPr id="23" name="Graphic 13" descr="Swimming outline">
                <a:extLst>
                  <a:ext uri="{FF2B5EF4-FFF2-40B4-BE49-F238E27FC236}">
                    <a16:creationId xmlns:a16="http://schemas.microsoft.com/office/drawing/2014/main" id="{68FCF063-5F66-0BB7-037C-BBC93D132A15}"/>
                  </a:ext>
                </a:extLst>
              </p:cNvPr>
              <p:cNvGrpSpPr/>
              <p:nvPr/>
            </p:nvGrpSpPr>
            <p:grpSpPr>
              <a:xfrm>
                <a:off x="9078305" y="3222562"/>
                <a:ext cx="420722" cy="369332"/>
                <a:chOff x="6033758" y="4148441"/>
                <a:chExt cx="763409" cy="525370"/>
              </a:xfrm>
              <a:solidFill>
                <a:srgbClr val="000000"/>
              </a:solidFill>
            </p:grpSpPr>
            <p:sp>
              <p:nvSpPr>
                <p:cNvPr id="39" name="Freeform: Shape 38">
                  <a:extLst>
                    <a:ext uri="{FF2B5EF4-FFF2-40B4-BE49-F238E27FC236}">
                      <a16:creationId xmlns:a16="http://schemas.microsoft.com/office/drawing/2014/main" id="{E39B2896-915A-86A3-F5A5-F912D7D45839}"/>
                    </a:ext>
                  </a:extLst>
                </p:cNvPr>
                <p:cNvSpPr/>
                <p:nvPr/>
              </p:nvSpPr>
              <p:spPr>
                <a:xfrm>
                  <a:off x="6160184" y="4148441"/>
                  <a:ext cx="493033" cy="397154"/>
                </a:xfrm>
                <a:custGeom>
                  <a:avLst/>
                  <a:gdLst>
                    <a:gd name="connsiteX0" fmla="*/ 241935 w 493033"/>
                    <a:gd name="connsiteY0" fmla="*/ 238792 h 397154"/>
                    <a:gd name="connsiteX1" fmla="*/ 0 w 493033"/>
                    <a:gd name="connsiteY1" fmla="*/ 382248 h 397154"/>
                    <a:gd name="connsiteX2" fmla="*/ 26432 w 493033"/>
                    <a:gd name="connsiteY2" fmla="*/ 388725 h 397154"/>
                    <a:gd name="connsiteX3" fmla="*/ 251670 w 493033"/>
                    <a:gd name="connsiteY3" fmla="*/ 255175 h 397154"/>
                    <a:gd name="connsiteX4" fmla="*/ 267129 w 493033"/>
                    <a:gd name="connsiteY4" fmla="*/ 246012 h 397154"/>
                    <a:gd name="connsiteX5" fmla="*/ 258880 w 493033"/>
                    <a:gd name="connsiteY5" fmla="*/ 230095 h 397154"/>
                    <a:gd name="connsiteX6" fmla="*/ 200625 w 493033"/>
                    <a:gd name="connsiteY6" fmla="*/ 117338 h 397154"/>
                    <a:gd name="connsiteX7" fmla="*/ 200406 w 493033"/>
                    <a:gd name="connsiteY7" fmla="*/ 92935 h 397154"/>
                    <a:gd name="connsiteX8" fmla="*/ 219142 w 493033"/>
                    <a:gd name="connsiteY8" fmla="*/ 77191 h 397154"/>
                    <a:gd name="connsiteX9" fmla="*/ 438217 w 493033"/>
                    <a:gd name="connsiteY9" fmla="*/ 20041 h 397154"/>
                    <a:gd name="connsiteX10" fmla="*/ 445608 w 493033"/>
                    <a:gd name="connsiteY10" fmla="*/ 19088 h 397154"/>
                    <a:gd name="connsiteX11" fmla="*/ 474001 w 493033"/>
                    <a:gd name="connsiteY11" fmla="*/ 48090 h 397154"/>
                    <a:gd name="connsiteX12" fmla="*/ 452447 w 493033"/>
                    <a:gd name="connsiteY12" fmla="*/ 75581 h 397154"/>
                    <a:gd name="connsiteX13" fmla="*/ 291475 w 493033"/>
                    <a:gd name="connsiteY13" fmla="*/ 117491 h 397154"/>
                    <a:gd name="connsiteX14" fmla="*/ 268338 w 493033"/>
                    <a:gd name="connsiteY14" fmla="*/ 123511 h 397154"/>
                    <a:gd name="connsiteX15" fmla="*/ 279368 w 493033"/>
                    <a:gd name="connsiteY15" fmla="*/ 144713 h 397154"/>
                    <a:gd name="connsiteX16" fmla="*/ 406117 w 493033"/>
                    <a:gd name="connsiteY16" fmla="*/ 388210 h 397154"/>
                    <a:gd name="connsiteX17" fmla="*/ 421872 w 493033"/>
                    <a:gd name="connsiteY17" fmla="*/ 393925 h 397154"/>
                    <a:gd name="connsiteX18" fmla="*/ 432254 w 493033"/>
                    <a:gd name="connsiteY18" fmla="*/ 397154 h 397154"/>
                    <a:gd name="connsiteX19" fmla="*/ 296228 w 493033"/>
                    <a:gd name="connsiteY19" fmla="*/ 135893 h 397154"/>
                    <a:gd name="connsiteX20" fmla="*/ 457200 w 493033"/>
                    <a:gd name="connsiteY20" fmla="*/ 93983 h 397154"/>
                    <a:gd name="connsiteX21" fmla="*/ 491508 w 493033"/>
                    <a:gd name="connsiteY21" fmla="*/ 35821 h 397154"/>
                    <a:gd name="connsiteX22" fmla="*/ 445560 w 493033"/>
                    <a:gd name="connsiteY22" fmla="*/ 0 h 397154"/>
                    <a:gd name="connsiteX23" fmla="*/ 433387 w 493033"/>
                    <a:gd name="connsiteY23" fmla="*/ 1562 h 397154"/>
                    <a:gd name="connsiteX24" fmla="*/ 214313 w 493033"/>
                    <a:gd name="connsiteY24" fmla="*/ 58712 h 397154"/>
                    <a:gd name="connsiteX25" fmla="*/ 182880 w 493033"/>
                    <a:gd name="connsiteY25" fmla="*/ 85382 h 397154"/>
                    <a:gd name="connsiteX26" fmla="*/ 183833 w 493033"/>
                    <a:gd name="connsiteY26" fmla="*/ 126340 h 39715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</a:cxnLst>
                  <a:rect l="l" t="t" r="r" b="b"/>
                  <a:pathLst>
                    <a:path w="493033" h="397154">
                      <a:moveTo>
                        <a:pt x="241935" y="238792"/>
                      </a:moveTo>
                      <a:lnTo>
                        <a:pt x="0" y="382248"/>
                      </a:lnTo>
                      <a:cubicBezTo>
                        <a:pt x="8950" y="383794"/>
                        <a:pt x="17781" y="385958"/>
                        <a:pt x="26432" y="388725"/>
                      </a:cubicBezTo>
                      <a:lnTo>
                        <a:pt x="251670" y="255175"/>
                      </a:lnTo>
                      <a:lnTo>
                        <a:pt x="267129" y="246012"/>
                      </a:lnTo>
                      <a:lnTo>
                        <a:pt x="258880" y="230095"/>
                      </a:lnTo>
                      <a:lnTo>
                        <a:pt x="200625" y="117338"/>
                      </a:lnTo>
                      <a:cubicBezTo>
                        <a:pt x="196898" y="109648"/>
                        <a:pt x="196818" y="100692"/>
                        <a:pt x="200406" y="92935"/>
                      </a:cubicBezTo>
                      <a:cubicBezTo>
                        <a:pt x="203850" y="85050"/>
                        <a:pt x="210781" y="79225"/>
                        <a:pt x="219142" y="77191"/>
                      </a:cubicBezTo>
                      <a:lnTo>
                        <a:pt x="438217" y="20041"/>
                      </a:lnTo>
                      <a:cubicBezTo>
                        <a:pt x="440630" y="19415"/>
                        <a:pt x="443114" y="19095"/>
                        <a:pt x="445608" y="19088"/>
                      </a:cubicBezTo>
                      <a:cubicBezTo>
                        <a:pt x="461457" y="19257"/>
                        <a:pt x="474169" y="32241"/>
                        <a:pt x="474001" y="48090"/>
                      </a:cubicBezTo>
                      <a:cubicBezTo>
                        <a:pt x="473863" y="61074"/>
                        <a:pt x="465024" y="72349"/>
                        <a:pt x="452447" y="75581"/>
                      </a:cubicBezTo>
                      <a:lnTo>
                        <a:pt x="291475" y="117491"/>
                      </a:lnTo>
                      <a:lnTo>
                        <a:pt x="268338" y="123511"/>
                      </a:lnTo>
                      <a:lnTo>
                        <a:pt x="279368" y="144713"/>
                      </a:lnTo>
                      <a:lnTo>
                        <a:pt x="406117" y="388210"/>
                      </a:lnTo>
                      <a:cubicBezTo>
                        <a:pt x="411451" y="389906"/>
                        <a:pt x="416700" y="391801"/>
                        <a:pt x="421872" y="393925"/>
                      </a:cubicBezTo>
                      <a:cubicBezTo>
                        <a:pt x="425271" y="395190"/>
                        <a:pt x="428737" y="396268"/>
                        <a:pt x="432254" y="397154"/>
                      </a:cubicBezTo>
                      <a:lnTo>
                        <a:pt x="296228" y="135893"/>
                      </a:lnTo>
                      <a:lnTo>
                        <a:pt x="457200" y="93983"/>
                      </a:lnTo>
                      <a:cubicBezTo>
                        <a:pt x="482735" y="87396"/>
                        <a:pt x="498096" y="61356"/>
                        <a:pt x="491508" y="35821"/>
                      </a:cubicBezTo>
                      <a:cubicBezTo>
                        <a:pt x="486095" y="14837"/>
                        <a:pt x="467231" y="130"/>
                        <a:pt x="445560" y="0"/>
                      </a:cubicBezTo>
                      <a:cubicBezTo>
                        <a:pt x="441453" y="3"/>
                        <a:pt x="437362" y="528"/>
                        <a:pt x="433387" y="1562"/>
                      </a:cubicBezTo>
                      <a:lnTo>
                        <a:pt x="214313" y="58712"/>
                      </a:lnTo>
                      <a:cubicBezTo>
                        <a:pt x="200259" y="62234"/>
                        <a:pt x="188643" y="72090"/>
                        <a:pt x="182880" y="85382"/>
                      </a:cubicBezTo>
                      <a:cubicBezTo>
                        <a:pt x="176984" y="98475"/>
                        <a:pt x="177335" y="113534"/>
                        <a:pt x="183833" y="12634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40" name="Freeform: Shape 39">
                  <a:extLst>
                    <a:ext uri="{FF2B5EF4-FFF2-40B4-BE49-F238E27FC236}">
                      <a16:creationId xmlns:a16="http://schemas.microsoft.com/office/drawing/2014/main" id="{FB6ED542-05DD-817C-707B-9458F5B461A7}"/>
                    </a:ext>
                  </a:extLst>
                </p:cNvPr>
                <p:cNvSpPr/>
                <p:nvPr/>
              </p:nvSpPr>
              <p:spPr>
                <a:xfrm>
                  <a:off x="6033758" y="4555882"/>
                  <a:ext cx="763409" cy="40052"/>
                </a:xfrm>
                <a:custGeom>
                  <a:avLst/>
                  <a:gdLst>
                    <a:gd name="connsiteX0" fmla="*/ 572195 w 763409"/>
                    <a:gd name="connsiteY0" fmla="*/ 40024 h 40052"/>
                    <a:gd name="connsiteX1" fmla="*/ 571519 w 763409"/>
                    <a:gd name="connsiteY1" fmla="*/ 40024 h 40052"/>
                    <a:gd name="connsiteX2" fmla="*/ 530676 w 763409"/>
                    <a:gd name="connsiteY2" fmla="*/ 30851 h 40052"/>
                    <a:gd name="connsiteX3" fmla="*/ 476488 w 763409"/>
                    <a:gd name="connsiteY3" fmla="*/ 19079 h 40052"/>
                    <a:gd name="connsiteX4" fmla="*/ 423491 w 763409"/>
                    <a:gd name="connsiteY4" fmla="*/ 30737 h 40052"/>
                    <a:gd name="connsiteX5" fmla="*/ 382362 w 763409"/>
                    <a:gd name="connsiteY5" fmla="*/ 40024 h 40052"/>
                    <a:gd name="connsiteX6" fmla="*/ 381686 w 763409"/>
                    <a:gd name="connsiteY6" fmla="*/ 40024 h 40052"/>
                    <a:gd name="connsiteX7" fmla="*/ 381010 w 763409"/>
                    <a:gd name="connsiteY7" fmla="*/ 40024 h 40052"/>
                    <a:gd name="connsiteX8" fmla="*/ 340166 w 763409"/>
                    <a:gd name="connsiteY8" fmla="*/ 30851 h 40052"/>
                    <a:gd name="connsiteX9" fmla="*/ 285979 w 763409"/>
                    <a:gd name="connsiteY9" fmla="*/ 19079 h 40052"/>
                    <a:gd name="connsiteX10" fmla="*/ 232982 w 763409"/>
                    <a:gd name="connsiteY10" fmla="*/ 30737 h 40052"/>
                    <a:gd name="connsiteX11" fmla="*/ 191853 w 763409"/>
                    <a:gd name="connsiteY11" fmla="*/ 40024 h 40052"/>
                    <a:gd name="connsiteX12" fmla="*/ 191176 w 763409"/>
                    <a:gd name="connsiteY12" fmla="*/ 40024 h 40052"/>
                    <a:gd name="connsiteX13" fmla="*/ 190500 w 763409"/>
                    <a:gd name="connsiteY13" fmla="*/ 40024 h 40052"/>
                    <a:gd name="connsiteX14" fmla="*/ 149657 w 763409"/>
                    <a:gd name="connsiteY14" fmla="*/ 30851 h 40052"/>
                    <a:gd name="connsiteX15" fmla="*/ 95469 w 763409"/>
                    <a:gd name="connsiteY15" fmla="*/ 19079 h 40052"/>
                    <a:gd name="connsiteX16" fmla="*/ 42472 w 763409"/>
                    <a:gd name="connsiteY16" fmla="*/ 30737 h 40052"/>
                    <a:gd name="connsiteX17" fmla="*/ 1343 w 763409"/>
                    <a:gd name="connsiteY17" fmla="*/ 40024 h 40052"/>
                    <a:gd name="connsiteX18" fmla="*/ 0 w 763409"/>
                    <a:gd name="connsiteY18" fmla="*/ 20974 h 40052"/>
                    <a:gd name="connsiteX19" fmla="*/ 35357 w 763409"/>
                    <a:gd name="connsiteY19" fmla="*/ 13021 h 40052"/>
                    <a:gd name="connsiteX20" fmla="*/ 95469 w 763409"/>
                    <a:gd name="connsiteY20" fmla="*/ 0 h 40052"/>
                    <a:gd name="connsiteX21" fmla="*/ 156801 w 763409"/>
                    <a:gd name="connsiteY21" fmla="*/ 13154 h 40052"/>
                    <a:gd name="connsiteX22" fmla="*/ 191195 w 763409"/>
                    <a:gd name="connsiteY22" fmla="*/ 20926 h 40052"/>
                    <a:gd name="connsiteX23" fmla="*/ 225885 w 763409"/>
                    <a:gd name="connsiteY23" fmla="*/ 13021 h 40052"/>
                    <a:gd name="connsiteX24" fmla="*/ 285998 w 763409"/>
                    <a:gd name="connsiteY24" fmla="*/ 0 h 40052"/>
                    <a:gd name="connsiteX25" fmla="*/ 347310 w 763409"/>
                    <a:gd name="connsiteY25" fmla="*/ 13154 h 40052"/>
                    <a:gd name="connsiteX26" fmla="*/ 381695 w 763409"/>
                    <a:gd name="connsiteY26" fmla="*/ 20926 h 40052"/>
                    <a:gd name="connsiteX27" fmla="*/ 416385 w 763409"/>
                    <a:gd name="connsiteY27" fmla="*/ 13021 h 40052"/>
                    <a:gd name="connsiteX28" fmla="*/ 476498 w 763409"/>
                    <a:gd name="connsiteY28" fmla="*/ 0 h 40052"/>
                    <a:gd name="connsiteX29" fmla="*/ 537820 w 763409"/>
                    <a:gd name="connsiteY29" fmla="*/ 13154 h 40052"/>
                    <a:gd name="connsiteX30" fmla="*/ 572195 w 763409"/>
                    <a:gd name="connsiteY30" fmla="*/ 20926 h 40052"/>
                    <a:gd name="connsiteX31" fmla="*/ 606885 w 763409"/>
                    <a:gd name="connsiteY31" fmla="*/ 13021 h 40052"/>
                    <a:gd name="connsiteX32" fmla="*/ 666998 w 763409"/>
                    <a:gd name="connsiteY32" fmla="*/ 0 h 40052"/>
                    <a:gd name="connsiteX33" fmla="*/ 728329 w 763409"/>
                    <a:gd name="connsiteY33" fmla="*/ 13154 h 40052"/>
                    <a:gd name="connsiteX34" fmla="*/ 763410 w 763409"/>
                    <a:gd name="connsiteY34" fmla="*/ 21003 h 40052"/>
                    <a:gd name="connsiteX35" fmla="*/ 762057 w 763409"/>
                    <a:gd name="connsiteY35" fmla="*/ 40053 h 40052"/>
                    <a:gd name="connsiteX36" fmla="*/ 721214 w 763409"/>
                    <a:gd name="connsiteY36" fmla="*/ 30880 h 40052"/>
                    <a:gd name="connsiteX37" fmla="*/ 667026 w 763409"/>
                    <a:gd name="connsiteY37" fmla="*/ 19107 h 40052"/>
                    <a:gd name="connsiteX38" fmla="*/ 614029 w 763409"/>
                    <a:gd name="connsiteY38" fmla="*/ 30766 h 40052"/>
                    <a:gd name="connsiteX39" fmla="*/ 572900 w 763409"/>
                    <a:gd name="connsiteY39" fmla="*/ 40053 h 4005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763409" h="40052">
                      <a:moveTo>
                        <a:pt x="572195" y="40024"/>
                      </a:moveTo>
                      <a:lnTo>
                        <a:pt x="571519" y="40024"/>
                      </a:lnTo>
                      <a:cubicBezTo>
                        <a:pt x="557522" y="39031"/>
                        <a:pt x="543754" y="35939"/>
                        <a:pt x="530676" y="30851"/>
                      </a:cubicBezTo>
                      <a:cubicBezTo>
                        <a:pt x="513463" y="23717"/>
                        <a:pt x="495110" y="19730"/>
                        <a:pt x="476488" y="19079"/>
                      </a:cubicBezTo>
                      <a:cubicBezTo>
                        <a:pt x="458273" y="19813"/>
                        <a:pt x="440332" y="23760"/>
                        <a:pt x="423491" y="30737"/>
                      </a:cubicBezTo>
                      <a:cubicBezTo>
                        <a:pt x="410327" y="35885"/>
                        <a:pt x="396461" y="39015"/>
                        <a:pt x="382362" y="40024"/>
                      </a:cubicBezTo>
                      <a:lnTo>
                        <a:pt x="381686" y="40024"/>
                      </a:lnTo>
                      <a:lnTo>
                        <a:pt x="381010" y="40024"/>
                      </a:lnTo>
                      <a:cubicBezTo>
                        <a:pt x="367013" y="39031"/>
                        <a:pt x="353244" y="35939"/>
                        <a:pt x="340166" y="30851"/>
                      </a:cubicBezTo>
                      <a:cubicBezTo>
                        <a:pt x="322954" y="23717"/>
                        <a:pt x="304600" y="19730"/>
                        <a:pt x="285979" y="19079"/>
                      </a:cubicBezTo>
                      <a:cubicBezTo>
                        <a:pt x="267764" y="19813"/>
                        <a:pt x="249823" y="23760"/>
                        <a:pt x="232982" y="30737"/>
                      </a:cubicBezTo>
                      <a:cubicBezTo>
                        <a:pt x="219817" y="35885"/>
                        <a:pt x="205951" y="39015"/>
                        <a:pt x="191853" y="40024"/>
                      </a:cubicBezTo>
                      <a:lnTo>
                        <a:pt x="191176" y="40024"/>
                      </a:lnTo>
                      <a:lnTo>
                        <a:pt x="190500" y="40024"/>
                      </a:lnTo>
                      <a:cubicBezTo>
                        <a:pt x="176503" y="39031"/>
                        <a:pt x="162735" y="35939"/>
                        <a:pt x="149657" y="30851"/>
                      </a:cubicBezTo>
                      <a:cubicBezTo>
                        <a:pt x="132444" y="23717"/>
                        <a:pt x="114090" y="19730"/>
                        <a:pt x="95469" y="19079"/>
                      </a:cubicBezTo>
                      <a:cubicBezTo>
                        <a:pt x="77254" y="19813"/>
                        <a:pt x="59313" y="23760"/>
                        <a:pt x="42472" y="30737"/>
                      </a:cubicBezTo>
                      <a:cubicBezTo>
                        <a:pt x="29307" y="35885"/>
                        <a:pt x="15442" y="39015"/>
                        <a:pt x="1343" y="40024"/>
                      </a:cubicBezTo>
                      <a:lnTo>
                        <a:pt x="0" y="20974"/>
                      </a:lnTo>
                      <a:cubicBezTo>
                        <a:pt x="12118" y="20110"/>
                        <a:pt x="24036" y="17429"/>
                        <a:pt x="35357" y="13021"/>
                      </a:cubicBezTo>
                      <a:cubicBezTo>
                        <a:pt x="54461" y="5142"/>
                        <a:pt x="74817" y="732"/>
                        <a:pt x="95469" y="0"/>
                      </a:cubicBezTo>
                      <a:cubicBezTo>
                        <a:pt x="116538" y="656"/>
                        <a:pt x="137315" y="5112"/>
                        <a:pt x="156801" y="13154"/>
                      </a:cubicBezTo>
                      <a:cubicBezTo>
                        <a:pt x="167824" y="17411"/>
                        <a:pt x="179412" y="20029"/>
                        <a:pt x="191195" y="20926"/>
                      </a:cubicBezTo>
                      <a:cubicBezTo>
                        <a:pt x="203083" y="20006"/>
                        <a:pt x="214773" y="17342"/>
                        <a:pt x="225885" y="13021"/>
                      </a:cubicBezTo>
                      <a:cubicBezTo>
                        <a:pt x="244990" y="5142"/>
                        <a:pt x="265346" y="732"/>
                        <a:pt x="285998" y="0"/>
                      </a:cubicBezTo>
                      <a:cubicBezTo>
                        <a:pt x="307060" y="658"/>
                        <a:pt x="327831" y="5114"/>
                        <a:pt x="347310" y="13154"/>
                      </a:cubicBezTo>
                      <a:cubicBezTo>
                        <a:pt x="358331" y="17410"/>
                        <a:pt x="369916" y="20028"/>
                        <a:pt x="381695" y="20926"/>
                      </a:cubicBezTo>
                      <a:cubicBezTo>
                        <a:pt x="393583" y="20006"/>
                        <a:pt x="405273" y="17342"/>
                        <a:pt x="416385" y="13021"/>
                      </a:cubicBezTo>
                      <a:cubicBezTo>
                        <a:pt x="435490" y="5142"/>
                        <a:pt x="455846" y="732"/>
                        <a:pt x="476498" y="0"/>
                      </a:cubicBezTo>
                      <a:cubicBezTo>
                        <a:pt x="497563" y="657"/>
                        <a:pt x="518337" y="5113"/>
                        <a:pt x="537820" y="13154"/>
                      </a:cubicBezTo>
                      <a:cubicBezTo>
                        <a:pt x="548837" y="17409"/>
                        <a:pt x="560419" y="20027"/>
                        <a:pt x="572195" y="20926"/>
                      </a:cubicBezTo>
                      <a:cubicBezTo>
                        <a:pt x="584084" y="20006"/>
                        <a:pt x="595773" y="17342"/>
                        <a:pt x="606885" y="13021"/>
                      </a:cubicBezTo>
                      <a:cubicBezTo>
                        <a:pt x="625990" y="5142"/>
                        <a:pt x="646346" y="732"/>
                        <a:pt x="666998" y="0"/>
                      </a:cubicBezTo>
                      <a:cubicBezTo>
                        <a:pt x="688067" y="656"/>
                        <a:pt x="708844" y="5112"/>
                        <a:pt x="728329" y="13154"/>
                      </a:cubicBezTo>
                      <a:cubicBezTo>
                        <a:pt x="739564" y="17510"/>
                        <a:pt x="751389" y="20156"/>
                        <a:pt x="763410" y="21003"/>
                      </a:cubicBezTo>
                      <a:lnTo>
                        <a:pt x="762057" y="40053"/>
                      </a:lnTo>
                      <a:cubicBezTo>
                        <a:pt x="748060" y="39059"/>
                        <a:pt x="734292" y="35967"/>
                        <a:pt x="721214" y="30880"/>
                      </a:cubicBezTo>
                      <a:cubicBezTo>
                        <a:pt x="704001" y="23746"/>
                        <a:pt x="685648" y="19759"/>
                        <a:pt x="667026" y="19107"/>
                      </a:cubicBezTo>
                      <a:cubicBezTo>
                        <a:pt x="648812" y="19842"/>
                        <a:pt x="630870" y="23789"/>
                        <a:pt x="614029" y="30766"/>
                      </a:cubicBezTo>
                      <a:cubicBezTo>
                        <a:pt x="600865" y="35913"/>
                        <a:pt x="586999" y="39044"/>
                        <a:pt x="572900" y="40053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41" name="Freeform: Shape 40">
                  <a:extLst>
                    <a:ext uri="{FF2B5EF4-FFF2-40B4-BE49-F238E27FC236}">
                      <a16:creationId xmlns:a16="http://schemas.microsoft.com/office/drawing/2014/main" id="{FF6DCED4-3A55-2B2E-D917-07496DC74A72}"/>
                    </a:ext>
                  </a:extLst>
                </p:cNvPr>
                <p:cNvSpPr/>
                <p:nvPr/>
              </p:nvSpPr>
              <p:spPr>
                <a:xfrm>
                  <a:off x="6033787" y="4633807"/>
                  <a:ext cx="763381" cy="40004"/>
                </a:xfrm>
                <a:custGeom>
                  <a:avLst/>
                  <a:gdLst>
                    <a:gd name="connsiteX0" fmla="*/ 572167 w 763381"/>
                    <a:gd name="connsiteY0" fmla="*/ 40005 h 40004"/>
                    <a:gd name="connsiteX1" fmla="*/ 571491 w 763381"/>
                    <a:gd name="connsiteY1" fmla="*/ 39948 h 40004"/>
                    <a:gd name="connsiteX2" fmla="*/ 530647 w 763381"/>
                    <a:gd name="connsiteY2" fmla="*/ 30775 h 40004"/>
                    <a:gd name="connsiteX3" fmla="*/ 476488 w 763381"/>
                    <a:gd name="connsiteY3" fmla="*/ 19050 h 40004"/>
                    <a:gd name="connsiteX4" fmla="*/ 423491 w 763381"/>
                    <a:gd name="connsiteY4" fmla="*/ 30709 h 40004"/>
                    <a:gd name="connsiteX5" fmla="*/ 382362 w 763381"/>
                    <a:gd name="connsiteY5" fmla="*/ 39986 h 40004"/>
                    <a:gd name="connsiteX6" fmla="*/ 381667 w 763381"/>
                    <a:gd name="connsiteY6" fmla="*/ 40005 h 40004"/>
                    <a:gd name="connsiteX7" fmla="*/ 380991 w 763381"/>
                    <a:gd name="connsiteY7" fmla="*/ 39948 h 40004"/>
                    <a:gd name="connsiteX8" fmla="*/ 340147 w 763381"/>
                    <a:gd name="connsiteY8" fmla="*/ 30775 h 40004"/>
                    <a:gd name="connsiteX9" fmla="*/ 285979 w 763381"/>
                    <a:gd name="connsiteY9" fmla="*/ 19050 h 40004"/>
                    <a:gd name="connsiteX10" fmla="*/ 232982 w 763381"/>
                    <a:gd name="connsiteY10" fmla="*/ 30709 h 40004"/>
                    <a:gd name="connsiteX11" fmla="*/ 191853 w 763381"/>
                    <a:gd name="connsiteY11" fmla="*/ 39986 h 40004"/>
                    <a:gd name="connsiteX12" fmla="*/ 191167 w 763381"/>
                    <a:gd name="connsiteY12" fmla="*/ 40005 h 40004"/>
                    <a:gd name="connsiteX13" fmla="*/ 190500 w 763381"/>
                    <a:gd name="connsiteY13" fmla="*/ 40005 h 40004"/>
                    <a:gd name="connsiteX14" fmla="*/ 149657 w 763381"/>
                    <a:gd name="connsiteY14" fmla="*/ 30832 h 40004"/>
                    <a:gd name="connsiteX15" fmla="*/ 95469 w 763381"/>
                    <a:gd name="connsiteY15" fmla="*/ 19050 h 40004"/>
                    <a:gd name="connsiteX16" fmla="*/ 42472 w 763381"/>
                    <a:gd name="connsiteY16" fmla="*/ 30709 h 40004"/>
                    <a:gd name="connsiteX17" fmla="*/ 1343 w 763381"/>
                    <a:gd name="connsiteY17" fmla="*/ 39986 h 40004"/>
                    <a:gd name="connsiteX18" fmla="*/ 0 w 763381"/>
                    <a:gd name="connsiteY18" fmla="*/ 20955 h 40004"/>
                    <a:gd name="connsiteX19" fmla="*/ 35357 w 763381"/>
                    <a:gd name="connsiteY19" fmla="*/ 12992 h 40004"/>
                    <a:gd name="connsiteX20" fmla="*/ 95469 w 763381"/>
                    <a:gd name="connsiteY20" fmla="*/ 0 h 40004"/>
                    <a:gd name="connsiteX21" fmla="*/ 156772 w 763381"/>
                    <a:gd name="connsiteY21" fmla="*/ 13125 h 40004"/>
                    <a:gd name="connsiteX22" fmla="*/ 191167 w 763381"/>
                    <a:gd name="connsiteY22" fmla="*/ 20955 h 40004"/>
                    <a:gd name="connsiteX23" fmla="*/ 225857 w 763381"/>
                    <a:gd name="connsiteY23" fmla="*/ 13049 h 40004"/>
                    <a:gd name="connsiteX24" fmla="*/ 285979 w 763381"/>
                    <a:gd name="connsiteY24" fmla="*/ 0 h 40004"/>
                    <a:gd name="connsiteX25" fmla="*/ 347282 w 763381"/>
                    <a:gd name="connsiteY25" fmla="*/ 13125 h 40004"/>
                    <a:gd name="connsiteX26" fmla="*/ 381667 w 763381"/>
                    <a:gd name="connsiteY26" fmla="*/ 20955 h 40004"/>
                    <a:gd name="connsiteX27" fmla="*/ 416357 w 763381"/>
                    <a:gd name="connsiteY27" fmla="*/ 13049 h 40004"/>
                    <a:gd name="connsiteX28" fmla="*/ 476488 w 763381"/>
                    <a:gd name="connsiteY28" fmla="*/ 0 h 40004"/>
                    <a:gd name="connsiteX29" fmla="*/ 537791 w 763381"/>
                    <a:gd name="connsiteY29" fmla="*/ 13125 h 40004"/>
                    <a:gd name="connsiteX30" fmla="*/ 572167 w 763381"/>
                    <a:gd name="connsiteY30" fmla="*/ 20955 h 40004"/>
                    <a:gd name="connsiteX31" fmla="*/ 606857 w 763381"/>
                    <a:gd name="connsiteY31" fmla="*/ 13049 h 40004"/>
                    <a:gd name="connsiteX32" fmla="*/ 666998 w 763381"/>
                    <a:gd name="connsiteY32" fmla="*/ 0 h 40004"/>
                    <a:gd name="connsiteX33" fmla="*/ 728301 w 763381"/>
                    <a:gd name="connsiteY33" fmla="*/ 13125 h 40004"/>
                    <a:gd name="connsiteX34" fmla="*/ 763381 w 763381"/>
                    <a:gd name="connsiteY34" fmla="*/ 20974 h 40004"/>
                    <a:gd name="connsiteX35" fmla="*/ 762029 w 763381"/>
                    <a:gd name="connsiteY35" fmla="*/ 40005 h 40004"/>
                    <a:gd name="connsiteX36" fmla="*/ 721185 w 763381"/>
                    <a:gd name="connsiteY36" fmla="*/ 30832 h 40004"/>
                    <a:gd name="connsiteX37" fmla="*/ 666998 w 763381"/>
                    <a:gd name="connsiteY37" fmla="*/ 19050 h 40004"/>
                    <a:gd name="connsiteX38" fmla="*/ 614001 w 763381"/>
                    <a:gd name="connsiteY38" fmla="*/ 30709 h 40004"/>
                    <a:gd name="connsiteX39" fmla="*/ 572872 w 763381"/>
                    <a:gd name="connsiteY39" fmla="*/ 39986 h 40004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</a:cxnLst>
                  <a:rect l="l" t="t" r="r" b="b"/>
                  <a:pathLst>
                    <a:path w="763381" h="40004">
                      <a:moveTo>
                        <a:pt x="572167" y="40005"/>
                      </a:moveTo>
                      <a:lnTo>
                        <a:pt x="571491" y="39948"/>
                      </a:lnTo>
                      <a:cubicBezTo>
                        <a:pt x="557493" y="38958"/>
                        <a:pt x="543724" y="35866"/>
                        <a:pt x="530647" y="30775"/>
                      </a:cubicBezTo>
                      <a:cubicBezTo>
                        <a:pt x="513439" y="23665"/>
                        <a:pt x="495096" y="19694"/>
                        <a:pt x="476488" y="19050"/>
                      </a:cubicBezTo>
                      <a:cubicBezTo>
                        <a:pt x="458274" y="19784"/>
                        <a:pt x="440332" y="23732"/>
                        <a:pt x="423491" y="30709"/>
                      </a:cubicBezTo>
                      <a:cubicBezTo>
                        <a:pt x="410327" y="35853"/>
                        <a:pt x="396460" y="38980"/>
                        <a:pt x="382362" y="39986"/>
                      </a:cubicBezTo>
                      <a:lnTo>
                        <a:pt x="381667" y="40005"/>
                      </a:lnTo>
                      <a:lnTo>
                        <a:pt x="380991" y="39948"/>
                      </a:lnTo>
                      <a:cubicBezTo>
                        <a:pt x="366993" y="38958"/>
                        <a:pt x="353224" y="35866"/>
                        <a:pt x="340147" y="30775"/>
                      </a:cubicBezTo>
                      <a:cubicBezTo>
                        <a:pt x="322936" y="23664"/>
                        <a:pt x="304590" y="19693"/>
                        <a:pt x="285979" y="19050"/>
                      </a:cubicBezTo>
                      <a:cubicBezTo>
                        <a:pt x="267764" y="19784"/>
                        <a:pt x="249823" y="23732"/>
                        <a:pt x="232982" y="30709"/>
                      </a:cubicBezTo>
                      <a:cubicBezTo>
                        <a:pt x="219817" y="35853"/>
                        <a:pt x="205951" y="38980"/>
                        <a:pt x="191853" y="39986"/>
                      </a:cubicBezTo>
                      <a:lnTo>
                        <a:pt x="191167" y="40005"/>
                      </a:lnTo>
                      <a:lnTo>
                        <a:pt x="190500" y="40005"/>
                      </a:lnTo>
                      <a:cubicBezTo>
                        <a:pt x="176502" y="39015"/>
                        <a:pt x="162734" y="35924"/>
                        <a:pt x="149657" y="30832"/>
                      </a:cubicBezTo>
                      <a:cubicBezTo>
                        <a:pt x="132443" y="23699"/>
                        <a:pt x="114090" y="19709"/>
                        <a:pt x="95469" y="19050"/>
                      </a:cubicBezTo>
                      <a:cubicBezTo>
                        <a:pt x="77254" y="19784"/>
                        <a:pt x="59313" y="23732"/>
                        <a:pt x="42472" y="30709"/>
                      </a:cubicBezTo>
                      <a:cubicBezTo>
                        <a:pt x="29307" y="35853"/>
                        <a:pt x="15441" y="38980"/>
                        <a:pt x="1343" y="39986"/>
                      </a:cubicBezTo>
                      <a:lnTo>
                        <a:pt x="0" y="20955"/>
                      </a:lnTo>
                      <a:cubicBezTo>
                        <a:pt x="12118" y="20087"/>
                        <a:pt x="24037" y="17403"/>
                        <a:pt x="35357" y="12992"/>
                      </a:cubicBezTo>
                      <a:cubicBezTo>
                        <a:pt x="54463" y="5123"/>
                        <a:pt x="74819" y="723"/>
                        <a:pt x="95469" y="0"/>
                      </a:cubicBezTo>
                      <a:cubicBezTo>
                        <a:pt x="116527" y="646"/>
                        <a:pt x="137295" y="5092"/>
                        <a:pt x="156772" y="13125"/>
                      </a:cubicBezTo>
                      <a:cubicBezTo>
                        <a:pt x="167791" y="17406"/>
                        <a:pt x="179381" y="20044"/>
                        <a:pt x="191167" y="20955"/>
                      </a:cubicBezTo>
                      <a:cubicBezTo>
                        <a:pt x="203057" y="20044"/>
                        <a:pt x="214746" y="17380"/>
                        <a:pt x="225857" y="13049"/>
                      </a:cubicBezTo>
                      <a:cubicBezTo>
                        <a:pt x="244962" y="5160"/>
                        <a:pt x="265322" y="740"/>
                        <a:pt x="285979" y="0"/>
                      </a:cubicBezTo>
                      <a:cubicBezTo>
                        <a:pt x="307036" y="646"/>
                        <a:pt x="327805" y="5092"/>
                        <a:pt x="347282" y="13125"/>
                      </a:cubicBezTo>
                      <a:cubicBezTo>
                        <a:pt x="358298" y="17405"/>
                        <a:pt x="369883" y="20043"/>
                        <a:pt x="381667" y="20955"/>
                      </a:cubicBezTo>
                      <a:cubicBezTo>
                        <a:pt x="393557" y="20043"/>
                        <a:pt x="405246" y="17380"/>
                        <a:pt x="416357" y="13049"/>
                      </a:cubicBezTo>
                      <a:cubicBezTo>
                        <a:pt x="435465" y="5158"/>
                        <a:pt x="455827" y="739"/>
                        <a:pt x="476488" y="0"/>
                      </a:cubicBezTo>
                      <a:cubicBezTo>
                        <a:pt x="497546" y="646"/>
                        <a:pt x="518314" y="5092"/>
                        <a:pt x="537791" y="13125"/>
                      </a:cubicBezTo>
                      <a:cubicBezTo>
                        <a:pt x="548805" y="17404"/>
                        <a:pt x="560386" y="20043"/>
                        <a:pt x="572167" y="20955"/>
                      </a:cubicBezTo>
                      <a:cubicBezTo>
                        <a:pt x="584057" y="20043"/>
                        <a:pt x="595746" y="17379"/>
                        <a:pt x="606857" y="13049"/>
                      </a:cubicBezTo>
                      <a:cubicBezTo>
                        <a:pt x="625968" y="5157"/>
                        <a:pt x="646334" y="738"/>
                        <a:pt x="666998" y="0"/>
                      </a:cubicBezTo>
                      <a:cubicBezTo>
                        <a:pt x="688056" y="645"/>
                        <a:pt x="708824" y="5092"/>
                        <a:pt x="728301" y="13125"/>
                      </a:cubicBezTo>
                      <a:cubicBezTo>
                        <a:pt x="739537" y="17476"/>
                        <a:pt x="751362" y="20122"/>
                        <a:pt x="763381" y="20974"/>
                      </a:cubicBezTo>
                      <a:lnTo>
                        <a:pt x="762029" y="40005"/>
                      </a:lnTo>
                      <a:cubicBezTo>
                        <a:pt x="748031" y="39015"/>
                        <a:pt x="734262" y="35924"/>
                        <a:pt x="721185" y="30832"/>
                      </a:cubicBezTo>
                      <a:cubicBezTo>
                        <a:pt x="703972" y="23699"/>
                        <a:pt x="685619" y="19709"/>
                        <a:pt x="666998" y="19050"/>
                      </a:cubicBezTo>
                      <a:cubicBezTo>
                        <a:pt x="648783" y="19784"/>
                        <a:pt x="630842" y="23732"/>
                        <a:pt x="614001" y="30709"/>
                      </a:cubicBezTo>
                      <a:cubicBezTo>
                        <a:pt x="600836" y="35853"/>
                        <a:pt x="586970" y="38980"/>
                        <a:pt x="572872" y="39986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42" name="Freeform: Shape 41">
                  <a:extLst>
                    <a:ext uri="{FF2B5EF4-FFF2-40B4-BE49-F238E27FC236}">
                      <a16:creationId xmlns:a16="http://schemas.microsoft.com/office/drawing/2014/main" id="{A8A8653F-3AA8-74A5-2E25-E42523D51B65}"/>
                    </a:ext>
                  </a:extLst>
                </p:cNvPr>
                <p:cNvSpPr/>
                <p:nvPr/>
              </p:nvSpPr>
              <p:spPr>
                <a:xfrm>
                  <a:off x="6553566" y="4286239"/>
                  <a:ext cx="171450" cy="171450"/>
                </a:xfrm>
                <a:custGeom>
                  <a:avLst/>
                  <a:gdLst>
                    <a:gd name="connsiteX0" fmla="*/ 85725 w 171450"/>
                    <a:gd name="connsiteY0" fmla="*/ 19050 h 171450"/>
                    <a:gd name="connsiteX1" fmla="*/ 152400 w 171450"/>
                    <a:gd name="connsiteY1" fmla="*/ 85725 h 171450"/>
                    <a:gd name="connsiteX2" fmla="*/ 85725 w 171450"/>
                    <a:gd name="connsiteY2" fmla="*/ 152400 h 171450"/>
                    <a:gd name="connsiteX3" fmla="*/ 19050 w 171450"/>
                    <a:gd name="connsiteY3" fmla="*/ 85725 h 171450"/>
                    <a:gd name="connsiteX4" fmla="*/ 85725 w 171450"/>
                    <a:gd name="connsiteY4" fmla="*/ 19050 h 171450"/>
                    <a:gd name="connsiteX5" fmla="*/ 85725 w 171450"/>
                    <a:gd name="connsiteY5" fmla="*/ 0 h 171450"/>
                    <a:gd name="connsiteX6" fmla="*/ 0 w 171450"/>
                    <a:gd name="connsiteY6" fmla="*/ 85725 h 171450"/>
                    <a:gd name="connsiteX7" fmla="*/ 85725 w 171450"/>
                    <a:gd name="connsiteY7" fmla="*/ 171450 h 171450"/>
                    <a:gd name="connsiteX8" fmla="*/ 171450 w 171450"/>
                    <a:gd name="connsiteY8" fmla="*/ 85725 h 171450"/>
                    <a:gd name="connsiteX9" fmla="*/ 85725 w 171450"/>
                    <a:gd name="connsiteY9" fmla="*/ 0 h 1714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71450" h="171450">
                      <a:moveTo>
                        <a:pt x="85725" y="19050"/>
                      </a:moveTo>
                      <a:cubicBezTo>
                        <a:pt x="122549" y="19050"/>
                        <a:pt x="152400" y="48901"/>
                        <a:pt x="152400" y="85725"/>
                      </a:cubicBezTo>
                      <a:cubicBezTo>
                        <a:pt x="152400" y="122549"/>
                        <a:pt x="122549" y="152400"/>
                        <a:pt x="85725" y="152400"/>
                      </a:cubicBezTo>
                      <a:cubicBezTo>
                        <a:pt x="48901" y="152400"/>
                        <a:pt x="19050" y="122549"/>
                        <a:pt x="19050" y="85725"/>
                      </a:cubicBezTo>
                      <a:cubicBezTo>
                        <a:pt x="19098" y="48921"/>
                        <a:pt x="48921" y="19098"/>
                        <a:pt x="85725" y="19050"/>
                      </a:cubicBezTo>
                      <a:moveTo>
                        <a:pt x="85725" y="0"/>
                      </a:moveTo>
                      <a:cubicBezTo>
                        <a:pt x="38380" y="0"/>
                        <a:pt x="0" y="38380"/>
                        <a:pt x="0" y="85725"/>
                      </a:cubicBezTo>
                      <a:cubicBezTo>
                        <a:pt x="0" y="133070"/>
                        <a:pt x="38380" y="171450"/>
                        <a:pt x="85725" y="171450"/>
                      </a:cubicBezTo>
                      <a:cubicBezTo>
                        <a:pt x="133070" y="171450"/>
                        <a:pt x="171450" y="133070"/>
                        <a:pt x="171450" y="85725"/>
                      </a:cubicBezTo>
                      <a:cubicBezTo>
                        <a:pt x="171450" y="38380"/>
                        <a:pt x="133070" y="0"/>
                        <a:pt x="85725" y="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</p:grpSp>
          <p:grpSp>
            <p:nvGrpSpPr>
              <p:cNvPr id="24" name="Graphic 21" descr="Skipping Rope outline">
                <a:extLst>
                  <a:ext uri="{FF2B5EF4-FFF2-40B4-BE49-F238E27FC236}">
                    <a16:creationId xmlns:a16="http://schemas.microsoft.com/office/drawing/2014/main" id="{CE800E50-C54E-D9DA-8C7B-EFD5AE82ADEC}"/>
                  </a:ext>
                </a:extLst>
              </p:cNvPr>
              <p:cNvGrpSpPr/>
              <p:nvPr/>
            </p:nvGrpSpPr>
            <p:grpSpPr>
              <a:xfrm>
                <a:off x="9775934" y="3621525"/>
                <a:ext cx="367125" cy="457200"/>
                <a:chOff x="6424448" y="4257532"/>
                <a:chExt cx="591970" cy="876300"/>
              </a:xfrm>
              <a:solidFill>
                <a:srgbClr val="000000"/>
              </a:solidFill>
            </p:grpSpPr>
            <p:sp>
              <p:nvSpPr>
                <p:cNvPr id="37" name="Freeform: Shape 36">
                  <a:extLst>
                    <a:ext uri="{FF2B5EF4-FFF2-40B4-BE49-F238E27FC236}">
                      <a16:creationId xmlns:a16="http://schemas.microsoft.com/office/drawing/2014/main" id="{3D7754D0-345F-A8CA-0385-EFC03AB780F2}"/>
                    </a:ext>
                  </a:extLst>
                </p:cNvPr>
                <p:cNvSpPr/>
                <p:nvPr/>
              </p:nvSpPr>
              <p:spPr>
                <a:xfrm>
                  <a:off x="6644235" y="4257532"/>
                  <a:ext cx="152400" cy="152400"/>
                </a:xfrm>
                <a:custGeom>
                  <a:avLst/>
                  <a:gdLst>
                    <a:gd name="connsiteX0" fmla="*/ 76200 w 152400"/>
                    <a:gd name="connsiteY0" fmla="*/ 152400 h 152400"/>
                    <a:gd name="connsiteX1" fmla="*/ 152400 w 152400"/>
                    <a:gd name="connsiteY1" fmla="*/ 76200 h 152400"/>
                    <a:gd name="connsiteX2" fmla="*/ 76200 w 152400"/>
                    <a:gd name="connsiteY2" fmla="*/ 0 h 152400"/>
                    <a:gd name="connsiteX3" fmla="*/ 0 w 152400"/>
                    <a:gd name="connsiteY3" fmla="*/ 76200 h 152400"/>
                    <a:gd name="connsiteX4" fmla="*/ 76200 w 152400"/>
                    <a:gd name="connsiteY4" fmla="*/ 152400 h 152400"/>
                    <a:gd name="connsiteX5" fmla="*/ 76200 w 152400"/>
                    <a:gd name="connsiteY5" fmla="*/ 19050 h 152400"/>
                    <a:gd name="connsiteX6" fmla="*/ 133350 w 152400"/>
                    <a:gd name="connsiteY6" fmla="*/ 76200 h 152400"/>
                    <a:gd name="connsiteX7" fmla="*/ 76200 w 152400"/>
                    <a:gd name="connsiteY7" fmla="*/ 133350 h 152400"/>
                    <a:gd name="connsiteX8" fmla="*/ 19050 w 152400"/>
                    <a:gd name="connsiteY8" fmla="*/ 76200 h 152400"/>
                    <a:gd name="connsiteX9" fmla="*/ 76200 w 152400"/>
                    <a:gd name="connsiteY9" fmla="*/ 19050 h 1524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52400" h="152400">
                      <a:moveTo>
                        <a:pt x="76200" y="152400"/>
                      </a:moveTo>
                      <a:cubicBezTo>
                        <a:pt x="118284" y="152400"/>
                        <a:pt x="152400" y="118284"/>
                        <a:pt x="152400" y="76200"/>
                      </a:cubicBezTo>
                      <a:cubicBezTo>
                        <a:pt x="152400" y="34116"/>
                        <a:pt x="118284" y="0"/>
                        <a:pt x="76200" y="0"/>
                      </a:cubicBezTo>
                      <a:cubicBezTo>
                        <a:pt x="34116" y="0"/>
                        <a:pt x="0" y="34116"/>
                        <a:pt x="0" y="76200"/>
                      </a:cubicBezTo>
                      <a:cubicBezTo>
                        <a:pt x="0" y="118284"/>
                        <a:pt x="34116" y="152400"/>
                        <a:pt x="76200" y="152400"/>
                      </a:cubicBezTo>
                      <a:close/>
                      <a:moveTo>
                        <a:pt x="76200" y="19050"/>
                      </a:moveTo>
                      <a:cubicBezTo>
                        <a:pt x="107763" y="19050"/>
                        <a:pt x="133350" y="44637"/>
                        <a:pt x="133350" y="76200"/>
                      </a:cubicBezTo>
                      <a:cubicBezTo>
                        <a:pt x="133350" y="107763"/>
                        <a:pt x="107763" y="133350"/>
                        <a:pt x="76200" y="133350"/>
                      </a:cubicBezTo>
                      <a:cubicBezTo>
                        <a:pt x="44637" y="133350"/>
                        <a:pt x="19050" y="107763"/>
                        <a:pt x="19050" y="76200"/>
                      </a:cubicBezTo>
                      <a:cubicBezTo>
                        <a:pt x="19087" y="44652"/>
                        <a:pt x="44652" y="19087"/>
                        <a:pt x="76200" y="19050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38" name="Freeform: Shape 37">
                  <a:extLst>
                    <a:ext uri="{FF2B5EF4-FFF2-40B4-BE49-F238E27FC236}">
                      <a16:creationId xmlns:a16="http://schemas.microsoft.com/office/drawing/2014/main" id="{E488DB69-CDD4-3323-0AB1-B11A4C3E09B2}"/>
                    </a:ext>
                  </a:extLst>
                </p:cNvPr>
                <p:cNvSpPr/>
                <p:nvPr/>
              </p:nvSpPr>
              <p:spPr>
                <a:xfrm>
                  <a:off x="6424448" y="4439030"/>
                  <a:ext cx="591970" cy="694801"/>
                </a:xfrm>
                <a:custGeom>
                  <a:avLst/>
                  <a:gdLst>
                    <a:gd name="connsiteX0" fmla="*/ 564906 w 591970"/>
                    <a:gd name="connsiteY0" fmla="*/ 162354 h 694801"/>
                    <a:gd name="connsiteX1" fmla="*/ 482696 w 591970"/>
                    <a:gd name="connsiteY1" fmla="*/ 121244 h 694801"/>
                    <a:gd name="connsiteX2" fmla="*/ 405782 w 591970"/>
                    <a:gd name="connsiteY2" fmla="*/ 27242 h 694801"/>
                    <a:gd name="connsiteX3" fmla="*/ 382626 w 591970"/>
                    <a:gd name="connsiteY3" fmla="*/ 12097 h 694801"/>
                    <a:gd name="connsiteX4" fmla="*/ 377407 w 591970"/>
                    <a:gd name="connsiteY4" fmla="*/ 10792 h 694801"/>
                    <a:gd name="connsiteX5" fmla="*/ 361938 w 591970"/>
                    <a:gd name="connsiteY5" fmla="*/ 7325 h 694801"/>
                    <a:gd name="connsiteX6" fmla="*/ 230045 w 591970"/>
                    <a:gd name="connsiteY6" fmla="*/ 7258 h 694801"/>
                    <a:gd name="connsiteX7" fmla="*/ 215015 w 591970"/>
                    <a:gd name="connsiteY7" fmla="*/ 10621 h 694801"/>
                    <a:gd name="connsiteX8" fmla="*/ 208881 w 591970"/>
                    <a:gd name="connsiteY8" fmla="*/ 12240 h 694801"/>
                    <a:gd name="connsiteX9" fmla="*/ 186230 w 591970"/>
                    <a:gd name="connsiteY9" fmla="*/ 27242 h 694801"/>
                    <a:gd name="connsiteX10" fmla="*/ 109326 w 591970"/>
                    <a:gd name="connsiteY10" fmla="*/ 121225 h 694801"/>
                    <a:gd name="connsiteX11" fmla="*/ 27068 w 591970"/>
                    <a:gd name="connsiteY11" fmla="*/ 162354 h 694801"/>
                    <a:gd name="connsiteX12" fmla="*/ 4265 w 591970"/>
                    <a:gd name="connsiteY12" fmla="*/ 224007 h 694801"/>
                    <a:gd name="connsiteX13" fmla="*/ 38850 w 591970"/>
                    <a:gd name="connsiteY13" fmla="*/ 250432 h 694801"/>
                    <a:gd name="connsiteX14" fmla="*/ 267450 w 591970"/>
                    <a:gd name="connsiteY14" fmla="*/ 626002 h 694801"/>
                    <a:gd name="connsiteX15" fmla="*/ 267450 w 591970"/>
                    <a:gd name="connsiteY15" fmla="*/ 606809 h 694801"/>
                    <a:gd name="connsiteX16" fmla="*/ 57900 w 591970"/>
                    <a:gd name="connsiteY16" fmla="*/ 249622 h 694801"/>
                    <a:gd name="connsiteX17" fmla="*/ 67349 w 591970"/>
                    <a:gd name="connsiteY17" fmla="*/ 246155 h 694801"/>
                    <a:gd name="connsiteX18" fmla="*/ 159741 w 591970"/>
                    <a:gd name="connsiteY18" fmla="*/ 199940 h 694801"/>
                    <a:gd name="connsiteX19" fmla="*/ 174800 w 591970"/>
                    <a:gd name="connsiteY19" fmla="*/ 188071 h 694801"/>
                    <a:gd name="connsiteX20" fmla="*/ 200604 w 591970"/>
                    <a:gd name="connsiteY20" fmla="*/ 158477 h 694801"/>
                    <a:gd name="connsiteX21" fmla="*/ 200775 w 591970"/>
                    <a:gd name="connsiteY21" fmla="*/ 158534 h 694801"/>
                    <a:gd name="connsiteX22" fmla="*/ 200775 w 591970"/>
                    <a:gd name="connsiteY22" fmla="*/ 462391 h 694801"/>
                    <a:gd name="connsiteX23" fmla="*/ 252210 w 591970"/>
                    <a:gd name="connsiteY23" fmla="*/ 513826 h 694801"/>
                    <a:gd name="connsiteX24" fmla="*/ 254115 w 591970"/>
                    <a:gd name="connsiteY24" fmla="*/ 513826 h 694801"/>
                    <a:gd name="connsiteX25" fmla="*/ 286500 w 591970"/>
                    <a:gd name="connsiteY25" fmla="*/ 502320 h 694801"/>
                    <a:gd name="connsiteX26" fmla="*/ 286500 w 591970"/>
                    <a:gd name="connsiteY26" fmla="*/ 643366 h 694801"/>
                    <a:gd name="connsiteX27" fmla="*/ 337935 w 591970"/>
                    <a:gd name="connsiteY27" fmla="*/ 694801 h 694801"/>
                    <a:gd name="connsiteX28" fmla="*/ 339840 w 591970"/>
                    <a:gd name="connsiteY28" fmla="*/ 694801 h 694801"/>
                    <a:gd name="connsiteX29" fmla="*/ 391275 w 591970"/>
                    <a:gd name="connsiteY29" fmla="*/ 643366 h 694801"/>
                    <a:gd name="connsiteX30" fmla="*/ 391275 w 591970"/>
                    <a:gd name="connsiteY30" fmla="*/ 158544 h 694801"/>
                    <a:gd name="connsiteX31" fmla="*/ 391437 w 591970"/>
                    <a:gd name="connsiteY31" fmla="*/ 158487 h 694801"/>
                    <a:gd name="connsiteX32" fmla="*/ 417040 w 591970"/>
                    <a:gd name="connsiteY32" fmla="*/ 187852 h 694801"/>
                    <a:gd name="connsiteX33" fmla="*/ 432233 w 591970"/>
                    <a:gd name="connsiteY33" fmla="*/ 199997 h 694801"/>
                    <a:gd name="connsiteX34" fmla="*/ 524625 w 591970"/>
                    <a:gd name="connsiteY34" fmla="*/ 246222 h 694801"/>
                    <a:gd name="connsiteX35" fmla="*/ 534055 w 591970"/>
                    <a:gd name="connsiteY35" fmla="*/ 249698 h 694801"/>
                    <a:gd name="connsiteX36" fmla="*/ 410230 w 591970"/>
                    <a:gd name="connsiteY36" fmla="*/ 579749 h 694801"/>
                    <a:gd name="connsiteX37" fmla="*/ 410230 w 591970"/>
                    <a:gd name="connsiteY37" fmla="*/ 601266 h 694801"/>
                    <a:gd name="connsiteX38" fmla="*/ 553038 w 591970"/>
                    <a:gd name="connsiteY38" fmla="*/ 250460 h 694801"/>
                    <a:gd name="connsiteX39" fmla="*/ 591343 w 591970"/>
                    <a:gd name="connsiteY39" fmla="*/ 197022 h 694801"/>
                    <a:gd name="connsiteX40" fmla="*/ 564906 w 591970"/>
                    <a:gd name="connsiteY40" fmla="*/ 162354 h 694801"/>
                    <a:gd name="connsiteX41" fmla="*/ 571279 w 591970"/>
                    <a:gd name="connsiteY41" fmla="*/ 213875 h 694801"/>
                    <a:gd name="connsiteX42" fmla="*/ 536206 w 591970"/>
                    <a:gd name="connsiteY42" fmla="*/ 230456 h 694801"/>
                    <a:gd name="connsiteX43" fmla="*/ 533179 w 591970"/>
                    <a:gd name="connsiteY43" fmla="*/ 229162 h 694801"/>
                    <a:gd name="connsiteX44" fmla="*/ 440729 w 591970"/>
                    <a:gd name="connsiteY44" fmla="*/ 182937 h 694801"/>
                    <a:gd name="connsiteX45" fmla="*/ 431585 w 591970"/>
                    <a:gd name="connsiteY45" fmla="*/ 175546 h 694801"/>
                    <a:gd name="connsiteX46" fmla="*/ 391266 w 591970"/>
                    <a:gd name="connsiteY46" fmla="*/ 129274 h 694801"/>
                    <a:gd name="connsiteX47" fmla="*/ 391266 w 591970"/>
                    <a:gd name="connsiteY47" fmla="*/ 117844 h 694801"/>
                    <a:gd name="connsiteX48" fmla="*/ 381741 w 591970"/>
                    <a:gd name="connsiteY48" fmla="*/ 108319 h 694801"/>
                    <a:gd name="connsiteX49" fmla="*/ 372216 w 591970"/>
                    <a:gd name="connsiteY49" fmla="*/ 117844 h 694801"/>
                    <a:gd name="connsiteX50" fmla="*/ 372216 w 591970"/>
                    <a:gd name="connsiteY50" fmla="*/ 643366 h 694801"/>
                    <a:gd name="connsiteX51" fmla="*/ 339831 w 591970"/>
                    <a:gd name="connsiteY51" fmla="*/ 675751 h 694801"/>
                    <a:gd name="connsiteX52" fmla="*/ 337926 w 591970"/>
                    <a:gd name="connsiteY52" fmla="*/ 675751 h 694801"/>
                    <a:gd name="connsiteX53" fmla="*/ 305541 w 591970"/>
                    <a:gd name="connsiteY53" fmla="*/ 643366 h 694801"/>
                    <a:gd name="connsiteX54" fmla="*/ 305541 w 591970"/>
                    <a:gd name="connsiteY54" fmla="*/ 323326 h 694801"/>
                    <a:gd name="connsiteX55" fmla="*/ 286491 w 591970"/>
                    <a:gd name="connsiteY55" fmla="*/ 323326 h 694801"/>
                    <a:gd name="connsiteX56" fmla="*/ 286491 w 591970"/>
                    <a:gd name="connsiteY56" fmla="*/ 462391 h 694801"/>
                    <a:gd name="connsiteX57" fmla="*/ 254106 w 591970"/>
                    <a:gd name="connsiteY57" fmla="*/ 494776 h 694801"/>
                    <a:gd name="connsiteX58" fmla="*/ 252201 w 591970"/>
                    <a:gd name="connsiteY58" fmla="*/ 494776 h 694801"/>
                    <a:gd name="connsiteX59" fmla="*/ 219816 w 591970"/>
                    <a:gd name="connsiteY59" fmla="*/ 462391 h 694801"/>
                    <a:gd name="connsiteX60" fmla="*/ 219816 w 591970"/>
                    <a:gd name="connsiteY60" fmla="*/ 117825 h 694801"/>
                    <a:gd name="connsiteX61" fmla="*/ 210291 w 591970"/>
                    <a:gd name="connsiteY61" fmla="*/ 108300 h 694801"/>
                    <a:gd name="connsiteX62" fmla="*/ 200766 w 591970"/>
                    <a:gd name="connsiteY62" fmla="*/ 117825 h 694801"/>
                    <a:gd name="connsiteX63" fmla="*/ 200766 w 591970"/>
                    <a:gd name="connsiteY63" fmla="*/ 129255 h 694801"/>
                    <a:gd name="connsiteX64" fmla="*/ 160227 w 591970"/>
                    <a:gd name="connsiteY64" fmla="*/ 175756 h 694801"/>
                    <a:gd name="connsiteX65" fmla="*/ 151255 w 591970"/>
                    <a:gd name="connsiteY65" fmla="*/ 182918 h 694801"/>
                    <a:gd name="connsiteX66" fmla="*/ 58862 w 591970"/>
                    <a:gd name="connsiteY66" fmla="*/ 229143 h 694801"/>
                    <a:gd name="connsiteX67" fmla="*/ 22048 w 591970"/>
                    <a:gd name="connsiteY67" fmla="*/ 216865 h 694801"/>
                    <a:gd name="connsiteX68" fmla="*/ 20762 w 591970"/>
                    <a:gd name="connsiteY68" fmla="*/ 213856 h 694801"/>
                    <a:gd name="connsiteX69" fmla="*/ 35659 w 591970"/>
                    <a:gd name="connsiteY69" fmla="*/ 179375 h 694801"/>
                    <a:gd name="connsiteX70" fmla="*/ 119698 w 591970"/>
                    <a:gd name="connsiteY70" fmla="*/ 137360 h 694801"/>
                    <a:gd name="connsiteX71" fmla="*/ 122813 w 591970"/>
                    <a:gd name="connsiteY71" fmla="*/ 134865 h 694801"/>
                    <a:gd name="connsiteX72" fmla="*/ 201004 w 591970"/>
                    <a:gd name="connsiteY72" fmla="*/ 39300 h 694801"/>
                    <a:gd name="connsiteX73" fmla="*/ 215377 w 591970"/>
                    <a:gd name="connsiteY73" fmla="*/ 30223 h 694801"/>
                    <a:gd name="connsiteX74" fmla="*/ 216663 w 591970"/>
                    <a:gd name="connsiteY74" fmla="*/ 29785 h 694801"/>
                    <a:gd name="connsiteX75" fmla="*/ 234246 w 591970"/>
                    <a:gd name="connsiteY75" fmla="*/ 25861 h 694801"/>
                    <a:gd name="connsiteX76" fmla="*/ 357852 w 591970"/>
                    <a:gd name="connsiteY76" fmla="*/ 25861 h 694801"/>
                    <a:gd name="connsiteX77" fmla="*/ 375949 w 591970"/>
                    <a:gd name="connsiteY77" fmla="*/ 29918 h 694801"/>
                    <a:gd name="connsiteX78" fmla="*/ 376749 w 591970"/>
                    <a:gd name="connsiteY78" fmla="*/ 30166 h 694801"/>
                    <a:gd name="connsiteX79" fmla="*/ 391132 w 591970"/>
                    <a:gd name="connsiteY79" fmla="*/ 39253 h 694801"/>
                    <a:gd name="connsiteX80" fmla="*/ 469323 w 591970"/>
                    <a:gd name="connsiteY80" fmla="*/ 134817 h 694801"/>
                    <a:gd name="connsiteX81" fmla="*/ 472438 w 591970"/>
                    <a:gd name="connsiteY81" fmla="*/ 137313 h 694801"/>
                    <a:gd name="connsiteX82" fmla="*/ 556477 w 591970"/>
                    <a:gd name="connsiteY82" fmla="*/ 179327 h 694801"/>
                    <a:gd name="connsiteX83" fmla="*/ 571279 w 591970"/>
                    <a:gd name="connsiteY83" fmla="*/ 213856 h 694801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</a:cxnLst>
                  <a:rect l="l" t="t" r="r" b="b"/>
                  <a:pathLst>
                    <a:path w="591970" h="694801">
                      <a:moveTo>
                        <a:pt x="564906" y="162354"/>
                      </a:moveTo>
                      <a:lnTo>
                        <a:pt x="482696" y="121244"/>
                      </a:lnTo>
                      <a:lnTo>
                        <a:pt x="405782" y="27242"/>
                      </a:lnTo>
                      <a:cubicBezTo>
                        <a:pt x="399801" y="19936"/>
                        <a:pt x="391717" y="14648"/>
                        <a:pt x="382626" y="12097"/>
                      </a:cubicBezTo>
                      <a:cubicBezTo>
                        <a:pt x="382150" y="11907"/>
                        <a:pt x="377921" y="10906"/>
                        <a:pt x="377407" y="10792"/>
                      </a:cubicBezTo>
                      <a:lnTo>
                        <a:pt x="361938" y="7325"/>
                      </a:lnTo>
                      <a:cubicBezTo>
                        <a:pt x="318516" y="-2419"/>
                        <a:pt x="273478" y="-2442"/>
                        <a:pt x="230045" y="7258"/>
                      </a:cubicBezTo>
                      <a:lnTo>
                        <a:pt x="215015" y="10621"/>
                      </a:lnTo>
                      <a:cubicBezTo>
                        <a:pt x="214310" y="10783"/>
                        <a:pt x="209509" y="11945"/>
                        <a:pt x="208881" y="12240"/>
                      </a:cubicBezTo>
                      <a:cubicBezTo>
                        <a:pt x="199989" y="14839"/>
                        <a:pt x="192093" y="20069"/>
                        <a:pt x="186230" y="27242"/>
                      </a:cubicBezTo>
                      <a:lnTo>
                        <a:pt x="109326" y="121225"/>
                      </a:lnTo>
                      <a:lnTo>
                        <a:pt x="27068" y="162354"/>
                      </a:lnTo>
                      <a:cubicBezTo>
                        <a:pt x="3746" y="173082"/>
                        <a:pt x="-6463" y="200685"/>
                        <a:pt x="4265" y="224007"/>
                      </a:cubicBezTo>
                      <a:cubicBezTo>
                        <a:pt x="10703" y="238002"/>
                        <a:pt x="23655" y="247899"/>
                        <a:pt x="38850" y="250432"/>
                      </a:cubicBezTo>
                      <a:cubicBezTo>
                        <a:pt x="39698" y="470459"/>
                        <a:pt x="124299" y="607810"/>
                        <a:pt x="267450" y="626002"/>
                      </a:cubicBezTo>
                      <a:lnTo>
                        <a:pt x="267450" y="606809"/>
                      </a:lnTo>
                      <a:cubicBezTo>
                        <a:pt x="134310" y="588864"/>
                        <a:pt x="58529" y="461020"/>
                        <a:pt x="57900" y="249622"/>
                      </a:cubicBezTo>
                      <a:cubicBezTo>
                        <a:pt x="61164" y="248808"/>
                        <a:pt x="64332" y="247646"/>
                        <a:pt x="67349" y="246155"/>
                      </a:cubicBezTo>
                      <a:lnTo>
                        <a:pt x="159741" y="199940"/>
                      </a:lnTo>
                      <a:cubicBezTo>
                        <a:pt x="165545" y="197095"/>
                        <a:pt x="170678" y="193050"/>
                        <a:pt x="174800" y="188071"/>
                      </a:cubicBezTo>
                      <a:lnTo>
                        <a:pt x="200604" y="158477"/>
                      </a:lnTo>
                      <a:cubicBezTo>
                        <a:pt x="200699" y="158363"/>
                        <a:pt x="200775" y="158391"/>
                        <a:pt x="200775" y="158534"/>
                      </a:cubicBezTo>
                      <a:lnTo>
                        <a:pt x="200775" y="462391"/>
                      </a:lnTo>
                      <a:cubicBezTo>
                        <a:pt x="200775" y="490798"/>
                        <a:pt x="223804" y="513826"/>
                        <a:pt x="252210" y="513826"/>
                      </a:cubicBezTo>
                      <a:lnTo>
                        <a:pt x="254115" y="513826"/>
                      </a:lnTo>
                      <a:cubicBezTo>
                        <a:pt x="265914" y="513837"/>
                        <a:pt x="277353" y="509773"/>
                        <a:pt x="286500" y="502320"/>
                      </a:cubicBezTo>
                      <a:lnTo>
                        <a:pt x="286500" y="643366"/>
                      </a:lnTo>
                      <a:cubicBezTo>
                        <a:pt x="286500" y="671773"/>
                        <a:pt x="309529" y="694801"/>
                        <a:pt x="337935" y="694801"/>
                      </a:cubicBezTo>
                      <a:lnTo>
                        <a:pt x="339840" y="694801"/>
                      </a:lnTo>
                      <a:cubicBezTo>
                        <a:pt x="368246" y="694801"/>
                        <a:pt x="391275" y="671773"/>
                        <a:pt x="391275" y="643366"/>
                      </a:cubicBezTo>
                      <a:lnTo>
                        <a:pt x="391275" y="158544"/>
                      </a:lnTo>
                      <a:cubicBezTo>
                        <a:pt x="391275" y="158401"/>
                        <a:pt x="391342" y="158372"/>
                        <a:pt x="391437" y="158487"/>
                      </a:cubicBezTo>
                      <a:lnTo>
                        <a:pt x="417040" y="187852"/>
                      </a:lnTo>
                      <a:cubicBezTo>
                        <a:pt x="421180" y="192938"/>
                        <a:pt x="426360" y="197078"/>
                        <a:pt x="432233" y="199997"/>
                      </a:cubicBezTo>
                      <a:lnTo>
                        <a:pt x="524625" y="246222"/>
                      </a:lnTo>
                      <a:cubicBezTo>
                        <a:pt x="527634" y="247716"/>
                        <a:pt x="530795" y="248882"/>
                        <a:pt x="534055" y="249698"/>
                      </a:cubicBezTo>
                      <a:cubicBezTo>
                        <a:pt x="533617" y="416757"/>
                        <a:pt x="490478" y="529733"/>
                        <a:pt x="410230" y="579749"/>
                      </a:cubicBezTo>
                      <a:lnTo>
                        <a:pt x="410230" y="601266"/>
                      </a:lnTo>
                      <a:cubicBezTo>
                        <a:pt x="501670" y="550345"/>
                        <a:pt x="552410" y="428625"/>
                        <a:pt x="553038" y="250460"/>
                      </a:cubicBezTo>
                      <a:cubicBezTo>
                        <a:pt x="578373" y="246282"/>
                        <a:pt x="595523" y="222357"/>
                        <a:pt x="591343" y="197022"/>
                      </a:cubicBezTo>
                      <a:cubicBezTo>
                        <a:pt x="588831" y="181794"/>
                        <a:pt x="578927" y="168805"/>
                        <a:pt x="564906" y="162354"/>
                      </a:cubicBezTo>
                      <a:close/>
                      <a:moveTo>
                        <a:pt x="571279" y="213875"/>
                      </a:moveTo>
                      <a:cubicBezTo>
                        <a:pt x="566172" y="228138"/>
                        <a:pt x="550469" y="235562"/>
                        <a:pt x="536206" y="230456"/>
                      </a:cubicBezTo>
                      <a:cubicBezTo>
                        <a:pt x="535172" y="230085"/>
                        <a:pt x="534161" y="229654"/>
                        <a:pt x="533179" y="229162"/>
                      </a:cubicBezTo>
                      <a:lnTo>
                        <a:pt x="440729" y="182937"/>
                      </a:lnTo>
                      <a:cubicBezTo>
                        <a:pt x="437184" y="181161"/>
                        <a:pt x="434065" y="178640"/>
                        <a:pt x="431585" y="175546"/>
                      </a:cubicBezTo>
                      <a:lnTo>
                        <a:pt x="391266" y="129274"/>
                      </a:lnTo>
                      <a:lnTo>
                        <a:pt x="391266" y="117844"/>
                      </a:lnTo>
                      <a:cubicBezTo>
                        <a:pt x="391266" y="112583"/>
                        <a:pt x="387001" y="108319"/>
                        <a:pt x="381741" y="108319"/>
                      </a:cubicBezTo>
                      <a:cubicBezTo>
                        <a:pt x="376480" y="108319"/>
                        <a:pt x="372216" y="112583"/>
                        <a:pt x="372216" y="117844"/>
                      </a:cubicBezTo>
                      <a:lnTo>
                        <a:pt x="372216" y="643366"/>
                      </a:lnTo>
                      <a:cubicBezTo>
                        <a:pt x="372216" y="661252"/>
                        <a:pt x="357717" y="675751"/>
                        <a:pt x="339831" y="675751"/>
                      </a:cubicBezTo>
                      <a:lnTo>
                        <a:pt x="337926" y="675751"/>
                      </a:lnTo>
                      <a:cubicBezTo>
                        <a:pt x="320039" y="675751"/>
                        <a:pt x="305541" y="661252"/>
                        <a:pt x="305541" y="643366"/>
                      </a:cubicBezTo>
                      <a:lnTo>
                        <a:pt x="305541" y="323326"/>
                      </a:lnTo>
                      <a:lnTo>
                        <a:pt x="286491" y="323326"/>
                      </a:lnTo>
                      <a:lnTo>
                        <a:pt x="286491" y="462391"/>
                      </a:lnTo>
                      <a:cubicBezTo>
                        <a:pt x="286491" y="480277"/>
                        <a:pt x="271992" y="494776"/>
                        <a:pt x="254106" y="494776"/>
                      </a:cubicBezTo>
                      <a:lnTo>
                        <a:pt x="252201" y="494776"/>
                      </a:lnTo>
                      <a:cubicBezTo>
                        <a:pt x="234314" y="494776"/>
                        <a:pt x="219816" y="480277"/>
                        <a:pt x="219816" y="462391"/>
                      </a:cubicBezTo>
                      <a:lnTo>
                        <a:pt x="219816" y="117825"/>
                      </a:lnTo>
                      <a:cubicBezTo>
                        <a:pt x="219816" y="112564"/>
                        <a:pt x="215551" y="108300"/>
                        <a:pt x="210291" y="108300"/>
                      </a:cubicBezTo>
                      <a:cubicBezTo>
                        <a:pt x="205030" y="108300"/>
                        <a:pt x="200766" y="112564"/>
                        <a:pt x="200766" y="117825"/>
                      </a:cubicBezTo>
                      <a:lnTo>
                        <a:pt x="200766" y="129255"/>
                      </a:lnTo>
                      <a:lnTo>
                        <a:pt x="160227" y="175756"/>
                      </a:lnTo>
                      <a:cubicBezTo>
                        <a:pt x="157775" y="178750"/>
                        <a:pt x="154718" y="181192"/>
                        <a:pt x="151255" y="182918"/>
                      </a:cubicBezTo>
                      <a:lnTo>
                        <a:pt x="58862" y="229143"/>
                      </a:lnTo>
                      <a:cubicBezTo>
                        <a:pt x="45305" y="235918"/>
                        <a:pt x="28823" y="230421"/>
                        <a:pt x="22048" y="216865"/>
                      </a:cubicBezTo>
                      <a:cubicBezTo>
                        <a:pt x="21559" y="215888"/>
                        <a:pt x="21131" y="214883"/>
                        <a:pt x="20762" y="213856"/>
                      </a:cubicBezTo>
                      <a:cubicBezTo>
                        <a:pt x="16416" y="200255"/>
                        <a:pt x="22776" y="185532"/>
                        <a:pt x="35659" y="179375"/>
                      </a:cubicBezTo>
                      <a:lnTo>
                        <a:pt x="119698" y="137360"/>
                      </a:lnTo>
                      <a:cubicBezTo>
                        <a:pt x="120899" y="136755"/>
                        <a:pt x="121960" y="135905"/>
                        <a:pt x="122813" y="134865"/>
                      </a:cubicBezTo>
                      <a:lnTo>
                        <a:pt x="201004" y="39300"/>
                      </a:lnTo>
                      <a:cubicBezTo>
                        <a:pt x="204697" y="34810"/>
                        <a:pt x="209735" y="31628"/>
                        <a:pt x="215377" y="30223"/>
                      </a:cubicBezTo>
                      <a:cubicBezTo>
                        <a:pt x="215815" y="30107"/>
                        <a:pt x="216245" y="29961"/>
                        <a:pt x="216663" y="29785"/>
                      </a:cubicBezTo>
                      <a:lnTo>
                        <a:pt x="234246" y="25861"/>
                      </a:lnTo>
                      <a:cubicBezTo>
                        <a:pt x="274951" y="16812"/>
                        <a:pt x="317147" y="16812"/>
                        <a:pt x="357852" y="25861"/>
                      </a:cubicBezTo>
                      <a:lnTo>
                        <a:pt x="375949" y="29918"/>
                      </a:lnTo>
                      <a:cubicBezTo>
                        <a:pt x="376211" y="30016"/>
                        <a:pt x="376478" y="30099"/>
                        <a:pt x="376749" y="30166"/>
                      </a:cubicBezTo>
                      <a:cubicBezTo>
                        <a:pt x="382393" y="31578"/>
                        <a:pt x="387434" y="34763"/>
                        <a:pt x="391132" y="39253"/>
                      </a:cubicBezTo>
                      <a:lnTo>
                        <a:pt x="469323" y="134817"/>
                      </a:lnTo>
                      <a:cubicBezTo>
                        <a:pt x="470174" y="135859"/>
                        <a:pt x="471235" y="136710"/>
                        <a:pt x="472438" y="137313"/>
                      </a:cubicBezTo>
                      <a:lnTo>
                        <a:pt x="556477" y="179327"/>
                      </a:lnTo>
                      <a:cubicBezTo>
                        <a:pt x="569346" y="185521"/>
                        <a:pt x="575667" y="200264"/>
                        <a:pt x="571279" y="213856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317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</p:grpSp>
          <p:grpSp>
            <p:nvGrpSpPr>
              <p:cNvPr id="25" name="Graphic 23" descr="Body builder outline">
                <a:extLst>
                  <a:ext uri="{FF2B5EF4-FFF2-40B4-BE49-F238E27FC236}">
                    <a16:creationId xmlns:a16="http://schemas.microsoft.com/office/drawing/2014/main" id="{DCF36CC2-1D78-9B9A-69EA-A985C7C5F542}"/>
                  </a:ext>
                </a:extLst>
              </p:cNvPr>
              <p:cNvGrpSpPr/>
              <p:nvPr/>
            </p:nvGrpSpPr>
            <p:grpSpPr>
              <a:xfrm>
                <a:off x="8914041" y="3720742"/>
                <a:ext cx="420721" cy="369332"/>
                <a:chOff x="6385314" y="4474207"/>
                <a:chExt cx="781051" cy="742950"/>
              </a:xfrm>
              <a:solidFill>
                <a:srgbClr val="000000"/>
              </a:solidFill>
            </p:grpSpPr>
            <p:sp>
              <p:nvSpPr>
                <p:cNvPr id="35" name="Freeform: Shape 34">
                  <a:extLst>
                    <a:ext uri="{FF2B5EF4-FFF2-40B4-BE49-F238E27FC236}">
                      <a16:creationId xmlns:a16="http://schemas.microsoft.com/office/drawing/2014/main" id="{B003BFF7-0908-20FA-B4CB-035354F7C802}"/>
                    </a:ext>
                  </a:extLst>
                </p:cNvPr>
                <p:cNvSpPr/>
                <p:nvPr/>
              </p:nvSpPr>
              <p:spPr>
                <a:xfrm>
                  <a:off x="6699625" y="4588602"/>
                  <a:ext cx="152400" cy="152398"/>
                </a:xfrm>
                <a:custGeom>
                  <a:avLst/>
                  <a:gdLst>
                    <a:gd name="connsiteX0" fmla="*/ 76200 w 152400"/>
                    <a:gd name="connsiteY0" fmla="*/ 152400 h 152399"/>
                    <a:gd name="connsiteX1" fmla="*/ 152400 w 152400"/>
                    <a:gd name="connsiteY1" fmla="*/ 76200 h 152399"/>
                    <a:gd name="connsiteX2" fmla="*/ 76200 w 152400"/>
                    <a:gd name="connsiteY2" fmla="*/ 0 h 152399"/>
                    <a:gd name="connsiteX3" fmla="*/ 0 w 152400"/>
                    <a:gd name="connsiteY3" fmla="*/ 76200 h 152399"/>
                    <a:gd name="connsiteX4" fmla="*/ 76200 w 152400"/>
                    <a:gd name="connsiteY4" fmla="*/ 152400 h 152399"/>
                    <a:gd name="connsiteX5" fmla="*/ 76200 w 152400"/>
                    <a:gd name="connsiteY5" fmla="*/ 19050 h 152399"/>
                    <a:gd name="connsiteX6" fmla="*/ 133350 w 152400"/>
                    <a:gd name="connsiteY6" fmla="*/ 76200 h 152399"/>
                    <a:gd name="connsiteX7" fmla="*/ 76200 w 152400"/>
                    <a:gd name="connsiteY7" fmla="*/ 133350 h 152399"/>
                    <a:gd name="connsiteX8" fmla="*/ 19050 w 152400"/>
                    <a:gd name="connsiteY8" fmla="*/ 76200 h 152399"/>
                    <a:gd name="connsiteX9" fmla="*/ 76200 w 152400"/>
                    <a:gd name="connsiteY9" fmla="*/ 19012 h 152399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</a:cxnLst>
                  <a:rect l="l" t="t" r="r" b="b"/>
                  <a:pathLst>
                    <a:path w="152400" h="152399">
                      <a:moveTo>
                        <a:pt x="76200" y="152400"/>
                      </a:moveTo>
                      <a:cubicBezTo>
                        <a:pt x="118284" y="152400"/>
                        <a:pt x="152400" y="118284"/>
                        <a:pt x="152400" y="76200"/>
                      </a:cubicBezTo>
                      <a:cubicBezTo>
                        <a:pt x="152400" y="34116"/>
                        <a:pt x="118284" y="0"/>
                        <a:pt x="76200" y="0"/>
                      </a:cubicBezTo>
                      <a:cubicBezTo>
                        <a:pt x="34116" y="0"/>
                        <a:pt x="0" y="34116"/>
                        <a:pt x="0" y="76200"/>
                      </a:cubicBezTo>
                      <a:cubicBezTo>
                        <a:pt x="0" y="118284"/>
                        <a:pt x="34116" y="152400"/>
                        <a:pt x="76200" y="152400"/>
                      </a:cubicBezTo>
                      <a:close/>
                      <a:moveTo>
                        <a:pt x="76200" y="19050"/>
                      </a:moveTo>
                      <a:cubicBezTo>
                        <a:pt x="107763" y="19050"/>
                        <a:pt x="133350" y="44637"/>
                        <a:pt x="133350" y="76200"/>
                      </a:cubicBezTo>
                      <a:cubicBezTo>
                        <a:pt x="133350" y="107763"/>
                        <a:pt x="107763" y="133350"/>
                        <a:pt x="76200" y="133350"/>
                      </a:cubicBezTo>
                      <a:cubicBezTo>
                        <a:pt x="44637" y="133350"/>
                        <a:pt x="19050" y="107763"/>
                        <a:pt x="19050" y="76200"/>
                      </a:cubicBezTo>
                      <a:cubicBezTo>
                        <a:pt x="19071" y="44640"/>
                        <a:pt x="44640" y="19054"/>
                        <a:pt x="76200" y="19012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9525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/>
                </a:p>
              </p:txBody>
            </p:sp>
            <p:sp>
              <p:nvSpPr>
                <p:cNvPr id="36" name="Freeform: Shape 35">
                  <a:extLst>
                    <a:ext uri="{FF2B5EF4-FFF2-40B4-BE49-F238E27FC236}">
                      <a16:creationId xmlns:a16="http://schemas.microsoft.com/office/drawing/2014/main" id="{EF421787-12B2-4844-A3B2-6099BD6C1789}"/>
                    </a:ext>
                  </a:extLst>
                </p:cNvPr>
                <p:cNvSpPr/>
                <p:nvPr/>
              </p:nvSpPr>
              <p:spPr>
                <a:xfrm>
                  <a:off x="6385314" y="4474207"/>
                  <a:ext cx="781051" cy="742950"/>
                </a:xfrm>
                <a:custGeom>
                  <a:avLst/>
                  <a:gdLst>
                    <a:gd name="connsiteX0" fmla="*/ 771525 w 781050"/>
                    <a:gd name="connsiteY0" fmla="*/ 76200 h 742950"/>
                    <a:gd name="connsiteX1" fmla="*/ 752475 w 781050"/>
                    <a:gd name="connsiteY1" fmla="*/ 76200 h 742950"/>
                    <a:gd name="connsiteX2" fmla="*/ 752475 w 781050"/>
                    <a:gd name="connsiteY2" fmla="*/ 56197 h 742950"/>
                    <a:gd name="connsiteX3" fmla="*/ 724853 w 781050"/>
                    <a:gd name="connsiteY3" fmla="*/ 28575 h 742950"/>
                    <a:gd name="connsiteX4" fmla="*/ 722948 w 781050"/>
                    <a:gd name="connsiteY4" fmla="*/ 28575 h 742950"/>
                    <a:gd name="connsiteX5" fmla="*/ 714375 w 781050"/>
                    <a:gd name="connsiteY5" fmla="*/ 30070 h 742950"/>
                    <a:gd name="connsiteX6" fmla="*/ 714375 w 781050"/>
                    <a:gd name="connsiteY6" fmla="*/ 27622 h 742950"/>
                    <a:gd name="connsiteX7" fmla="*/ 686753 w 781050"/>
                    <a:gd name="connsiteY7" fmla="*/ 0 h 742950"/>
                    <a:gd name="connsiteX8" fmla="*/ 684848 w 781050"/>
                    <a:gd name="connsiteY8" fmla="*/ 0 h 742950"/>
                    <a:gd name="connsiteX9" fmla="*/ 657225 w 781050"/>
                    <a:gd name="connsiteY9" fmla="*/ 27622 h 742950"/>
                    <a:gd name="connsiteX10" fmla="*/ 657225 w 781050"/>
                    <a:gd name="connsiteY10" fmla="*/ 76200 h 742950"/>
                    <a:gd name="connsiteX11" fmla="*/ 123825 w 781050"/>
                    <a:gd name="connsiteY11" fmla="*/ 76200 h 742950"/>
                    <a:gd name="connsiteX12" fmla="*/ 123825 w 781050"/>
                    <a:gd name="connsiteY12" fmla="*/ 27622 h 742950"/>
                    <a:gd name="connsiteX13" fmla="*/ 96203 w 781050"/>
                    <a:gd name="connsiteY13" fmla="*/ 0 h 742950"/>
                    <a:gd name="connsiteX14" fmla="*/ 94298 w 781050"/>
                    <a:gd name="connsiteY14" fmla="*/ 0 h 742950"/>
                    <a:gd name="connsiteX15" fmla="*/ 66675 w 781050"/>
                    <a:gd name="connsiteY15" fmla="*/ 27622 h 742950"/>
                    <a:gd name="connsiteX16" fmla="*/ 66675 w 781050"/>
                    <a:gd name="connsiteY16" fmla="*/ 30070 h 742950"/>
                    <a:gd name="connsiteX17" fmla="*/ 58103 w 781050"/>
                    <a:gd name="connsiteY17" fmla="*/ 28575 h 742950"/>
                    <a:gd name="connsiteX18" fmla="*/ 56197 w 781050"/>
                    <a:gd name="connsiteY18" fmla="*/ 28575 h 742950"/>
                    <a:gd name="connsiteX19" fmla="*/ 28575 w 781050"/>
                    <a:gd name="connsiteY19" fmla="*/ 56197 h 742950"/>
                    <a:gd name="connsiteX20" fmla="*/ 28575 w 781050"/>
                    <a:gd name="connsiteY20" fmla="*/ 76200 h 742950"/>
                    <a:gd name="connsiteX21" fmla="*/ 9525 w 781050"/>
                    <a:gd name="connsiteY21" fmla="*/ 76200 h 742950"/>
                    <a:gd name="connsiteX22" fmla="*/ 0 w 781050"/>
                    <a:gd name="connsiteY22" fmla="*/ 85725 h 742950"/>
                    <a:gd name="connsiteX23" fmla="*/ 9525 w 781050"/>
                    <a:gd name="connsiteY23" fmla="*/ 95250 h 742950"/>
                    <a:gd name="connsiteX24" fmla="*/ 28575 w 781050"/>
                    <a:gd name="connsiteY24" fmla="*/ 95250 h 742950"/>
                    <a:gd name="connsiteX25" fmla="*/ 28575 w 781050"/>
                    <a:gd name="connsiteY25" fmla="*/ 115253 h 742950"/>
                    <a:gd name="connsiteX26" fmla="*/ 56197 w 781050"/>
                    <a:gd name="connsiteY26" fmla="*/ 142875 h 742950"/>
                    <a:gd name="connsiteX27" fmla="*/ 58103 w 781050"/>
                    <a:gd name="connsiteY27" fmla="*/ 142875 h 742950"/>
                    <a:gd name="connsiteX28" fmla="*/ 66675 w 781050"/>
                    <a:gd name="connsiteY28" fmla="*/ 141380 h 742950"/>
                    <a:gd name="connsiteX29" fmla="*/ 66675 w 781050"/>
                    <a:gd name="connsiteY29" fmla="*/ 143828 h 742950"/>
                    <a:gd name="connsiteX30" fmla="*/ 94298 w 781050"/>
                    <a:gd name="connsiteY30" fmla="*/ 171450 h 742950"/>
                    <a:gd name="connsiteX31" fmla="*/ 96203 w 781050"/>
                    <a:gd name="connsiteY31" fmla="*/ 171450 h 742950"/>
                    <a:gd name="connsiteX32" fmla="*/ 123825 w 781050"/>
                    <a:gd name="connsiteY32" fmla="*/ 143828 h 742950"/>
                    <a:gd name="connsiteX33" fmla="*/ 123825 w 781050"/>
                    <a:gd name="connsiteY33" fmla="*/ 95250 h 742950"/>
                    <a:gd name="connsiteX34" fmla="*/ 168726 w 781050"/>
                    <a:gd name="connsiteY34" fmla="*/ 95250 h 742950"/>
                    <a:gd name="connsiteX35" fmla="*/ 168726 w 781050"/>
                    <a:gd name="connsiteY35" fmla="*/ 253003 h 742950"/>
                    <a:gd name="connsiteX36" fmla="*/ 191891 w 781050"/>
                    <a:gd name="connsiteY36" fmla="*/ 293075 h 742950"/>
                    <a:gd name="connsiteX37" fmla="*/ 304800 w 781050"/>
                    <a:gd name="connsiteY37" fmla="*/ 359626 h 742950"/>
                    <a:gd name="connsiteX38" fmla="*/ 304800 w 781050"/>
                    <a:gd name="connsiteY38" fmla="*/ 453923 h 742950"/>
                    <a:gd name="connsiteX39" fmla="*/ 189986 w 781050"/>
                    <a:gd name="connsiteY39" fmla="*/ 528218 h 742950"/>
                    <a:gd name="connsiteX40" fmla="*/ 168726 w 781050"/>
                    <a:gd name="connsiteY40" fmla="*/ 567271 h 742950"/>
                    <a:gd name="connsiteX41" fmla="*/ 168726 w 781050"/>
                    <a:gd name="connsiteY41" fmla="*/ 742950 h 742950"/>
                    <a:gd name="connsiteX42" fmla="*/ 252193 w 781050"/>
                    <a:gd name="connsiteY42" fmla="*/ 742950 h 742950"/>
                    <a:gd name="connsiteX43" fmla="*/ 252193 w 781050"/>
                    <a:gd name="connsiteY43" fmla="*/ 592636 h 742950"/>
                    <a:gd name="connsiteX44" fmla="*/ 319421 w 781050"/>
                    <a:gd name="connsiteY44" fmla="*/ 549088 h 742950"/>
                    <a:gd name="connsiteX45" fmla="*/ 461677 w 781050"/>
                    <a:gd name="connsiteY45" fmla="*/ 549088 h 742950"/>
                    <a:gd name="connsiteX46" fmla="*/ 528904 w 781050"/>
                    <a:gd name="connsiteY46" fmla="*/ 592636 h 742950"/>
                    <a:gd name="connsiteX47" fmla="*/ 528904 w 781050"/>
                    <a:gd name="connsiteY47" fmla="*/ 742950 h 742950"/>
                    <a:gd name="connsiteX48" fmla="*/ 612372 w 781050"/>
                    <a:gd name="connsiteY48" fmla="*/ 742950 h 742950"/>
                    <a:gd name="connsiteX49" fmla="*/ 612372 w 781050"/>
                    <a:gd name="connsiteY49" fmla="*/ 567299 h 742950"/>
                    <a:gd name="connsiteX50" fmla="*/ 591112 w 781050"/>
                    <a:gd name="connsiteY50" fmla="*/ 528247 h 742950"/>
                    <a:gd name="connsiteX51" fmla="*/ 476298 w 781050"/>
                    <a:gd name="connsiteY51" fmla="*/ 453952 h 742950"/>
                    <a:gd name="connsiteX52" fmla="*/ 476298 w 781050"/>
                    <a:gd name="connsiteY52" fmla="*/ 359654 h 742950"/>
                    <a:gd name="connsiteX53" fmla="*/ 589131 w 781050"/>
                    <a:gd name="connsiteY53" fmla="*/ 293141 h 742950"/>
                    <a:gd name="connsiteX54" fmla="*/ 612372 w 781050"/>
                    <a:gd name="connsiteY54" fmla="*/ 253003 h 742950"/>
                    <a:gd name="connsiteX55" fmla="*/ 612372 w 781050"/>
                    <a:gd name="connsiteY55" fmla="*/ 95250 h 742950"/>
                    <a:gd name="connsiteX56" fmla="*/ 657225 w 781050"/>
                    <a:gd name="connsiteY56" fmla="*/ 95250 h 742950"/>
                    <a:gd name="connsiteX57" fmla="*/ 657225 w 781050"/>
                    <a:gd name="connsiteY57" fmla="*/ 143828 h 742950"/>
                    <a:gd name="connsiteX58" fmla="*/ 684848 w 781050"/>
                    <a:gd name="connsiteY58" fmla="*/ 171450 h 742950"/>
                    <a:gd name="connsiteX59" fmla="*/ 686753 w 781050"/>
                    <a:gd name="connsiteY59" fmla="*/ 171450 h 742950"/>
                    <a:gd name="connsiteX60" fmla="*/ 714375 w 781050"/>
                    <a:gd name="connsiteY60" fmla="*/ 143828 h 742950"/>
                    <a:gd name="connsiteX61" fmla="*/ 714375 w 781050"/>
                    <a:gd name="connsiteY61" fmla="*/ 141380 h 742950"/>
                    <a:gd name="connsiteX62" fmla="*/ 722948 w 781050"/>
                    <a:gd name="connsiteY62" fmla="*/ 142875 h 742950"/>
                    <a:gd name="connsiteX63" fmla="*/ 724853 w 781050"/>
                    <a:gd name="connsiteY63" fmla="*/ 142875 h 742950"/>
                    <a:gd name="connsiteX64" fmla="*/ 752475 w 781050"/>
                    <a:gd name="connsiteY64" fmla="*/ 115253 h 742950"/>
                    <a:gd name="connsiteX65" fmla="*/ 752475 w 781050"/>
                    <a:gd name="connsiteY65" fmla="*/ 95250 h 742950"/>
                    <a:gd name="connsiteX66" fmla="*/ 771525 w 781050"/>
                    <a:gd name="connsiteY66" fmla="*/ 95250 h 742950"/>
                    <a:gd name="connsiteX67" fmla="*/ 781050 w 781050"/>
                    <a:gd name="connsiteY67" fmla="*/ 85725 h 742950"/>
                    <a:gd name="connsiteX68" fmla="*/ 771525 w 781050"/>
                    <a:gd name="connsiteY68" fmla="*/ 76200 h 742950"/>
                    <a:gd name="connsiteX69" fmla="*/ 58103 w 781050"/>
                    <a:gd name="connsiteY69" fmla="*/ 123825 h 742950"/>
                    <a:gd name="connsiteX70" fmla="*/ 56197 w 781050"/>
                    <a:gd name="connsiteY70" fmla="*/ 123825 h 742950"/>
                    <a:gd name="connsiteX71" fmla="*/ 47625 w 781050"/>
                    <a:gd name="connsiteY71" fmla="*/ 115253 h 742950"/>
                    <a:gd name="connsiteX72" fmla="*/ 47625 w 781050"/>
                    <a:gd name="connsiteY72" fmla="*/ 56197 h 742950"/>
                    <a:gd name="connsiteX73" fmla="*/ 56197 w 781050"/>
                    <a:gd name="connsiteY73" fmla="*/ 47625 h 742950"/>
                    <a:gd name="connsiteX74" fmla="*/ 58103 w 781050"/>
                    <a:gd name="connsiteY74" fmla="*/ 47625 h 742950"/>
                    <a:gd name="connsiteX75" fmla="*/ 66675 w 781050"/>
                    <a:gd name="connsiteY75" fmla="*/ 56197 h 742950"/>
                    <a:gd name="connsiteX76" fmla="*/ 66675 w 781050"/>
                    <a:gd name="connsiteY76" fmla="*/ 115253 h 742950"/>
                    <a:gd name="connsiteX77" fmla="*/ 58103 w 781050"/>
                    <a:gd name="connsiteY77" fmla="*/ 123825 h 742950"/>
                    <a:gd name="connsiteX78" fmla="*/ 104775 w 781050"/>
                    <a:gd name="connsiteY78" fmla="*/ 143828 h 742950"/>
                    <a:gd name="connsiteX79" fmla="*/ 96203 w 781050"/>
                    <a:gd name="connsiteY79" fmla="*/ 152400 h 742950"/>
                    <a:gd name="connsiteX80" fmla="*/ 94298 w 781050"/>
                    <a:gd name="connsiteY80" fmla="*/ 152400 h 742950"/>
                    <a:gd name="connsiteX81" fmla="*/ 85725 w 781050"/>
                    <a:gd name="connsiteY81" fmla="*/ 143828 h 742950"/>
                    <a:gd name="connsiteX82" fmla="*/ 85725 w 781050"/>
                    <a:gd name="connsiteY82" fmla="*/ 27622 h 742950"/>
                    <a:gd name="connsiteX83" fmla="*/ 94298 w 781050"/>
                    <a:gd name="connsiteY83" fmla="*/ 19050 h 742950"/>
                    <a:gd name="connsiteX84" fmla="*/ 96203 w 781050"/>
                    <a:gd name="connsiteY84" fmla="*/ 19050 h 742950"/>
                    <a:gd name="connsiteX85" fmla="*/ 104775 w 781050"/>
                    <a:gd name="connsiteY85" fmla="*/ 27622 h 742950"/>
                    <a:gd name="connsiteX86" fmla="*/ 528904 w 781050"/>
                    <a:gd name="connsiteY86" fmla="*/ 95250 h 742950"/>
                    <a:gd name="connsiteX87" fmla="*/ 528904 w 781050"/>
                    <a:gd name="connsiteY87" fmla="*/ 226352 h 742950"/>
                    <a:gd name="connsiteX88" fmla="*/ 421272 w 781050"/>
                    <a:gd name="connsiteY88" fmla="*/ 289674 h 742950"/>
                    <a:gd name="connsiteX89" fmla="*/ 359769 w 781050"/>
                    <a:gd name="connsiteY89" fmla="*/ 289674 h 742950"/>
                    <a:gd name="connsiteX90" fmla="*/ 252193 w 781050"/>
                    <a:gd name="connsiteY90" fmla="*/ 226352 h 742950"/>
                    <a:gd name="connsiteX91" fmla="*/ 252193 w 781050"/>
                    <a:gd name="connsiteY91" fmla="*/ 95250 h 742950"/>
                    <a:gd name="connsiteX92" fmla="*/ 593322 w 781050"/>
                    <a:gd name="connsiteY92" fmla="*/ 567299 h 742950"/>
                    <a:gd name="connsiteX93" fmla="*/ 593322 w 781050"/>
                    <a:gd name="connsiteY93" fmla="*/ 723900 h 742950"/>
                    <a:gd name="connsiteX94" fmla="*/ 547954 w 781050"/>
                    <a:gd name="connsiteY94" fmla="*/ 723900 h 742950"/>
                    <a:gd name="connsiteX95" fmla="*/ 547954 w 781050"/>
                    <a:gd name="connsiteY95" fmla="*/ 582273 h 742950"/>
                    <a:gd name="connsiteX96" fmla="*/ 467316 w 781050"/>
                    <a:gd name="connsiteY96" fmla="*/ 530038 h 742950"/>
                    <a:gd name="connsiteX97" fmla="*/ 313782 w 781050"/>
                    <a:gd name="connsiteY97" fmla="*/ 530038 h 742950"/>
                    <a:gd name="connsiteX98" fmla="*/ 233143 w 781050"/>
                    <a:gd name="connsiteY98" fmla="*/ 582273 h 742950"/>
                    <a:gd name="connsiteX99" fmla="*/ 233143 w 781050"/>
                    <a:gd name="connsiteY99" fmla="*/ 723900 h 742950"/>
                    <a:gd name="connsiteX100" fmla="*/ 187776 w 781050"/>
                    <a:gd name="connsiteY100" fmla="*/ 723900 h 742950"/>
                    <a:gd name="connsiteX101" fmla="*/ 187776 w 781050"/>
                    <a:gd name="connsiteY101" fmla="*/ 567299 h 742950"/>
                    <a:gd name="connsiteX102" fmla="*/ 200330 w 781050"/>
                    <a:gd name="connsiteY102" fmla="*/ 544230 h 742950"/>
                    <a:gd name="connsiteX103" fmla="*/ 328917 w 781050"/>
                    <a:gd name="connsiteY103" fmla="*/ 460981 h 742950"/>
                    <a:gd name="connsiteX104" fmla="*/ 452161 w 781050"/>
                    <a:gd name="connsiteY104" fmla="*/ 460981 h 742950"/>
                    <a:gd name="connsiteX105" fmla="*/ 580749 w 781050"/>
                    <a:gd name="connsiteY105" fmla="*/ 544230 h 742950"/>
                    <a:gd name="connsiteX106" fmla="*/ 593322 w 781050"/>
                    <a:gd name="connsiteY106" fmla="*/ 567299 h 742950"/>
                    <a:gd name="connsiteX107" fmla="*/ 457248 w 781050"/>
                    <a:gd name="connsiteY107" fmla="*/ 441960 h 742950"/>
                    <a:gd name="connsiteX108" fmla="*/ 323850 w 781050"/>
                    <a:gd name="connsiteY108" fmla="*/ 441960 h 742950"/>
                    <a:gd name="connsiteX109" fmla="*/ 323850 w 781050"/>
                    <a:gd name="connsiteY109" fmla="*/ 362502 h 742950"/>
                    <a:gd name="connsiteX110" fmla="*/ 323912 w 781050"/>
                    <a:gd name="connsiteY110" fmla="*/ 349127 h 742950"/>
                    <a:gd name="connsiteX111" fmla="*/ 321945 w 781050"/>
                    <a:gd name="connsiteY111" fmla="*/ 347605 h 742950"/>
                    <a:gd name="connsiteX112" fmla="*/ 201492 w 781050"/>
                    <a:gd name="connsiteY112" fmla="*/ 276616 h 742950"/>
                    <a:gd name="connsiteX113" fmla="*/ 187776 w 781050"/>
                    <a:gd name="connsiteY113" fmla="*/ 252974 h 742950"/>
                    <a:gd name="connsiteX114" fmla="*/ 187776 w 781050"/>
                    <a:gd name="connsiteY114" fmla="*/ 95250 h 742950"/>
                    <a:gd name="connsiteX115" fmla="*/ 233143 w 781050"/>
                    <a:gd name="connsiteY115" fmla="*/ 95250 h 742950"/>
                    <a:gd name="connsiteX116" fmla="*/ 233143 w 781050"/>
                    <a:gd name="connsiteY116" fmla="*/ 237249 h 742950"/>
                    <a:gd name="connsiteX117" fmla="*/ 354587 w 781050"/>
                    <a:gd name="connsiteY117" fmla="*/ 308686 h 742950"/>
                    <a:gd name="connsiteX118" fmla="*/ 426501 w 781050"/>
                    <a:gd name="connsiteY118" fmla="*/ 308686 h 742950"/>
                    <a:gd name="connsiteX119" fmla="*/ 547954 w 781050"/>
                    <a:gd name="connsiteY119" fmla="*/ 237249 h 742950"/>
                    <a:gd name="connsiteX120" fmla="*/ 547954 w 781050"/>
                    <a:gd name="connsiteY120" fmla="*/ 95250 h 742950"/>
                    <a:gd name="connsiteX121" fmla="*/ 593322 w 781050"/>
                    <a:gd name="connsiteY121" fmla="*/ 95250 h 742950"/>
                    <a:gd name="connsiteX122" fmla="*/ 593322 w 781050"/>
                    <a:gd name="connsiteY122" fmla="*/ 252936 h 742950"/>
                    <a:gd name="connsiteX123" fmla="*/ 579530 w 781050"/>
                    <a:gd name="connsiteY123" fmla="*/ 276663 h 742950"/>
                    <a:gd name="connsiteX124" fmla="*/ 459372 w 781050"/>
                    <a:gd name="connsiteY124" fmla="*/ 347491 h 742950"/>
                    <a:gd name="connsiteX125" fmla="*/ 456000 w 781050"/>
                    <a:gd name="connsiteY125" fmla="*/ 360531 h 742950"/>
                    <a:gd name="connsiteX126" fmla="*/ 457248 w 781050"/>
                    <a:gd name="connsiteY126" fmla="*/ 361921 h 742950"/>
                    <a:gd name="connsiteX127" fmla="*/ 695325 w 781050"/>
                    <a:gd name="connsiteY127" fmla="*/ 143828 h 742950"/>
                    <a:gd name="connsiteX128" fmla="*/ 686753 w 781050"/>
                    <a:gd name="connsiteY128" fmla="*/ 152400 h 742950"/>
                    <a:gd name="connsiteX129" fmla="*/ 684848 w 781050"/>
                    <a:gd name="connsiteY129" fmla="*/ 152400 h 742950"/>
                    <a:gd name="connsiteX130" fmla="*/ 676275 w 781050"/>
                    <a:gd name="connsiteY130" fmla="*/ 143828 h 742950"/>
                    <a:gd name="connsiteX131" fmla="*/ 676275 w 781050"/>
                    <a:gd name="connsiteY131" fmla="*/ 27622 h 742950"/>
                    <a:gd name="connsiteX132" fmla="*/ 684848 w 781050"/>
                    <a:gd name="connsiteY132" fmla="*/ 19050 h 742950"/>
                    <a:gd name="connsiteX133" fmla="*/ 686753 w 781050"/>
                    <a:gd name="connsiteY133" fmla="*/ 19050 h 742950"/>
                    <a:gd name="connsiteX134" fmla="*/ 695325 w 781050"/>
                    <a:gd name="connsiteY134" fmla="*/ 27622 h 742950"/>
                    <a:gd name="connsiteX135" fmla="*/ 695325 w 781050"/>
                    <a:gd name="connsiteY135" fmla="*/ 143828 h 742950"/>
                    <a:gd name="connsiteX136" fmla="*/ 733425 w 781050"/>
                    <a:gd name="connsiteY136" fmla="*/ 115253 h 742950"/>
                    <a:gd name="connsiteX137" fmla="*/ 724853 w 781050"/>
                    <a:gd name="connsiteY137" fmla="*/ 123825 h 742950"/>
                    <a:gd name="connsiteX138" fmla="*/ 722948 w 781050"/>
                    <a:gd name="connsiteY138" fmla="*/ 123825 h 742950"/>
                    <a:gd name="connsiteX139" fmla="*/ 714375 w 781050"/>
                    <a:gd name="connsiteY139" fmla="*/ 115253 h 742950"/>
                    <a:gd name="connsiteX140" fmla="*/ 714375 w 781050"/>
                    <a:gd name="connsiteY140" fmla="*/ 56197 h 742950"/>
                    <a:gd name="connsiteX141" fmla="*/ 722948 w 781050"/>
                    <a:gd name="connsiteY141" fmla="*/ 47625 h 742950"/>
                    <a:gd name="connsiteX142" fmla="*/ 724853 w 781050"/>
                    <a:gd name="connsiteY142" fmla="*/ 47625 h 742950"/>
                    <a:gd name="connsiteX143" fmla="*/ 733425 w 781050"/>
                    <a:gd name="connsiteY143" fmla="*/ 56197 h 7429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  <a:cxn ang="0">
                      <a:pos x="connsiteX138" y="connsiteY138"/>
                    </a:cxn>
                    <a:cxn ang="0">
                      <a:pos x="connsiteX139" y="connsiteY139"/>
                    </a:cxn>
                    <a:cxn ang="0">
                      <a:pos x="connsiteX140" y="connsiteY140"/>
                    </a:cxn>
                    <a:cxn ang="0">
                      <a:pos x="connsiteX141" y="connsiteY141"/>
                    </a:cxn>
                    <a:cxn ang="0">
                      <a:pos x="connsiteX142" y="connsiteY142"/>
                    </a:cxn>
                    <a:cxn ang="0">
                      <a:pos x="connsiteX143" y="connsiteY143"/>
                    </a:cxn>
                  </a:cxnLst>
                  <a:rect l="l" t="t" r="r" b="b"/>
                  <a:pathLst>
                    <a:path w="781050" h="742950">
                      <a:moveTo>
                        <a:pt x="771525" y="76200"/>
                      </a:moveTo>
                      <a:lnTo>
                        <a:pt x="752475" y="76200"/>
                      </a:lnTo>
                      <a:lnTo>
                        <a:pt x="752475" y="56197"/>
                      </a:lnTo>
                      <a:cubicBezTo>
                        <a:pt x="752475" y="40942"/>
                        <a:pt x="740108" y="28575"/>
                        <a:pt x="724853" y="28575"/>
                      </a:cubicBezTo>
                      <a:lnTo>
                        <a:pt x="722948" y="28575"/>
                      </a:lnTo>
                      <a:cubicBezTo>
                        <a:pt x="720028" y="28611"/>
                        <a:pt x="717133" y="29116"/>
                        <a:pt x="714375" y="30070"/>
                      </a:cubicBezTo>
                      <a:lnTo>
                        <a:pt x="714375" y="27622"/>
                      </a:lnTo>
                      <a:cubicBezTo>
                        <a:pt x="714375" y="12367"/>
                        <a:pt x="702008" y="0"/>
                        <a:pt x="686753" y="0"/>
                      </a:cubicBezTo>
                      <a:lnTo>
                        <a:pt x="684848" y="0"/>
                      </a:lnTo>
                      <a:cubicBezTo>
                        <a:pt x="669592" y="0"/>
                        <a:pt x="657225" y="12367"/>
                        <a:pt x="657225" y="27622"/>
                      </a:cubicBezTo>
                      <a:lnTo>
                        <a:pt x="657225" y="76200"/>
                      </a:lnTo>
                      <a:lnTo>
                        <a:pt x="123825" y="76200"/>
                      </a:lnTo>
                      <a:lnTo>
                        <a:pt x="123825" y="27622"/>
                      </a:lnTo>
                      <a:cubicBezTo>
                        <a:pt x="123825" y="12367"/>
                        <a:pt x="111458" y="0"/>
                        <a:pt x="96203" y="0"/>
                      </a:cubicBezTo>
                      <a:lnTo>
                        <a:pt x="94298" y="0"/>
                      </a:lnTo>
                      <a:cubicBezTo>
                        <a:pt x="79042" y="0"/>
                        <a:pt x="66675" y="12367"/>
                        <a:pt x="66675" y="27622"/>
                      </a:cubicBezTo>
                      <a:lnTo>
                        <a:pt x="66675" y="30070"/>
                      </a:lnTo>
                      <a:cubicBezTo>
                        <a:pt x="63917" y="29116"/>
                        <a:pt x="61022" y="28611"/>
                        <a:pt x="58103" y="28575"/>
                      </a:cubicBezTo>
                      <a:lnTo>
                        <a:pt x="56197" y="28575"/>
                      </a:lnTo>
                      <a:cubicBezTo>
                        <a:pt x="40942" y="28575"/>
                        <a:pt x="28575" y="40942"/>
                        <a:pt x="28575" y="56197"/>
                      </a:cubicBezTo>
                      <a:lnTo>
                        <a:pt x="28575" y="76200"/>
                      </a:lnTo>
                      <a:lnTo>
                        <a:pt x="9525" y="76200"/>
                      </a:lnTo>
                      <a:cubicBezTo>
                        <a:pt x="4265" y="76200"/>
                        <a:pt x="0" y="80464"/>
                        <a:pt x="0" y="85725"/>
                      </a:cubicBezTo>
                      <a:cubicBezTo>
                        <a:pt x="0" y="90986"/>
                        <a:pt x="4265" y="95250"/>
                        <a:pt x="9525" y="95250"/>
                      </a:cubicBezTo>
                      <a:lnTo>
                        <a:pt x="28575" y="95250"/>
                      </a:lnTo>
                      <a:lnTo>
                        <a:pt x="28575" y="115253"/>
                      </a:lnTo>
                      <a:cubicBezTo>
                        <a:pt x="28575" y="130508"/>
                        <a:pt x="40942" y="142875"/>
                        <a:pt x="56197" y="142875"/>
                      </a:cubicBezTo>
                      <a:lnTo>
                        <a:pt x="58103" y="142875"/>
                      </a:lnTo>
                      <a:cubicBezTo>
                        <a:pt x="61022" y="142839"/>
                        <a:pt x="63917" y="142334"/>
                        <a:pt x="66675" y="141380"/>
                      </a:cubicBezTo>
                      <a:lnTo>
                        <a:pt x="66675" y="143828"/>
                      </a:lnTo>
                      <a:cubicBezTo>
                        <a:pt x="66675" y="159083"/>
                        <a:pt x="79042" y="171450"/>
                        <a:pt x="94298" y="171450"/>
                      </a:cubicBezTo>
                      <a:lnTo>
                        <a:pt x="96203" y="171450"/>
                      </a:lnTo>
                      <a:cubicBezTo>
                        <a:pt x="111458" y="171450"/>
                        <a:pt x="123825" y="159083"/>
                        <a:pt x="123825" y="143828"/>
                      </a:cubicBezTo>
                      <a:lnTo>
                        <a:pt x="123825" y="95250"/>
                      </a:lnTo>
                      <a:lnTo>
                        <a:pt x="168726" y="95250"/>
                      </a:lnTo>
                      <a:lnTo>
                        <a:pt x="168726" y="253003"/>
                      </a:lnTo>
                      <a:cubicBezTo>
                        <a:pt x="168813" y="269518"/>
                        <a:pt x="177623" y="284757"/>
                        <a:pt x="191891" y="293075"/>
                      </a:cubicBezTo>
                      <a:lnTo>
                        <a:pt x="304800" y="359626"/>
                      </a:lnTo>
                      <a:lnTo>
                        <a:pt x="304800" y="453923"/>
                      </a:lnTo>
                      <a:lnTo>
                        <a:pt x="189986" y="528218"/>
                      </a:lnTo>
                      <a:cubicBezTo>
                        <a:pt x="176709" y="536764"/>
                        <a:pt x="168696" y="551481"/>
                        <a:pt x="168726" y="567271"/>
                      </a:cubicBezTo>
                      <a:lnTo>
                        <a:pt x="168726" y="742950"/>
                      </a:lnTo>
                      <a:lnTo>
                        <a:pt x="252193" y="742950"/>
                      </a:lnTo>
                      <a:lnTo>
                        <a:pt x="252193" y="592636"/>
                      </a:lnTo>
                      <a:lnTo>
                        <a:pt x="319421" y="549088"/>
                      </a:lnTo>
                      <a:lnTo>
                        <a:pt x="461677" y="549088"/>
                      </a:lnTo>
                      <a:lnTo>
                        <a:pt x="528904" y="592636"/>
                      </a:lnTo>
                      <a:lnTo>
                        <a:pt x="528904" y="742950"/>
                      </a:lnTo>
                      <a:lnTo>
                        <a:pt x="612372" y="742950"/>
                      </a:lnTo>
                      <a:lnTo>
                        <a:pt x="612372" y="567299"/>
                      </a:lnTo>
                      <a:cubicBezTo>
                        <a:pt x="612401" y="551510"/>
                        <a:pt x="604389" y="536793"/>
                        <a:pt x="591112" y="528247"/>
                      </a:cubicBezTo>
                      <a:lnTo>
                        <a:pt x="476298" y="453952"/>
                      </a:lnTo>
                      <a:lnTo>
                        <a:pt x="476298" y="359654"/>
                      </a:lnTo>
                      <a:lnTo>
                        <a:pt x="589131" y="293141"/>
                      </a:lnTo>
                      <a:cubicBezTo>
                        <a:pt x="603448" y="284831"/>
                        <a:pt x="612292" y="269558"/>
                        <a:pt x="612372" y="253003"/>
                      </a:cubicBezTo>
                      <a:lnTo>
                        <a:pt x="612372" y="95250"/>
                      </a:lnTo>
                      <a:lnTo>
                        <a:pt x="657225" y="95250"/>
                      </a:lnTo>
                      <a:lnTo>
                        <a:pt x="657225" y="143828"/>
                      </a:lnTo>
                      <a:cubicBezTo>
                        <a:pt x="657225" y="159083"/>
                        <a:pt x="669592" y="171450"/>
                        <a:pt x="684848" y="171450"/>
                      </a:cubicBezTo>
                      <a:lnTo>
                        <a:pt x="686753" y="171450"/>
                      </a:lnTo>
                      <a:cubicBezTo>
                        <a:pt x="702008" y="171450"/>
                        <a:pt x="714375" y="159083"/>
                        <a:pt x="714375" y="143828"/>
                      </a:cubicBezTo>
                      <a:lnTo>
                        <a:pt x="714375" y="141380"/>
                      </a:lnTo>
                      <a:cubicBezTo>
                        <a:pt x="717133" y="142334"/>
                        <a:pt x="720028" y="142839"/>
                        <a:pt x="722948" y="142875"/>
                      </a:cubicBezTo>
                      <a:lnTo>
                        <a:pt x="724853" y="142875"/>
                      </a:lnTo>
                      <a:cubicBezTo>
                        <a:pt x="740108" y="142875"/>
                        <a:pt x="752475" y="130508"/>
                        <a:pt x="752475" y="115253"/>
                      </a:cubicBezTo>
                      <a:lnTo>
                        <a:pt x="752475" y="95250"/>
                      </a:lnTo>
                      <a:lnTo>
                        <a:pt x="771525" y="95250"/>
                      </a:lnTo>
                      <a:cubicBezTo>
                        <a:pt x="776786" y="95250"/>
                        <a:pt x="781050" y="90986"/>
                        <a:pt x="781050" y="85725"/>
                      </a:cubicBezTo>
                      <a:cubicBezTo>
                        <a:pt x="781050" y="80464"/>
                        <a:pt x="776786" y="76200"/>
                        <a:pt x="771525" y="76200"/>
                      </a:cubicBezTo>
                      <a:close/>
                      <a:moveTo>
                        <a:pt x="58103" y="123825"/>
                      </a:moveTo>
                      <a:lnTo>
                        <a:pt x="56197" y="123825"/>
                      </a:lnTo>
                      <a:cubicBezTo>
                        <a:pt x="51463" y="123825"/>
                        <a:pt x="47625" y="119987"/>
                        <a:pt x="47625" y="115253"/>
                      </a:cubicBezTo>
                      <a:lnTo>
                        <a:pt x="47625" y="56197"/>
                      </a:lnTo>
                      <a:cubicBezTo>
                        <a:pt x="47625" y="51463"/>
                        <a:pt x="51463" y="47625"/>
                        <a:pt x="56197" y="47625"/>
                      </a:cubicBezTo>
                      <a:lnTo>
                        <a:pt x="58103" y="47625"/>
                      </a:lnTo>
                      <a:cubicBezTo>
                        <a:pt x="62837" y="47625"/>
                        <a:pt x="66675" y="51463"/>
                        <a:pt x="66675" y="56197"/>
                      </a:cubicBezTo>
                      <a:lnTo>
                        <a:pt x="66675" y="115253"/>
                      </a:lnTo>
                      <a:cubicBezTo>
                        <a:pt x="66675" y="119987"/>
                        <a:pt x="62837" y="123825"/>
                        <a:pt x="58103" y="123825"/>
                      </a:cubicBezTo>
                      <a:close/>
                      <a:moveTo>
                        <a:pt x="104775" y="143828"/>
                      </a:moveTo>
                      <a:cubicBezTo>
                        <a:pt x="104775" y="148562"/>
                        <a:pt x="100937" y="152400"/>
                        <a:pt x="96203" y="152400"/>
                      </a:cubicBezTo>
                      <a:lnTo>
                        <a:pt x="94298" y="152400"/>
                      </a:lnTo>
                      <a:cubicBezTo>
                        <a:pt x="89563" y="152400"/>
                        <a:pt x="85725" y="148562"/>
                        <a:pt x="85725" y="143828"/>
                      </a:cubicBezTo>
                      <a:lnTo>
                        <a:pt x="85725" y="27622"/>
                      </a:lnTo>
                      <a:cubicBezTo>
                        <a:pt x="85725" y="22888"/>
                        <a:pt x="89563" y="19050"/>
                        <a:pt x="94298" y="19050"/>
                      </a:cubicBezTo>
                      <a:lnTo>
                        <a:pt x="96203" y="19050"/>
                      </a:lnTo>
                      <a:cubicBezTo>
                        <a:pt x="100937" y="19050"/>
                        <a:pt x="104775" y="22888"/>
                        <a:pt x="104775" y="27622"/>
                      </a:cubicBezTo>
                      <a:close/>
                      <a:moveTo>
                        <a:pt x="528904" y="95250"/>
                      </a:moveTo>
                      <a:lnTo>
                        <a:pt x="528904" y="226352"/>
                      </a:lnTo>
                      <a:lnTo>
                        <a:pt x="421272" y="289674"/>
                      </a:lnTo>
                      <a:lnTo>
                        <a:pt x="359769" y="289674"/>
                      </a:lnTo>
                      <a:lnTo>
                        <a:pt x="252193" y="226352"/>
                      </a:lnTo>
                      <a:lnTo>
                        <a:pt x="252193" y="95250"/>
                      </a:lnTo>
                      <a:close/>
                      <a:moveTo>
                        <a:pt x="593322" y="567299"/>
                      </a:moveTo>
                      <a:lnTo>
                        <a:pt x="593322" y="723900"/>
                      </a:lnTo>
                      <a:lnTo>
                        <a:pt x="547954" y="723900"/>
                      </a:lnTo>
                      <a:lnTo>
                        <a:pt x="547954" y="582273"/>
                      </a:lnTo>
                      <a:lnTo>
                        <a:pt x="467316" y="530038"/>
                      </a:lnTo>
                      <a:lnTo>
                        <a:pt x="313782" y="530038"/>
                      </a:lnTo>
                      <a:lnTo>
                        <a:pt x="233143" y="582273"/>
                      </a:lnTo>
                      <a:lnTo>
                        <a:pt x="233143" y="723900"/>
                      </a:lnTo>
                      <a:lnTo>
                        <a:pt x="187776" y="723900"/>
                      </a:lnTo>
                      <a:lnTo>
                        <a:pt x="187776" y="567299"/>
                      </a:lnTo>
                      <a:cubicBezTo>
                        <a:pt x="187764" y="557975"/>
                        <a:pt x="192494" y="549284"/>
                        <a:pt x="200330" y="544230"/>
                      </a:cubicBezTo>
                      <a:lnTo>
                        <a:pt x="328917" y="460981"/>
                      </a:lnTo>
                      <a:lnTo>
                        <a:pt x="452161" y="460981"/>
                      </a:lnTo>
                      <a:lnTo>
                        <a:pt x="580749" y="544230"/>
                      </a:lnTo>
                      <a:cubicBezTo>
                        <a:pt x="588597" y="549274"/>
                        <a:pt x="593336" y="557970"/>
                        <a:pt x="593322" y="567299"/>
                      </a:cubicBezTo>
                      <a:close/>
                      <a:moveTo>
                        <a:pt x="457248" y="441960"/>
                      </a:moveTo>
                      <a:lnTo>
                        <a:pt x="323850" y="441960"/>
                      </a:lnTo>
                      <a:lnTo>
                        <a:pt x="323850" y="362502"/>
                      </a:lnTo>
                      <a:cubicBezTo>
                        <a:pt x="327561" y="358826"/>
                        <a:pt x="327589" y="352837"/>
                        <a:pt x="323912" y="349127"/>
                      </a:cubicBezTo>
                      <a:cubicBezTo>
                        <a:pt x="323326" y="348535"/>
                        <a:pt x="322665" y="348024"/>
                        <a:pt x="321945" y="347605"/>
                      </a:cubicBezTo>
                      <a:lnTo>
                        <a:pt x="201492" y="276616"/>
                      </a:lnTo>
                      <a:cubicBezTo>
                        <a:pt x="193057" y="271719"/>
                        <a:pt x="187841" y="262727"/>
                        <a:pt x="187776" y="252974"/>
                      </a:cubicBezTo>
                      <a:lnTo>
                        <a:pt x="187776" y="95250"/>
                      </a:lnTo>
                      <a:lnTo>
                        <a:pt x="233143" y="95250"/>
                      </a:lnTo>
                      <a:lnTo>
                        <a:pt x="233143" y="237249"/>
                      </a:lnTo>
                      <a:lnTo>
                        <a:pt x="354587" y="308686"/>
                      </a:lnTo>
                      <a:lnTo>
                        <a:pt x="426501" y="308686"/>
                      </a:lnTo>
                      <a:lnTo>
                        <a:pt x="547954" y="237249"/>
                      </a:lnTo>
                      <a:lnTo>
                        <a:pt x="547954" y="95250"/>
                      </a:lnTo>
                      <a:lnTo>
                        <a:pt x="593322" y="95250"/>
                      </a:lnTo>
                      <a:lnTo>
                        <a:pt x="593322" y="252936"/>
                      </a:lnTo>
                      <a:cubicBezTo>
                        <a:pt x="593256" y="262731"/>
                        <a:pt x="588009" y="271759"/>
                        <a:pt x="579530" y="276663"/>
                      </a:cubicBezTo>
                      <a:lnTo>
                        <a:pt x="459372" y="347491"/>
                      </a:lnTo>
                      <a:cubicBezTo>
                        <a:pt x="454841" y="350161"/>
                        <a:pt x="453331" y="355999"/>
                        <a:pt x="456000" y="360531"/>
                      </a:cubicBezTo>
                      <a:cubicBezTo>
                        <a:pt x="456368" y="361036"/>
                        <a:pt x="456786" y="361501"/>
                        <a:pt x="457248" y="361921"/>
                      </a:cubicBezTo>
                      <a:close/>
                      <a:moveTo>
                        <a:pt x="695325" y="143828"/>
                      </a:moveTo>
                      <a:cubicBezTo>
                        <a:pt x="695325" y="148562"/>
                        <a:pt x="691487" y="152400"/>
                        <a:pt x="686753" y="152400"/>
                      </a:cubicBezTo>
                      <a:lnTo>
                        <a:pt x="684848" y="152400"/>
                      </a:lnTo>
                      <a:cubicBezTo>
                        <a:pt x="680113" y="152400"/>
                        <a:pt x="676275" y="148562"/>
                        <a:pt x="676275" y="143828"/>
                      </a:cubicBezTo>
                      <a:lnTo>
                        <a:pt x="676275" y="27622"/>
                      </a:lnTo>
                      <a:cubicBezTo>
                        <a:pt x="676275" y="22888"/>
                        <a:pt x="680113" y="19050"/>
                        <a:pt x="684848" y="19050"/>
                      </a:cubicBezTo>
                      <a:lnTo>
                        <a:pt x="686753" y="19050"/>
                      </a:lnTo>
                      <a:cubicBezTo>
                        <a:pt x="691487" y="19050"/>
                        <a:pt x="695325" y="22888"/>
                        <a:pt x="695325" y="27622"/>
                      </a:cubicBezTo>
                      <a:lnTo>
                        <a:pt x="695325" y="143828"/>
                      </a:lnTo>
                      <a:close/>
                      <a:moveTo>
                        <a:pt x="733425" y="115253"/>
                      </a:moveTo>
                      <a:cubicBezTo>
                        <a:pt x="733425" y="119987"/>
                        <a:pt x="729587" y="123825"/>
                        <a:pt x="724853" y="123825"/>
                      </a:cubicBezTo>
                      <a:lnTo>
                        <a:pt x="722948" y="123825"/>
                      </a:lnTo>
                      <a:cubicBezTo>
                        <a:pt x="718213" y="123825"/>
                        <a:pt x="714375" y="119987"/>
                        <a:pt x="714375" y="115253"/>
                      </a:cubicBezTo>
                      <a:lnTo>
                        <a:pt x="714375" y="56197"/>
                      </a:lnTo>
                      <a:cubicBezTo>
                        <a:pt x="714375" y="51463"/>
                        <a:pt x="718213" y="47625"/>
                        <a:pt x="722948" y="47625"/>
                      </a:cubicBezTo>
                      <a:lnTo>
                        <a:pt x="724853" y="47625"/>
                      </a:lnTo>
                      <a:cubicBezTo>
                        <a:pt x="729587" y="47625"/>
                        <a:pt x="733425" y="51463"/>
                        <a:pt x="733425" y="56197"/>
                      </a:cubicBezTo>
                      <a:close/>
                    </a:path>
                  </a:pathLst>
                </a:custGeom>
                <a:solidFill>
                  <a:schemeClr val="bg1"/>
                </a:solidFill>
                <a:ln w="6350" cap="flat">
                  <a:solidFill>
                    <a:schemeClr val="bg1"/>
                  </a:solidFill>
                  <a:prstDash val="solid"/>
                  <a:miter/>
                </a:ln>
              </p:spPr>
              <p:txBody>
                <a:bodyPr rtlCol="0" anchor="ctr"/>
                <a:lstStyle/>
                <a:p>
                  <a:endParaRPr lang="en-US" sz="1801" dirty="0"/>
                </a:p>
              </p:txBody>
            </p:sp>
          </p:grpSp>
          <p:pic>
            <p:nvPicPr>
              <p:cNvPr id="31" name="Graphic 30" descr="Run outline">
                <a:extLst>
                  <a:ext uri="{FF2B5EF4-FFF2-40B4-BE49-F238E27FC236}">
                    <a16:creationId xmlns:a16="http://schemas.microsoft.com/office/drawing/2014/main" id="{0323E4E5-05C6-A761-6C93-6BF609E2424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96DAC541-7B7A-43D3-8B79-37D633B846F1}">
                    <asvg:svgBlip xmlns:asvg="http://schemas.microsoft.com/office/drawing/2016/SVG/main" r:embed="rId15"/>
                  </a:ext>
                </a:extLst>
              </a:blip>
              <a:stretch>
                <a:fillRect/>
              </a:stretch>
            </p:blipFill>
            <p:spPr>
              <a:xfrm>
                <a:off x="9507991" y="3238745"/>
                <a:ext cx="457200" cy="457199"/>
              </a:xfrm>
              <a:prstGeom prst="rect">
                <a:avLst/>
              </a:prstGeom>
            </p:spPr>
          </p:pic>
          <p:pic>
            <p:nvPicPr>
              <p:cNvPr id="33" name="Graphic 32" descr="Cycling outline">
                <a:extLst>
                  <a:ext uri="{FF2B5EF4-FFF2-40B4-BE49-F238E27FC236}">
                    <a16:creationId xmlns:a16="http://schemas.microsoft.com/office/drawing/2014/main" id="{044566FF-8EB1-5603-5E00-507906E1DF4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96DAC541-7B7A-43D3-8B79-37D633B846F1}">
                    <asvg:svgBlip xmlns:asvg="http://schemas.microsoft.com/office/drawing/2016/SVG/main" r:embed="rId17"/>
                  </a:ext>
                </a:extLst>
              </a:blip>
              <a:stretch>
                <a:fillRect/>
              </a:stretch>
            </p:blipFill>
            <p:spPr>
              <a:xfrm>
                <a:off x="9513072" y="3986115"/>
                <a:ext cx="490460" cy="490461"/>
              </a:xfrm>
              <a:prstGeom prst="rect">
                <a:avLst/>
              </a:prstGeom>
            </p:spPr>
          </p:pic>
          <p:pic>
            <p:nvPicPr>
              <p:cNvPr id="34" name="Graphic 33" descr="Tennis outline">
                <a:extLst>
                  <a:ext uri="{FF2B5EF4-FFF2-40B4-BE49-F238E27FC236}">
                    <a16:creationId xmlns:a16="http://schemas.microsoft.com/office/drawing/2014/main" id="{06C553A3-A2AB-8A60-0820-517F061BF61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96DAC541-7B7A-43D3-8B79-37D633B846F1}">
                    <asvg:svgBlip xmlns:asvg="http://schemas.microsoft.com/office/drawing/2016/SVG/main" r:embed="rId19"/>
                  </a:ext>
                </a:extLst>
              </a:blip>
              <a:stretch>
                <a:fillRect/>
              </a:stretch>
            </p:blipFill>
            <p:spPr>
              <a:xfrm>
                <a:off x="9172156" y="4043245"/>
                <a:ext cx="457201" cy="457200"/>
              </a:xfrm>
              <a:prstGeom prst="rect">
                <a:avLst/>
              </a:prstGeom>
            </p:spPr>
          </p:pic>
        </p:grp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8356B2C4-C86C-1E98-52C6-4D850A7A23BA}"/>
              </a:ext>
            </a:extLst>
          </p:cNvPr>
          <p:cNvSpPr txBox="1"/>
          <p:nvPr/>
        </p:nvSpPr>
        <p:spPr>
          <a:xfrm>
            <a:off x="3578741" y="2934978"/>
            <a:ext cx="2123147" cy="369460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>
            <a:solidFill>
              <a:schemeClr val="tx2">
                <a:lumMod val="90000"/>
                <a:lumOff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1" dirty="0">
                <a:solidFill>
                  <a:schemeClr val="bg1"/>
                </a:solidFill>
              </a:rPr>
              <a:t>Interventio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2F1681D-A96D-9ECE-7F2F-E3912B23712D}"/>
              </a:ext>
            </a:extLst>
          </p:cNvPr>
          <p:cNvSpPr txBox="1"/>
          <p:nvPr/>
        </p:nvSpPr>
        <p:spPr>
          <a:xfrm>
            <a:off x="5772832" y="2921606"/>
            <a:ext cx="1674854" cy="369460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>
            <a:solidFill>
              <a:schemeClr val="tx2">
                <a:lumMod val="90000"/>
                <a:lumOff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801" dirty="0">
                <a:solidFill>
                  <a:schemeClr val="bg1"/>
                </a:solidFill>
              </a:rPr>
              <a:t>Comparator</a:t>
            </a:r>
          </a:p>
        </p:txBody>
      </p:sp>
      <p:sp>
        <p:nvSpPr>
          <p:cNvPr id="46" name="Multiplication Sign 45">
            <a:extLst>
              <a:ext uri="{FF2B5EF4-FFF2-40B4-BE49-F238E27FC236}">
                <a16:creationId xmlns:a16="http://schemas.microsoft.com/office/drawing/2014/main" id="{44DB192D-BD3F-ED70-7481-24CB14ECC73A}"/>
              </a:ext>
            </a:extLst>
          </p:cNvPr>
          <p:cNvSpPr/>
          <p:nvPr/>
        </p:nvSpPr>
        <p:spPr>
          <a:xfrm rot="2751992">
            <a:off x="4393361" y="3503762"/>
            <a:ext cx="384832" cy="369360"/>
          </a:xfrm>
          <a:prstGeom prst="mathMultiply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1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3755C7F-9166-9AC5-E34D-BF55594754B1}"/>
              </a:ext>
            </a:extLst>
          </p:cNvPr>
          <p:cNvSpPr txBox="1"/>
          <p:nvPr/>
        </p:nvSpPr>
        <p:spPr>
          <a:xfrm>
            <a:off x="4958452" y="4757348"/>
            <a:ext cx="2529103" cy="338554"/>
          </a:xfrm>
          <a:prstGeom prst="rect">
            <a:avLst/>
          </a:prstGeom>
          <a:solidFill>
            <a:schemeClr val="tx2">
              <a:lumMod val="90000"/>
              <a:lumOff val="10000"/>
            </a:schemeClr>
          </a:solidFill>
          <a:ln>
            <a:solidFill>
              <a:schemeClr val="tx2">
                <a:lumMod val="90000"/>
                <a:lumOff val="1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bg1"/>
                </a:solidFill>
              </a:rPr>
              <a:t>Secondary</a:t>
            </a:r>
            <a:endParaRPr lang="en-US" sz="1600" dirty="0">
              <a:solidFill>
                <a:schemeClr val="bg1"/>
              </a:solidFill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EA80032-9B0D-AC36-6533-AD9B9B1C90D9}"/>
              </a:ext>
            </a:extLst>
          </p:cNvPr>
          <p:cNvSpPr txBox="1"/>
          <p:nvPr/>
        </p:nvSpPr>
        <p:spPr>
          <a:xfrm>
            <a:off x="3766225" y="4044614"/>
            <a:ext cx="48327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LSI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4D82484-38F0-2750-5A67-C214AFEC230E}"/>
              </a:ext>
            </a:extLst>
          </p:cNvPr>
          <p:cNvSpPr txBox="1"/>
          <p:nvPr/>
        </p:nvSpPr>
        <p:spPr>
          <a:xfrm>
            <a:off x="6395955" y="4043551"/>
            <a:ext cx="483273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LS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396FD0E-8EAF-EE28-BAB4-F94B1325AF1C}"/>
              </a:ext>
            </a:extLst>
          </p:cNvPr>
          <p:cNvSpPr txBox="1"/>
          <p:nvPr/>
        </p:nvSpPr>
        <p:spPr>
          <a:xfrm>
            <a:off x="4595445" y="4035251"/>
            <a:ext cx="118640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Metformin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E46CE4B-A063-8AC1-C0B8-15BFB27792C0}"/>
              </a:ext>
            </a:extLst>
          </p:cNvPr>
          <p:cNvSpPr txBox="1"/>
          <p:nvPr/>
        </p:nvSpPr>
        <p:spPr>
          <a:xfrm>
            <a:off x="251245" y="3546324"/>
            <a:ext cx="30519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Cochrane ROB2 tool for QA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A74A596-DEFD-4FC2-C5A6-84E70CCA9D39}"/>
              </a:ext>
            </a:extLst>
          </p:cNvPr>
          <p:cNvSpPr txBox="1"/>
          <p:nvPr/>
        </p:nvSpPr>
        <p:spPr>
          <a:xfrm>
            <a:off x="247477" y="4598921"/>
            <a:ext cx="311349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5" indent="-285745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Subgroup analysis based on:</a:t>
            </a:r>
          </a:p>
          <a:p>
            <a:pPr marL="285745" indent="-285745">
              <a:buFont typeface="Wingdings" panose="05000000000000000000" pitchFamily="2" charset="2"/>
              <a:buChar char="Ø"/>
            </a:pPr>
            <a:endParaRPr lang="en-US" sz="1600" b="1" dirty="0">
              <a:solidFill>
                <a:schemeClr val="tx2">
                  <a:lumMod val="90000"/>
                  <a:lumOff val="10000"/>
                </a:schemeClr>
              </a:solidFill>
            </a:endParaRPr>
          </a:p>
          <a:p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            Follow-up duration</a:t>
            </a:r>
          </a:p>
          <a:p>
            <a:endParaRPr lang="en-US" sz="1600" b="1" dirty="0">
              <a:solidFill>
                <a:schemeClr val="tx2">
                  <a:lumMod val="90000"/>
                  <a:lumOff val="10000"/>
                </a:schemeClr>
              </a:solidFill>
            </a:endParaRPr>
          </a:p>
          <a:p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             Age group</a:t>
            </a:r>
          </a:p>
          <a:p>
            <a:endParaRPr lang="en-US" sz="1600" b="1" dirty="0">
              <a:solidFill>
                <a:schemeClr val="tx2">
                  <a:lumMod val="90000"/>
                  <a:lumOff val="10000"/>
                </a:schemeClr>
              </a:solidFill>
            </a:endParaRPr>
          </a:p>
          <a:p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             Study location</a:t>
            </a:r>
          </a:p>
        </p:txBody>
      </p:sp>
      <p:pic>
        <p:nvPicPr>
          <p:cNvPr id="58" name="Graphic 57" descr="Marker outline">
            <a:extLst>
              <a:ext uri="{FF2B5EF4-FFF2-40B4-BE49-F238E27FC236}">
                <a16:creationId xmlns:a16="http://schemas.microsoft.com/office/drawing/2014/main" id="{2ECE25F2-CB16-C3BC-E348-C0224FDE84F0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96DAC541-7B7A-43D3-8B79-37D633B846F1}">
                <asvg:svgBlip xmlns:asvg="http://schemas.microsoft.com/office/drawing/2016/SVG/main" r:embed="rId21"/>
              </a:ext>
            </a:extLst>
          </a:blip>
          <a:stretch>
            <a:fillRect/>
          </a:stretch>
        </p:blipFill>
        <p:spPr>
          <a:xfrm>
            <a:off x="310775" y="5966588"/>
            <a:ext cx="362824" cy="533443"/>
          </a:xfrm>
          <a:prstGeom prst="rect">
            <a:avLst/>
          </a:prstGeom>
        </p:spPr>
      </p:pic>
      <p:pic>
        <p:nvPicPr>
          <p:cNvPr id="60" name="Graphic 59" descr="Monthly calendar outline">
            <a:extLst>
              <a:ext uri="{FF2B5EF4-FFF2-40B4-BE49-F238E27FC236}">
                <a16:creationId xmlns:a16="http://schemas.microsoft.com/office/drawing/2014/main" id="{63FB717F-552E-371F-8FF2-D3ADBD5043AC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96DAC541-7B7A-43D3-8B79-37D633B846F1}">
                <asvg:svgBlip xmlns:asvg="http://schemas.microsoft.com/office/drawing/2016/SVG/main" r:embed="rId23"/>
              </a:ext>
            </a:extLst>
          </a:blip>
          <a:stretch>
            <a:fillRect/>
          </a:stretch>
        </p:blipFill>
        <p:spPr>
          <a:xfrm>
            <a:off x="310866" y="4974465"/>
            <a:ext cx="349017" cy="513143"/>
          </a:xfrm>
          <a:prstGeom prst="rect">
            <a:avLst/>
          </a:prstGeom>
        </p:spPr>
      </p:pic>
      <p:pic>
        <p:nvPicPr>
          <p:cNvPr id="62" name="Graphic 61" descr="Users with solid fill">
            <a:extLst>
              <a:ext uri="{FF2B5EF4-FFF2-40B4-BE49-F238E27FC236}">
                <a16:creationId xmlns:a16="http://schemas.microsoft.com/office/drawing/2014/main" id="{1FA81E0A-88B5-2C27-33CB-BAE066CB7271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96DAC541-7B7A-43D3-8B79-37D633B846F1}">
                <asvg:svgBlip xmlns:asvg="http://schemas.microsoft.com/office/drawing/2016/SVG/main" r:embed="rId25"/>
              </a:ext>
            </a:extLst>
          </a:blip>
          <a:stretch>
            <a:fillRect/>
          </a:stretch>
        </p:blipFill>
        <p:spPr>
          <a:xfrm>
            <a:off x="306794" y="5522608"/>
            <a:ext cx="349017" cy="513144"/>
          </a:xfrm>
          <a:prstGeom prst="rect">
            <a:avLst/>
          </a:prstGeom>
        </p:spPr>
      </p:pic>
      <p:sp>
        <p:nvSpPr>
          <p:cNvPr id="55" name="Rectangle 1">
            <a:extLst>
              <a:ext uri="{FF2B5EF4-FFF2-40B4-BE49-F238E27FC236}">
                <a16:creationId xmlns:a16="http://schemas.microsoft.com/office/drawing/2014/main" id="{E796967F-00DD-D7F0-21FF-1E7173CD5E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476" y="6946143"/>
            <a:ext cx="11402614" cy="584777"/>
          </a:xfrm>
          <a:prstGeom prst="rect">
            <a:avLst/>
          </a:prstGeom>
          <a:solidFill>
            <a:schemeClr val="tx2">
              <a:lumMod val="25000"/>
              <a:lumOff val="75000"/>
            </a:schemeClr>
          </a:solidFill>
          <a:ln w="57150">
            <a:solidFill>
              <a:schemeClr val="tx2">
                <a:lumMod val="25000"/>
                <a:lumOff val="75000"/>
              </a:schemeClr>
            </a:solidFill>
            <a:miter lim="800000"/>
            <a:headEnd/>
            <a:tailEnd/>
          </a:ln>
          <a:effectLst/>
        </p:spPr>
        <p:txBody>
          <a:bodyPr vert="horz" wrap="square" lIns="91440" tIns="45721" rIns="91440" bIns="45721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Adding metformin to lifestyle interventions may improve glycemic control in individuals with prediabetes and reduce their risk of progression to diabetes, compared to lifestyle interventions alone.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AA147CE-789F-59FD-1F05-EB8C1204A385}"/>
              </a:ext>
            </a:extLst>
          </p:cNvPr>
          <p:cNvSpPr txBox="1"/>
          <p:nvPr/>
        </p:nvSpPr>
        <p:spPr>
          <a:xfrm>
            <a:off x="240607" y="3837888"/>
            <a:ext cx="29327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5" indent="-285745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Random effect MA.</a:t>
            </a:r>
          </a:p>
          <a:p>
            <a:pPr marL="285745" indent="-285745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Sensitivity analysis using the leave-one-out model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3FBC2F8C-CCF4-5252-3BAB-8BAF61FE303A}"/>
              </a:ext>
            </a:extLst>
          </p:cNvPr>
          <p:cNvGrpSpPr/>
          <p:nvPr/>
        </p:nvGrpSpPr>
        <p:grpSpPr>
          <a:xfrm>
            <a:off x="727738" y="1880477"/>
            <a:ext cx="1874353" cy="1212517"/>
            <a:chOff x="471492" y="2062117"/>
            <a:chExt cx="3016450" cy="1946815"/>
          </a:xfrm>
        </p:grpSpPr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2185E442-2546-6840-5CDD-162FE6508E9F}"/>
                </a:ext>
              </a:extLst>
            </p:cNvPr>
            <p:cNvSpPr/>
            <p:nvPr/>
          </p:nvSpPr>
          <p:spPr>
            <a:xfrm>
              <a:off x="677722" y="3626844"/>
              <a:ext cx="2617238" cy="382088"/>
            </a:xfrm>
            <a:prstGeom prst="rect">
              <a:avLst/>
            </a:prstGeom>
            <a:blipFill dpi="0" rotWithShape="1"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 dirty="0"/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58296EA6-316E-0780-31EF-D159A9FD87C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13990" y="3258855"/>
              <a:ext cx="63740" cy="353731"/>
            </a:xfrm>
            <a:prstGeom prst="line">
              <a:avLst/>
            </a:prstGeom>
            <a:ln w="28575">
              <a:solidFill>
                <a:srgbClr val="00336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Straight Connector 60">
              <a:extLst>
                <a:ext uri="{FF2B5EF4-FFF2-40B4-BE49-F238E27FC236}">
                  <a16:creationId xmlns:a16="http://schemas.microsoft.com/office/drawing/2014/main" id="{B6BAB725-623B-DD1B-B244-A5CCF23E54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87169" y="2844163"/>
              <a:ext cx="0" cy="778583"/>
            </a:xfrm>
            <a:prstGeom prst="line">
              <a:avLst/>
            </a:prstGeom>
            <a:ln w="28575">
              <a:solidFill>
                <a:srgbClr val="00336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id="{7973E345-839F-0D73-D365-AADAD63B912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95600" y="3289208"/>
              <a:ext cx="81280" cy="327115"/>
            </a:xfrm>
            <a:prstGeom prst="line">
              <a:avLst/>
            </a:prstGeom>
            <a:ln w="28575">
              <a:solidFill>
                <a:srgbClr val="00336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1EE39A15-C741-C8FC-76C7-D5EAE8FA47D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77600" y="2844163"/>
              <a:ext cx="0" cy="778583"/>
            </a:xfrm>
            <a:prstGeom prst="line">
              <a:avLst/>
            </a:prstGeom>
            <a:ln w="28575">
              <a:solidFill>
                <a:srgbClr val="00336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Straight Connector 66">
              <a:extLst>
                <a:ext uri="{FF2B5EF4-FFF2-40B4-BE49-F238E27FC236}">
                  <a16:creationId xmlns:a16="http://schemas.microsoft.com/office/drawing/2014/main" id="{FCE73675-1466-21D7-D8E7-2186C0833292}"/>
                </a:ext>
              </a:extLst>
            </p:cNvPr>
            <p:cNvCxnSpPr>
              <a:cxnSpLocks/>
            </p:cNvCxnSpPr>
            <p:nvPr/>
          </p:nvCxnSpPr>
          <p:spPr>
            <a:xfrm>
              <a:off x="1929762" y="3279048"/>
              <a:ext cx="0" cy="333538"/>
            </a:xfrm>
            <a:prstGeom prst="line">
              <a:avLst/>
            </a:prstGeom>
            <a:ln w="28575">
              <a:solidFill>
                <a:srgbClr val="00336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9" name="Flowchart: Connector 68">
              <a:extLst>
                <a:ext uri="{FF2B5EF4-FFF2-40B4-BE49-F238E27FC236}">
                  <a16:creationId xmlns:a16="http://schemas.microsoft.com/office/drawing/2014/main" id="{118B89FA-EE76-3306-DEDD-DBFAE3598D3C}"/>
                </a:ext>
              </a:extLst>
            </p:cNvPr>
            <p:cNvSpPr/>
            <p:nvPr/>
          </p:nvSpPr>
          <p:spPr>
            <a:xfrm>
              <a:off x="471492" y="2603944"/>
              <a:ext cx="676958" cy="650225"/>
            </a:xfrm>
            <a:prstGeom prst="flowChartConnector">
              <a:avLst/>
            </a:prstGeom>
            <a:blipFill dpi="0" rotWithShape="1"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70" name="Flowchart: Connector 69">
              <a:extLst>
                <a:ext uri="{FF2B5EF4-FFF2-40B4-BE49-F238E27FC236}">
                  <a16:creationId xmlns:a16="http://schemas.microsoft.com/office/drawing/2014/main" id="{7286ACC7-510E-AAA0-4868-D371051217E5}"/>
                </a:ext>
              </a:extLst>
            </p:cNvPr>
            <p:cNvSpPr/>
            <p:nvPr/>
          </p:nvSpPr>
          <p:spPr>
            <a:xfrm>
              <a:off x="1160083" y="2062117"/>
              <a:ext cx="676955" cy="778582"/>
            </a:xfrm>
            <a:prstGeom prst="flowChartConnector">
              <a:avLst/>
            </a:prstGeom>
            <a:blipFill dpi="0" rotWithShape="1"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71" name="Flowchart: Connector 70">
              <a:extLst>
                <a:ext uri="{FF2B5EF4-FFF2-40B4-BE49-F238E27FC236}">
                  <a16:creationId xmlns:a16="http://schemas.microsoft.com/office/drawing/2014/main" id="{EAAED16C-AA01-C6F6-DB13-54F6D210DF1E}"/>
                </a:ext>
              </a:extLst>
            </p:cNvPr>
            <p:cNvSpPr/>
            <p:nvPr/>
          </p:nvSpPr>
          <p:spPr>
            <a:xfrm>
              <a:off x="1654225" y="2775597"/>
              <a:ext cx="564962" cy="510969"/>
            </a:xfrm>
            <a:prstGeom prst="flowChartConnector">
              <a:avLst/>
            </a:prstGeom>
            <a:blipFill dpi="0" rotWithShape="1"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72" name="Flowchart: Connector 71">
              <a:extLst>
                <a:ext uri="{FF2B5EF4-FFF2-40B4-BE49-F238E27FC236}">
                  <a16:creationId xmlns:a16="http://schemas.microsoft.com/office/drawing/2014/main" id="{258B967D-5816-0703-EE86-3781696AF097}"/>
                </a:ext>
              </a:extLst>
            </p:cNvPr>
            <p:cNvSpPr/>
            <p:nvPr/>
          </p:nvSpPr>
          <p:spPr>
            <a:xfrm>
              <a:off x="2055133" y="2209552"/>
              <a:ext cx="676958" cy="650225"/>
            </a:xfrm>
            <a:prstGeom prst="flowChartConnector">
              <a:avLst/>
            </a:prstGeom>
            <a:blipFill dpi="0" rotWithShape="1"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76" name="Flowchart: Connector 75">
              <a:extLst>
                <a:ext uri="{FF2B5EF4-FFF2-40B4-BE49-F238E27FC236}">
                  <a16:creationId xmlns:a16="http://schemas.microsoft.com/office/drawing/2014/main" id="{BBB4FF34-856E-AD6F-C6A1-C2BCEDF92123}"/>
                </a:ext>
              </a:extLst>
            </p:cNvPr>
            <p:cNvSpPr/>
            <p:nvPr/>
          </p:nvSpPr>
          <p:spPr>
            <a:xfrm>
              <a:off x="2719916" y="2567102"/>
              <a:ext cx="768026" cy="778582"/>
            </a:xfrm>
            <a:prstGeom prst="flowChartConnector">
              <a:avLst/>
            </a:prstGeom>
            <a:blipFill dpi="0" rotWithShape="1"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  <p:sp>
        <p:nvSpPr>
          <p:cNvPr id="78" name="TextBox 77">
            <a:extLst>
              <a:ext uri="{FF2B5EF4-FFF2-40B4-BE49-F238E27FC236}">
                <a16:creationId xmlns:a16="http://schemas.microsoft.com/office/drawing/2014/main" id="{824C9006-5CEA-7C6D-42B6-99E8580343E7}"/>
              </a:ext>
            </a:extLst>
          </p:cNvPr>
          <p:cNvSpPr txBox="1"/>
          <p:nvPr/>
        </p:nvSpPr>
        <p:spPr>
          <a:xfrm>
            <a:off x="7712195" y="5501645"/>
            <a:ext cx="367208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47" indent="-285747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</a:rPr>
              <a:t>Metformin + LSI significantly     the incidence of T2DM (</a:t>
            </a: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  <a:ea typeface="Calibri" panose="020F0502020204030204" pitchFamily="34" charset="0"/>
                <a:cs typeface="Arial" panose="020B0604020202020204" pitchFamily="34" charset="0"/>
              </a:rPr>
              <a:t>RR = 0.85, 95% CI [0.75, 0.97], </a:t>
            </a:r>
            <a:r>
              <a:rPr lang="en-US" sz="1600" b="1" i="1" dirty="0">
                <a:solidFill>
                  <a:schemeClr val="tx2">
                    <a:lumMod val="90000"/>
                    <a:lumOff val="10000"/>
                  </a:schemeClr>
                </a:solidFill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  <a:ea typeface="Calibri" panose="020F0502020204030204" pitchFamily="34" charset="0"/>
                <a:cs typeface="Arial" panose="020B0604020202020204" pitchFamily="34" charset="0"/>
              </a:rPr>
              <a:t> = 0.01)</a:t>
            </a:r>
          </a:p>
          <a:p>
            <a:pPr marL="285747" indent="-285747">
              <a:buFont typeface="Wingdings" panose="05000000000000000000" pitchFamily="2" charset="2"/>
              <a:buChar char="Ø"/>
            </a:pPr>
            <a:r>
              <a:rPr lang="en-US" sz="1600" b="1" dirty="0">
                <a:solidFill>
                  <a:schemeClr val="tx2">
                    <a:lumMod val="90000"/>
                    <a:lumOff val="10000"/>
                  </a:schemeClr>
                </a:solidFill>
                <a:ea typeface="Calibri" panose="020F0502020204030204" pitchFamily="34" charset="0"/>
                <a:cs typeface="Arial" panose="020B0604020202020204" pitchFamily="34" charset="0"/>
              </a:rPr>
              <a:t>No significant difference in all secondary outcomes</a:t>
            </a:r>
            <a:endParaRPr lang="en-US" sz="1600" b="1" dirty="0">
              <a:solidFill>
                <a:schemeClr val="tx2">
                  <a:lumMod val="90000"/>
                  <a:lumOff val="10000"/>
                </a:schemeClr>
              </a:solidFill>
            </a:endParaRPr>
          </a:p>
        </p:txBody>
      </p:sp>
      <p:sp>
        <p:nvSpPr>
          <p:cNvPr id="80" name="Arrow: Down 79">
            <a:extLst>
              <a:ext uri="{FF2B5EF4-FFF2-40B4-BE49-F238E27FC236}">
                <a16:creationId xmlns:a16="http://schemas.microsoft.com/office/drawing/2014/main" id="{3B6F8696-2D13-3557-66DF-2DAE63A5106F}"/>
              </a:ext>
            </a:extLst>
          </p:cNvPr>
          <p:cNvSpPr/>
          <p:nvPr/>
        </p:nvSpPr>
        <p:spPr>
          <a:xfrm>
            <a:off x="10750013" y="5558924"/>
            <a:ext cx="86627" cy="220256"/>
          </a:xfrm>
          <a:prstGeom prst="downArrow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74"/>
          </a:p>
        </p:txBody>
      </p:sp>
      <p:pic>
        <p:nvPicPr>
          <p:cNvPr id="88" name="Picture 87" descr="A graph of a graph showing the amount of blood in the blood&#10;&#10;Description automatically generated with medium confidence">
            <a:extLst>
              <a:ext uri="{FF2B5EF4-FFF2-40B4-BE49-F238E27FC236}">
                <a16:creationId xmlns:a16="http://schemas.microsoft.com/office/drawing/2014/main" id="{AB432AFD-D9A4-597B-9291-A3AD1914F046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1232" y="1852649"/>
            <a:ext cx="3694189" cy="36349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0601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7</TotalTime>
  <Words>153</Words>
  <Application>Microsoft Office PowerPoint</Application>
  <PresentationFormat>Custom</PresentationFormat>
  <Paragraphs>4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sma Ehab Amer</dc:creator>
  <cp:lastModifiedBy>Basma Ehab Amer</cp:lastModifiedBy>
  <cp:revision>16</cp:revision>
  <dcterms:created xsi:type="dcterms:W3CDTF">2024-08-15T15:52:32Z</dcterms:created>
  <dcterms:modified xsi:type="dcterms:W3CDTF">2024-10-22T18:27:02Z</dcterms:modified>
</cp:coreProperties>
</file>